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3" r:id="rId2"/>
  </p:sldIdLst>
  <p:sldSz cx="43891200" cy="32918400"/>
  <p:notesSz cx="7010400" cy="9296400"/>
  <p:custDataLst>
    <p:tags r:id="rId4"/>
  </p:custDataLst>
  <p:defaultTextStyle>
    <a:defPPr>
      <a:defRPr lang="en-US"/>
    </a:defPPr>
    <a:lvl1pPr algn="l" rtl="0" fontAlgn="base">
      <a:spcBef>
        <a:spcPct val="0"/>
      </a:spcBef>
      <a:spcAft>
        <a:spcPct val="0"/>
      </a:spcAft>
      <a:defRPr sz="3000" kern="1200">
        <a:solidFill>
          <a:schemeClr val="tx1"/>
        </a:solidFill>
        <a:latin typeface="Arial" charset="0"/>
        <a:ea typeface="+mn-ea"/>
        <a:cs typeface="Arial" charset="0"/>
      </a:defRPr>
    </a:lvl1pPr>
    <a:lvl2pPr marL="457200" algn="l" rtl="0" fontAlgn="base">
      <a:spcBef>
        <a:spcPct val="0"/>
      </a:spcBef>
      <a:spcAft>
        <a:spcPct val="0"/>
      </a:spcAft>
      <a:defRPr sz="3000" kern="1200">
        <a:solidFill>
          <a:schemeClr val="tx1"/>
        </a:solidFill>
        <a:latin typeface="Arial" charset="0"/>
        <a:ea typeface="+mn-ea"/>
        <a:cs typeface="Arial" charset="0"/>
      </a:defRPr>
    </a:lvl2pPr>
    <a:lvl3pPr marL="914400" algn="l" rtl="0" fontAlgn="base">
      <a:spcBef>
        <a:spcPct val="0"/>
      </a:spcBef>
      <a:spcAft>
        <a:spcPct val="0"/>
      </a:spcAft>
      <a:defRPr sz="3000" kern="1200">
        <a:solidFill>
          <a:schemeClr val="tx1"/>
        </a:solidFill>
        <a:latin typeface="Arial" charset="0"/>
        <a:ea typeface="+mn-ea"/>
        <a:cs typeface="Arial" charset="0"/>
      </a:defRPr>
    </a:lvl3pPr>
    <a:lvl4pPr marL="1371600" algn="l" rtl="0" fontAlgn="base">
      <a:spcBef>
        <a:spcPct val="0"/>
      </a:spcBef>
      <a:spcAft>
        <a:spcPct val="0"/>
      </a:spcAft>
      <a:defRPr sz="3000" kern="1200">
        <a:solidFill>
          <a:schemeClr val="tx1"/>
        </a:solidFill>
        <a:latin typeface="Arial" charset="0"/>
        <a:ea typeface="+mn-ea"/>
        <a:cs typeface="Arial" charset="0"/>
      </a:defRPr>
    </a:lvl4pPr>
    <a:lvl5pPr marL="1828800" algn="l" rtl="0" fontAlgn="base">
      <a:spcBef>
        <a:spcPct val="0"/>
      </a:spcBef>
      <a:spcAft>
        <a:spcPct val="0"/>
      </a:spcAft>
      <a:defRPr sz="3000" kern="1200">
        <a:solidFill>
          <a:schemeClr val="tx1"/>
        </a:solidFill>
        <a:latin typeface="Arial" charset="0"/>
        <a:ea typeface="+mn-ea"/>
        <a:cs typeface="Arial" charset="0"/>
      </a:defRPr>
    </a:lvl5pPr>
    <a:lvl6pPr marL="2286000" algn="l" defTabSz="914400" rtl="0" eaLnBrk="1" latinLnBrk="0" hangingPunct="1">
      <a:defRPr sz="3000" kern="1200">
        <a:solidFill>
          <a:schemeClr val="tx1"/>
        </a:solidFill>
        <a:latin typeface="Arial" charset="0"/>
        <a:ea typeface="+mn-ea"/>
        <a:cs typeface="Arial" charset="0"/>
      </a:defRPr>
    </a:lvl6pPr>
    <a:lvl7pPr marL="2743200" algn="l" defTabSz="914400" rtl="0" eaLnBrk="1" latinLnBrk="0" hangingPunct="1">
      <a:defRPr sz="3000" kern="1200">
        <a:solidFill>
          <a:schemeClr val="tx1"/>
        </a:solidFill>
        <a:latin typeface="Arial" charset="0"/>
        <a:ea typeface="+mn-ea"/>
        <a:cs typeface="Arial" charset="0"/>
      </a:defRPr>
    </a:lvl7pPr>
    <a:lvl8pPr marL="3200400" algn="l" defTabSz="914400" rtl="0" eaLnBrk="1" latinLnBrk="0" hangingPunct="1">
      <a:defRPr sz="3000" kern="1200">
        <a:solidFill>
          <a:schemeClr val="tx1"/>
        </a:solidFill>
        <a:latin typeface="Arial" charset="0"/>
        <a:ea typeface="+mn-ea"/>
        <a:cs typeface="Arial" charset="0"/>
      </a:defRPr>
    </a:lvl8pPr>
    <a:lvl9pPr marL="3657600" algn="l" defTabSz="914400" rtl="0" eaLnBrk="1" latinLnBrk="0" hangingPunct="1">
      <a:defRPr sz="3000"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10368" userDrawn="1">
          <p15:clr>
            <a:srgbClr val="A4A3A4"/>
          </p15:clr>
        </p15:guide>
        <p15:guide id="2" pos="1382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C5252"/>
    <a:srgbClr val="DED0D0"/>
    <a:srgbClr val="EFE9E9"/>
    <a:srgbClr val="6076B4"/>
    <a:srgbClr val="669900"/>
    <a:srgbClr val="672F37"/>
    <a:srgbClr val="461D7C"/>
    <a:srgbClr val="481F67"/>
    <a:srgbClr val="963D00"/>
    <a:srgbClr val="9900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26673D6-C87B-4BF6-DF41-92561C37DFB0}" v="597" dt="2024-04-24T19:06:50.876"/>
    <p1510:client id="{1196EBE1-F11E-98F8-FDEA-CFDA453928A8}" v="227" dt="2024-04-24T17:55:00.493"/>
    <p1510:client id="{400B19F5-A940-FD2A-3832-B8F1D1476D18}" v="121" dt="2024-04-24T17:48:44.348"/>
    <p1510:client id="{4082E421-114C-85E1-DCF2-049224C55206}" v="23" dt="2024-04-26T01:15:42.419"/>
    <p1510:client id="{64854D80-F1FC-C981-60B1-E09AD8605E32}" v="191" dt="2024-04-24T18:52:36.433"/>
    <p1510:client id="{A4C369C3-095A-5CE9-0F9E-E63957E58DC5}" v="298" dt="2024-04-24T19:05:47.237"/>
    <p1510:client id="{A54148CA-EA6B-BA7D-5E8C-CDB3E9B8D088}" v="186" dt="2024-04-25T16:32:36.880"/>
    <p1510:client id="{B8E5C5D3-6B91-541D-2A1F-27C65562E6F8}" v="106" dt="2024-04-24T17:41:31.337"/>
    <p1510:client id="{B9990D41-6DCA-05F2-A32C-A787C17485CB}" v="51" dt="2024-04-25T21:40:13.500"/>
    <p1510:client id="{D8813CDC-A716-DB6C-3C2D-AE3071ECD544}" v="18" dt="2024-04-25T21:45:51.511"/>
    <p1510:client id="{D9F428F8-B76F-4CCB-36D7-23EE754D8015}" v="105" dt="2024-04-24T18:26:16.342"/>
    <p1510:client id="{E2C00BC5-611D-A2D1-624D-5363A92191BA}" v="205" dt="2024-04-24T17:52:10.94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guide orient="horz" pos="10368"/>
        <p:guide pos="13824"/>
      </p:guideLst>
    </p:cSldViewPr>
  </p:slide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tags" Target="tags/tag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assidy V Herrin" userId="S::kherr17@lsu.edu::78f2563c-1de5-4d7a-85bd-6e884350cb72" providerId="AD" clId="Web-{4082E421-114C-85E1-DCF2-049224C55206}"/>
    <pc:docChg chg="mod modSld">
      <pc:chgData name="Kassidy V Herrin" userId="S::kherr17@lsu.edu::78f2563c-1de5-4d7a-85bd-6e884350cb72" providerId="AD" clId="Web-{4082E421-114C-85E1-DCF2-049224C55206}" dt="2024-04-26T01:15:42.419" v="22"/>
      <pc:docMkLst>
        <pc:docMk/>
      </pc:docMkLst>
      <pc:sldChg chg="modSp">
        <pc:chgData name="Kassidy V Herrin" userId="S::kherr17@lsu.edu::78f2563c-1de5-4d7a-85bd-6e884350cb72" providerId="AD" clId="Web-{4082E421-114C-85E1-DCF2-049224C55206}" dt="2024-04-26T01:14:37.182" v="21" actId="1076"/>
        <pc:sldMkLst>
          <pc:docMk/>
          <pc:sldMk cId="1267986695" sldId="263"/>
        </pc:sldMkLst>
        <pc:spChg chg="mod">
          <ac:chgData name="Kassidy V Herrin" userId="S::kherr17@lsu.edu::78f2563c-1de5-4d7a-85bd-6e884350cb72" providerId="AD" clId="Web-{4082E421-114C-85E1-DCF2-049224C55206}" dt="2024-04-26T01:14:25.698" v="18" actId="14100"/>
          <ac:spMkLst>
            <pc:docMk/>
            <pc:sldMk cId="1267986695" sldId="263"/>
            <ac:spMk id="2" creationId="{C391A11A-2981-C111-5347-6F129B8F65AF}"/>
          </ac:spMkLst>
        </pc:spChg>
        <pc:spChg chg="mod">
          <ac:chgData name="Kassidy V Herrin" userId="S::kherr17@lsu.edu::78f2563c-1de5-4d7a-85bd-6e884350cb72" providerId="AD" clId="Web-{4082E421-114C-85E1-DCF2-049224C55206}" dt="2024-04-26T01:14:35.995" v="20" actId="1076"/>
          <ac:spMkLst>
            <pc:docMk/>
            <pc:sldMk cId="1267986695" sldId="263"/>
            <ac:spMk id="3" creationId="{57203A09-E0E1-3B0B-8F2F-EDFB121ED264}"/>
          </ac:spMkLst>
        </pc:spChg>
        <pc:spChg chg="mod">
          <ac:chgData name="Kassidy V Herrin" userId="S::kherr17@lsu.edu::78f2563c-1de5-4d7a-85bd-6e884350cb72" providerId="AD" clId="Web-{4082E421-114C-85E1-DCF2-049224C55206}" dt="2024-04-26T01:11:49.425" v="0" actId="1076"/>
          <ac:spMkLst>
            <pc:docMk/>
            <pc:sldMk cId="1267986695" sldId="263"/>
            <ac:spMk id="7" creationId="{EE761138-33B1-0299-BC55-977C0A61093D}"/>
          </ac:spMkLst>
        </pc:spChg>
        <pc:spChg chg="mod">
          <ac:chgData name="Kassidy V Herrin" userId="S::kherr17@lsu.edu::78f2563c-1de5-4d7a-85bd-6e884350cb72" providerId="AD" clId="Web-{4082E421-114C-85E1-DCF2-049224C55206}" dt="2024-04-26T01:14:15.166" v="16" actId="1076"/>
          <ac:spMkLst>
            <pc:docMk/>
            <pc:sldMk cId="1267986695" sldId="263"/>
            <ac:spMk id="16" creationId="{00000000-0000-0000-0000-000000000000}"/>
          </ac:spMkLst>
        </pc:spChg>
        <pc:spChg chg="mod">
          <ac:chgData name="Kassidy V Herrin" userId="S::kherr17@lsu.edu::78f2563c-1de5-4d7a-85bd-6e884350cb72" providerId="AD" clId="Web-{4082E421-114C-85E1-DCF2-049224C55206}" dt="2024-04-26T01:14:37.182" v="21" actId="1076"/>
          <ac:spMkLst>
            <pc:docMk/>
            <pc:sldMk cId="1267986695" sldId="263"/>
            <ac:spMk id="19" creationId="{00000000-0000-0000-0000-000000000000}"/>
          </ac:spMkLst>
        </pc:spChg>
        <pc:spChg chg="mod">
          <ac:chgData name="Kassidy V Herrin" userId="S::kherr17@lsu.edu::78f2563c-1de5-4d7a-85bd-6e884350cb72" providerId="AD" clId="Web-{4082E421-114C-85E1-DCF2-049224C55206}" dt="2024-04-26T01:11:56.003" v="3" actId="1076"/>
          <ac:spMkLst>
            <pc:docMk/>
            <pc:sldMk cId="1267986695" sldId="263"/>
            <ac:spMk id="26" creationId="{C8AD3FA0-91D1-C89A-BD5C-192A99E78AA9}"/>
          </ac:spMkLst>
        </pc:spChg>
        <pc:spChg chg="mod">
          <ac:chgData name="Kassidy V Herrin" userId="S::kherr17@lsu.edu::78f2563c-1de5-4d7a-85bd-6e884350cb72" providerId="AD" clId="Web-{4082E421-114C-85E1-DCF2-049224C55206}" dt="2024-04-26T01:12:48.412" v="12" actId="1076"/>
          <ac:spMkLst>
            <pc:docMk/>
            <pc:sldMk cId="1267986695" sldId="263"/>
            <ac:spMk id="27" creationId="{E8598A00-C0A7-013C-851B-D8D74B2D51DB}"/>
          </ac:spMkLst>
        </pc:spChg>
        <pc:spChg chg="mod">
          <ac:chgData name="Kassidy V Herrin" userId="S::kherr17@lsu.edu::78f2563c-1de5-4d7a-85bd-6e884350cb72" providerId="AD" clId="Web-{4082E421-114C-85E1-DCF2-049224C55206}" dt="2024-04-26T01:13:16.335" v="15" actId="1076"/>
          <ac:spMkLst>
            <pc:docMk/>
            <pc:sldMk cId="1267986695" sldId="263"/>
            <ac:spMk id="29" creationId="{F79C0B08-929E-0C8F-A26D-D1900DFDD2FC}"/>
          </ac:spMkLst>
        </pc:spChg>
        <pc:spChg chg="mod">
          <ac:chgData name="Kassidy V Herrin" userId="S::kherr17@lsu.edu::78f2563c-1de5-4d7a-85bd-6e884350cb72" providerId="AD" clId="Web-{4082E421-114C-85E1-DCF2-049224C55206}" dt="2024-04-26T01:12:46.943" v="11" actId="1076"/>
          <ac:spMkLst>
            <pc:docMk/>
            <pc:sldMk cId="1267986695" sldId="263"/>
            <ac:spMk id="14342" creationId="{00000000-0000-0000-0000-000000000000}"/>
          </ac:spMkLst>
        </pc:spChg>
        <pc:picChg chg="mod modCrop">
          <ac:chgData name="Kassidy V Herrin" userId="S::kherr17@lsu.edu::78f2563c-1de5-4d7a-85bd-6e884350cb72" providerId="AD" clId="Web-{4082E421-114C-85E1-DCF2-049224C55206}" dt="2024-04-26T01:12:41.630" v="10" actId="1076"/>
          <ac:picMkLst>
            <pc:docMk/>
            <pc:sldMk cId="1267986695" sldId="263"/>
            <ac:picMk id="38" creationId="{58956C0E-CCF6-6E08-81C6-1B7D33AEA13B}"/>
          </ac:picMkLst>
        </pc:picChg>
      </pc:sldChg>
    </pc:docChg>
  </pc:docChgLst>
  <pc:docChgLst>
    <pc:chgData name="Kassidy V Herrin" userId="S::kherr17@lsu.edu::78f2563c-1de5-4d7a-85bd-6e884350cb72" providerId="AD" clId="Web-{724B3D24-4751-D046-2DB9-03A264121D04}"/>
    <pc:docChg chg="modSld">
      <pc:chgData name="Kassidy V Herrin" userId="S::kherr17@lsu.edu::78f2563c-1de5-4d7a-85bd-6e884350cb72" providerId="AD" clId="Web-{724B3D24-4751-D046-2DB9-03A264121D04}" dt="2024-04-15T03:01:28.589" v="16" actId="20577"/>
      <pc:docMkLst>
        <pc:docMk/>
      </pc:docMkLst>
      <pc:sldChg chg="modSp">
        <pc:chgData name="Kassidy V Herrin" userId="S::kherr17@lsu.edu::78f2563c-1de5-4d7a-85bd-6e884350cb72" providerId="AD" clId="Web-{724B3D24-4751-D046-2DB9-03A264121D04}" dt="2024-04-15T03:01:28.589" v="16" actId="20577"/>
        <pc:sldMkLst>
          <pc:docMk/>
          <pc:sldMk cId="1267986695" sldId="263"/>
        </pc:sldMkLst>
        <pc:spChg chg="mod">
          <ac:chgData name="Kassidy V Herrin" userId="S::kherr17@lsu.edu::78f2563c-1de5-4d7a-85bd-6e884350cb72" providerId="AD" clId="Web-{724B3D24-4751-D046-2DB9-03A264121D04}" dt="2024-04-15T02:59:39.194" v="4" actId="14100"/>
          <ac:spMkLst>
            <pc:docMk/>
            <pc:sldMk cId="1267986695" sldId="263"/>
            <ac:spMk id="22" creationId="{00000000-0000-0000-0000-000000000000}"/>
          </ac:spMkLst>
        </pc:spChg>
        <pc:spChg chg="mod">
          <ac:chgData name="Kassidy V Herrin" userId="S::kherr17@lsu.edu::78f2563c-1de5-4d7a-85bd-6e884350cb72" providerId="AD" clId="Web-{724B3D24-4751-D046-2DB9-03A264121D04}" dt="2024-04-15T02:59:44.695" v="5" actId="1076"/>
          <ac:spMkLst>
            <pc:docMk/>
            <pc:sldMk cId="1267986695" sldId="263"/>
            <ac:spMk id="23" creationId="{00000000-0000-0000-0000-000000000000}"/>
          </ac:spMkLst>
        </pc:spChg>
        <pc:spChg chg="mod">
          <ac:chgData name="Kassidy V Herrin" userId="S::kherr17@lsu.edu::78f2563c-1de5-4d7a-85bd-6e884350cb72" providerId="AD" clId="Web-{724B3D24-4751-D046-2DB9-03A264121D04}" dt="2024-04-15T03:01:28.589" v="16" actId="20577"/>
          <ac:spMkLst>
            <pc:docMk/>
            <pc:sldMk cId="1267986695" sldId="263"/>
            <ac:spMk id="14343" creationId="{00000000-0000-0000-0000-000000000000}"/>
          </ac:spMkLst>
        </pc:spChg>
      </pc:sldChg>
    </pc:docChg>
  </pc:docChgLst>
  <pc:docChgLst>
    <pc:chgData name="Charlotte E Robinson" userId="S::crob261@lsu.edu::b04a81f5-e1b9-4faa-b263-388a49954364" providerId="AD" clId="Web-{07483327-6B34-830F-DFB4-12877358E95E}"/>
    <pc:docChg chg="modSld">
      <pc:chgData name="Charlotte E Robinson" userId="S::crob261@lsu.edu::b04a81f5-e1b9-4faa-b263-388a49954364" providerId="AD" clId="Web-{07483327-6B34-830F-DFB4-12877358E95E}" dt="2024-04-11T17:47:51.763" v="4" actId="20577"/>
      <pc:docMkLst>
        <pc:docMk/>
      </pc:docMkLst>
      <pc:sldChg chg="modSp">
        <pc:chgData name="Charlotte E Robinson" userId="S::crob261@lsu.edu::b04a81f5-e1b9-4faa-b263-388a49954364" providerId="AD" clId="Web-{07483327-6B34-830F-DFB4-12877358E95E}" dt="2024-04-11T17:47:51.763" v="4" actId="20577"/>
        <pc:sldMkLst>
          <pc:docMk/>
          <pc:sldMk cId="1267986695" sldId="263"/>
        </pc:sldMkLst>
        <pc:spChg chg="mod">
          <ac:chgData name="Charlotte E Robinson" userId="S::crob261@lsu.edu::b04a81f5-e1b9-4faa-b263-388a49954364" providerId="AD" clId="Web-{07483327-6B34-830F-DFB4-12877358E95E}" dt="2024-04-11T17:47:51.763" v="4" actId="20577"/>
          <ac:spMkLst>
            <pc:docMk/>
            <pc:sldMk cId="1267986695" sldId="263"/>
            <ac:spMk id="14342" creationId="{00000000-0000-0000-0000-000000000000}"/>
          </ac:spMkLst>
        </pc:spChg>
      </pc:sldChg>
    </pc:docChg>
  </pc:docChgLst>
  <pc:docChgLst>
    <pc:chgData name="Kassidy V Herrin" userId="S::kherr17@lsu.edu::78f2563c-1de5-4d7a-85bd-6e884350cb72" providerId="AD" clId="Web-{1196EBE1-F11E-98F8-FDEA-CFDA453928A8}"/>
    <pc:docChg chg="modSld">
      <pc:chgData name="Kassidy V Herrin" userId="S::kherr17@lsu.edu::78f2563c-1de5-4d7a-85bd-6e884350cb72" providerId="AD" clId="Web-{1196EBE1-F11E-98F8-FDEA-CFDA453928A8}" dt="2024-04-24T17:55:00.493" v="207" actId="14100"/>
      <pc:docMkLst>
        <pc:docMk/>
      </pc:docMkLst>
      <pc:sldChg chg="addSp delSp modSp">
        <pc:chgData name="Kassidy V Herrin" userId="S::kherr17@lsu.edu::78f2563c-1de5-4d7a-85bd-6e884350cb72" providerId="AD" clId="Web-{1196EBE1-F11E-98F8-FDEA-CFDA453928A8}" dt="2024-04-24T17:55:00.493" v="207" actId="14100"/>
        <pc:sldMkLst>
          <pc:docMk/>
          <pc:sldMk cId="1267986695" sldId="263"/>
        </pc:sldMkLst>
        <pc:spChg chg="mod">
          <ac:chgData name="Kassidy V Herrin" userId="S::kherr17@lsu.edu::78f2563c-1de5-4d7a-85bd-6e884350cb72" providerId="AD" clId="Web-{1196EBE1-F11E-98F8-FDEA-CFDA453928A8}" dt="2024-04-24T17:51:52.032" v="186" actId="14100"/>
          <ac:spMkLst>
            <pc:docMk/>
            <pc:sldMk cId="1267986695" sldId="263"/>
            <ac:spMk id="2" creationId="{C391A11A-2981-C111-5347-6F129B8F65AF}"/>
          </ac:spMkLst>
        </pc:spChg>
        <pc:spChg chg="add mod">
          <ac:chgData name="Kassidy V Herrin" userId="S::kherr17@lsu.edu::78f2563c-1de5-4d7a-85bd-6e884350cb72" providerId="AD" clId="Web-{1196EBE1-F11E-98F8-FDEA-CFDA453928A8}" dt="2024-04-24T17:24:05.801" v="89" actId="1076"/>
          <ac:spMkLst>
            <pc:docMk/>
            <pc:sldMk cId="1267986695" sldId="263"/>
            <ac:spMk id="9" creationId="{A899D352-40E7-A6C6-BD2E-9467BAA1D812}"/>
          </ac:spMkLst>
        </pc:spChg>
        <pc:spChg chg="mod">
          <ac:chgData name="Kassidy V Herrin" userId="S::kherr17@lsu.edu::78f2563c-1de5-4d7a-85bd-6e884350cb72" providerId="AD" clId="Web-{1196EBE1-F11E-98F8-FDEA-CFDA453928A8}" dt="2024-04-24T17:51:39.734" v="183" actId="1076"/>
          <ac:spMkLst>
            <pc:docMk/>
            <pc:sldMk cId="1267986695" sldId="263"/>
            <ac:spMk id="14" creationId="{00000000-0000-0000-0000-000000000000}"/>
          </ac:spMkLst>
        </pc:spChg>
        <pc:spChg chg="mod">
          <ac:chgData name="Kassidy V Herrin" userId="S::kherr17@lsu.edu::78f2563c-1de5-4d7a-85bd-6e884350cb72" providerId="AD" clId="Web-{1196EBE1-F11E-98F8-FDEA-CFDA453928A8}" dt="2024-04-24T17:54:08.241" v="199" actId="1076"/>
          <ac:spMkLst>
            <pc:docMk/>
            <pc:sldMk cId="1267986695" sldId="263"/>
            <ac:spMk id="15" creationId="{00000000-0000-0000-0000-000000000000}"/>
          </ac:spMkLst>
        </pc:spChg>
        <pc:spChg chg="mod">
          <ac:chgData name="Kassidy V Herrin" userId="S::kherr17@lsu.edu::78f2563c-1de5-4d7a-85bd-6e884350cb72" providerId="AD" clId="Web-{1196EBE1-F11E-98F8-FDEA-CFDA453928A8}" dt="2024-04-24T17:54:21.101" v="200" actId="14100"/>
          <ac:spMkLst>
            <pc:docMk/>
            <pc:sldMk cId="1267986695" sldId="263"/>
            <ac:spMk id="17" creationId="{00000000-0000-0000-0000-000000000000}"/>
          </ac:spMkLst>
        </pc:spChg>
        <pc:spChg chg="mod">
          <ac:chgData name="Kassidy V Herrin" userId="S::kherr17@lsu.edu::78f2563c-1de5-4d7a-85bd-6e884350cb72" providerId="AD" clId="Web-{1196EBE1-F11E-98F8-FDEA-CFDA453928A8}" dt="2024-04-24T17:55:00.493" v="207" actId="14100"/>
          <ac:spMkLst>
            <pc:docMk/>
            <pc:sldMk cId="1267986695" sldId="263"/>
            <ac:spMk id="20" creationId="{00000000-0000-0000-0000-000000000000}"/>
          </ac:spMkLst>
        </pc:spChg>
        <pc:spChg chg="mod">
          <ac:chgData name="Kassidy V Herrin" userId="S::kherr17@lsu.edu::78f2563c-1de5-4d7a-85bd-6e884350cb72" providerId="AD" clId="Web-{1196EBE1-F11E-98F8-FDEA-CFDA453928A8}" dt="2024-04-24T17:54:36.945" v="203" actId="14100"/>
          <ac:spMkLst>
            <pc:docMk/>
            <pc:sldMk cId="1267986695" sldId="263"/>
            <ac:spMk id="22" creationId="{00000000-0000-0000-0000-000000000000}"/>
          </ac:spMkLst>
        </pc:spChg>
        <pc:spChg chg="mod">
          <ac:chgData name="Kassidy V Herrin" userId="S::kherr17@lsu.edu::78f2563c-1de5-4d7a-85bd-6e884350cb72" providerId="AD" clId="Web-{1196EBE1-F11E-98F8-FDEA-CFDA453928A8}" dt="2024-04-24T17:54:33.305" v="202" actId="14100"/>
          <ac:spMkLst>
            <pc:docMk/>
            <pc:sldMk cId="1267986695" sldId="263"/>
            <ac:spMk id="23" creationId="{00000000-0000-0000-0000-000000000000}"/>
          </ac:spMkLst>
        </pc:spChg>
        <pc:spChg chg="add mod">
          <ac:chgData name="Kassidy V Herrin" userId="S::kherr17@lsu.edu::78f2563c-1de5-4d7a-85bd-6e884350cb72" providerId="AD" clId="Web-{1196EBE1-F11E-98F8-FDEA-CFDA453928A8}" dt="2024-04-24T17:24:28.802" v="95" actId="20577"/>
          <ac:spMkLst>
            <pc:docMk/>
            <pc:sldMk cId="1267986695" sldId="263"/>
            <ac:spMk id="24" creationId="{98E8D37B-B528-A794-086D-319C56A08178}"/>
          </ac:spMkLst>
        </pc:spChg>
        <pc:spChg chg="mod">
          <ac:chgData name="Kassidy V Herrin" userId="S::kherr17@lsu.edu::78f2563c-1de5-4d7a-85bd-6e884350cb72" providerId="AD" clId="Web-{1196EBE1-F11E-98F8-FDEA-CFDA453928A8}" dt="2024-04-24T17:16:10.046" v="15" actId="1076"/>
          <ac:spMkLst>
            <pc:docMk/>
            <pc:sldMk cId="1267986695" sldId="263"/>
            <ac:spMk id="26" creationId="{C8AD3FA0-91D1-C89A-BD5C-192A99E78AA9}"/>
          </ac:spMkLst>
        </pc:spChg>
        <pc:spChg chg="mod">
          <ac:chgData name="Kassidy V Herrin" userId="S::kherr17@lsu.edu::78f2563c-1de5-4d7a-85bd-6e884350cb72" providerId="AD" clId="Web-{1196EBE1-F11E-98F8-FDEA-CFDA453928A8}" dt="2024-04-24T17:16:05.046" v="14" actId="1076"/>
          <ac:spMkLst>
            <pc:docMk/>
            <pc:sldMk cId="1267986695" sldId="263"/>
            <ac:spMk id="27" creationId="{E8598A00-C0A7-013C-851B-D8D74B2D51DB}"/>
          </ac:spMkLst>
        </pc:spChg>
        <pc:spChg chg="mod">
          <ac:chgData name="Kassidy V Herrin" userId="S::kherr17@lsu.edu::78f2563c-1de5-4d7a-85bd-6e884350cb72" providerId="AD" clId="Web-{1196EBE1-F11E-98F8-FDEA-CFDA453928A8}" dt="2024-04-24T17:50:00.105" v="178" actId="1076"/>
          <ac:spMkLst>
            <pc:docMk/>
            <pc:sldMk cId="1267986695" sldId="263"/>
            <ac:spMk id="31" creationId="{7F2FB729-B800-3746-3C27-976B0D44BD25}"/>
          </ac:spMkLst>
        </pc:spChg>
        <pc:spChg chg="mod">
          <ac:chgData name="Kassidy V Herrin" userId="S::kherr17@lsu.edu::78f2563c-1de5-4d7a-85bd-6e884350cb72" providerId="AD" clId="Web-{1196EBE1-F11E-98F8-FDEA-CFDA453928A8}" dt="2024-04-24T17:51:26.984" v="181" actId="1076"/>
          <ac:spMkLst>
            <pc:docMk/>
            <pc:sldMk cId="1267986695" sldId="263"/>
            <ac:spMk id="14339" creationId="{00000000-0000-0000-0000-000000000000}"/>
          </ac:spMkLst>
        </pc:spChg>
        <pc:spChg chg="add del mod">
          <ac:chgData name="Kassidy V Herrin" userId="S::kherr17@lsu.edu::78f2563c-1de5-4d7a-85bd-6e884350cb72" providerId="AD" clId="Web-{1196EBE1-F11E-98F8-FDEA-CFDA453928A8}" dt="2024-04-24T17:54:06.069" v="198" actId="1076"/>
          <ac:spMkLst>
            <pc:docMk/>
            <pc:sldMk cId="1267986695" sldId="263"/>
            <ac:spMk id="14340" creationId="{00000000-0000-0000-0000-000000000000}"/>
          </ac:spMkLst>
        </pc:spChg>
        <pc:spChg chg="mod">
          <ac:chgData name="Kassidy V Herrin" userId="S::kherr17@lsu.edu::78f2563c-1de5-4d7a-85bd-6e884350cb72" providerId="AD" clId="Web-{1196EBE1-F11E-98F8-FDEA-CFDA453928A8}" dt="2024-04-24T17:54:51.446" v="206" actId="14100"/>
          <ac:spMkLst>
            <pc:docMk/>
            <pc:sldMk cId="1267986695" sldId="263"/>
            <ac:spMk id="14341" creationId="{00000000-0000-0000-0000-000000000000}"/>
          </ac:spMkLst>
        </pc:spChg>
        <pc:spChg chg="mod">
          <ac:chgData name="Kassidy V Herrin" userId="S::kherr17@lsu.edu::78f2563c-1de5-4d7a-85bd-6e884350cb72" providerId="AD" clId="Web-{1196EBE1-F11E-98F8-FDEA-CFDA453928A8}" dt="2024-04-24T17:22:20.609" v="80" actId="1076"/>
          <ac:spMkLst>
            <pc:docMk/>
            <pc:sldMk cId="1267986695" sldId="263"/>
            <ac:spMk id="14342" creationId="{00000000-0000-0000-0000-000000000000}"/>
          </ac:spMkLst>
        </pc:spChg>
        <pc:spChg chg="mod">
          <ac:chgData name="Kassidy V Herrin" userId="S::kherr17@lsu.edu::78f2563c-1de5-4d7a-85bd-6e884350cb72" providerId="AD" clId="Web-{1196EBE1-F11E-98F8-FDEA-CFDA453928A8}" dt="2024-04-24T17:54:25.851" v="201" actId="14100"/>
          <ac:spMkLst>
            <pc:docMk/>
            <pc:sldMk cId="1267986695" sldId="263"/>
            <ac:spMk id="14343" creationId="{00000000-0000-0000-0000-000000000000}"/>
          </ac:spMkLst>
        </pc:spChg>
        <pc:picChg chg="del">
          <ac:chgData name="Kassidy V Herrin" userId="S::kherr17@lsu.edu::78f2563c-1de5-4d7a-85bd-6e884350cb72" providerId="AD" clId="Web-{1196EBE1-F11E-98F8-FDEA-CFDA453928A8}" dt="2024-04-24T17:15:08.105" v="0"/>
          <ac:picMkLst>
            <pc:docMk/>
            <pc:sldMk cId="1267986695" sldId="263"/>
            <ac:picMk id="6" creationId="{BF51E4AA-6805-7671-496A-A433D6BF0AD4}"/>
          </ac:picMkLst>
        </pc:picChg>
        <pc:picChg chg="del">
          <ac:chgData name="Kassidy V Herrin" userId="S::kherr17@lsu.edu::78f2563c-1de5-4d7a-85bd-6e884350cb72" providerId="AD" clId="Web-{1196EBE1-F11E-98F8-FDEA-CFDA453928A8}" dt="2024-04-24T17:18:48.818" v="46"/>
          <ac:picMkLst>
            <pc:docMk/>
            <pc:sldMk cId="1267986695" sldId="263"/>
            <ac:picMk id="7" creationId="{F8C19FE8-4253-EE09-6259-892CD191FD7C}"/>
          </ac:picMkLst>
        </pc:picChg>
        <pc:picChg chg="add mod">
          <ac:chgData name="Kassidy V Herrin" userId="S::kherr17@lsu.edu::78f2563c-1de5-4d7a-85bd-6e884350cb72" providerId="AD" clId="Web-{1196EBE1-F11E-98F8-FDEA-CFDA453928A8}" dt="2024-04-24T17:23:37.191" v="87"/>
          <ac:picMkLst>
            <pc:docMk/>
            <pc:sldMk cId="1267986695" sldId="263"/>
            <ac:picMk id="8" creationId="{5B0D1962-0B43-CF5F-45F3-9A9D490074A5}"/>
          </ac:picMkLst>
        </pc:picChg>
        <pc:picChg chg="add mod">
          <ac:chgData name="Kassidy V Herrin" userId="S::kherr17@lsu.edu::78f2563c-1de5-4d7a-85bd-6e884350cb72" providerId="AD" clId="Web-{1196EBE1-F11E-98F8-FDEA-CFDA453928A8}" dt="2024-04-24T17:20:59.340" v="68" actId="1076"/>
          <ac:picMkLst>
            <pc:docMk/>
            <pc:sldMk cId="1267986695" sldId="263"/>
            <ac:picMk id="10" creationId="{6BF1A5FE-F89A-88D7-93B9-E97A105CC5A6}"/>
          </ac:picMkLst>
        </pc:picChg>
      </pc:sldChg>
    </pc:docChg>
  </pc:docChgLst>
  <pc:docChgLst>
    <pc:chgData name="Kassidy V Herrin" userId="S::kherr17@lsu.edu::78f2563c-1de5-4d7a-85bd-6e884350cb72" providerId="AD" clId="Web-{C4EFF7E4-BE22-CE0E-1BA1-6B6A4FD45C78}"/>
    <pc:docChg chg="modSld">
      <pc:chgData name="Kassidy V Herrin" userId="S::kherr17@lsu.edu::78f2563c-1de5-4d7a-85bd-6e884350cb72" providerId="AD" clId="Web-{C4EFF7E4-BE22-CE0E-1BA1-6B6A4FD45C78}" dt="2024-04-24T01:09:02.744" v="6" actId="20577"/>
      <pc:docMkLst>
        <pc:docMk/>
      </pc:docMkLst>
      <pc:sldChg chg="modSp">
        <pc:chgData name="Kassidy V Herrin" userId="S::kherr17@lsu.edu::78f2563c-1de5-4d7a-85bd-6e884350cb72" providerId="AD" clId="Web-{C4EFF7E4-BE22-CE0E-1BA1-6B6A4FD45C78}" dt="2024-04-24T01:09:02.744" v="6" actId="20577"/>
        <pc:sldMkLst>
          <pc:docMk/>
          <pc:sldMk cId="1267986695" sldId="263"/>
        </pc:sldMkLst>
        <pc:spChg chg="mod">
          <ac:chgData name="Kassidy V Herrin" userId="S::kherr17@lsu.edu::78f2563c-1de5-4d7a-85bd-6e884350cb72" providerId="AD" clId="Web-{C4EFF7E4-BE22-CE0E-1BA1-6B6A4FD45C78}" dt="2024-04-24T01:09:02.744" v="6" actId="20577"/>
          <ac:spMkLst>
            <pc:docMk/>
            <pc:sldMk cId="1267986695" sldId="263"/>
            <ac:spMk id="14340" creationId="{00000000-0000-0000-0000-000000000000}"/>
          </ac:spMkLst>
        </pc:spChg>
      </pc:sldChg>
    </pc:docChg>
  </pc:docChgLst>
  <pc:docChgLst>
    <pc:chgData name="Zainalabedeen N Al Naseri" userId="S::zalnas2@lsu.edu::9807e083-1870-42e3-b813-d3919d9d723c" providerId="AD" clId="Web-{A4C369C3-095A-5CE9-0F9E-E63957E58DC5}"/>
    <pc:docChg chg="modSld">
      <pc:chgData name="Zainalabedeen N Al Naseri" userId="S::zalnas2@lsu.edu::9807e083-1870-42e3-b813-d3919d9d723c" providerId="AD" clId="Web-{A4C369C3-095A-5CE9-0F9E-E63957E58DC5}" dt="2024-04-24T19:05:47.096" v="209"/>
      <pc:docMkLst>
        <pc:docMk/>
      </pc:docMkLst>
      <pc:sldChg chg="modSp">
        <pc:chgData name="Zainalabedeen N Al Naseri" userId="S::zalnas2@lsu.edu::9807e083-1870-42e3-b813-d3919d9d723c" providerId="AD" clId="Web-{A4C369C3-095A-5CE9-0F9E-E63957E58DC5}" dt="2024-04-24T19:05:47.096" v="209"/>
        <pc:sldMkLst>
          <pc:docMk/>
          <pc:sldMk cId="1267986695" sldId="263"/>
        </pc:sldMkLst>
        <pc:spChg chg="mod">
          <ac:chgData name="Zainalabedeen N Al Naseri" userId="S::zalnas2@lsu.edu::9807e083-1870-42e3-b813-d3919d9d723c" providerId="AD" clId="Web-{A4C369C3-095A-5CE9-0F9E-E63957E58DC5}" dt="2024-04-24T19:05:47.096" v="209"/>
          <ac:spMkLst>
            <pc:docMk/>
            <pc:sldMk cId="1267986695" sldId="263"/>
            <ac:spMk id="7" creationId="{EE761138-33B1-0299-BC55-977C0A61093D}"/>
          </ac:spMkLst>
        </pc:spChg>
        <pc:spChg chg="mod ord">
          <ac:chgData name="Zainalabedeen N Al Naseri" userId="S::zalnas2@lsu.edu::9807e083-1870-42e3-b813-d3919d9d723c" providerId="AD" clId="Web-{A4C369C3-095A-5CE9-0F9E-E63957E58DC5}" dt="2024-04-24T18:58:23.581" v="145" actId="1076"/>
          <ac:spMkLst>
            <pc:docMk/>
            <pc:sldMk cId="1267986695" sldId="263"/>
            <ac:spMk id="9" creationId="{A899D352-40E7-A6C6-BD2E-9467BAA1D812}"/>
          </ac:spMkLst>
        </pc:spChg>
        <pc:spChg chg="mod">
          <ac:chgData name="Zainalabedeen N Al Naseri" userId="S::zalnas2@lsu.edu::9807e083-1870-42e3-b813-d3919d9d723c" providerId="AD" clId="Web-{A4C369C3-095A-5CE9-0F9E-E63957E58DC5}" dt="2024-04-24T19:03:26.232" v="176" actId="1076"/>
          <ac:spMkLst>
            <pc:docMk/>
            <pc:sldMk cId="1267986695" sldId="263"/>
            <ac:spMk id="16" creationId="{00000000-0000-0000-0000-000000000000}"/>
          </ac:spMkLst>
        </pc:spChg>
        <pc:spChg chg="mod">
          <ac:chgData name="Zainalabedeen N Al Naseri" userId="S::zalnas2@lsu.edu::9807e083-1870-42e3-b813-d3919d9d723c" providerId="AD" clId="Web-{A4C369C3-095A-5CE9-0F9E-E63957E58DC5}" dt="2024-04-24T18:54:29.339" v="136" actId="1076"/>
          <ac:spMkLst>
            <pc:docMk/>
            <pc:sldMk cId="1267986695" sldId="263"/>
            <ac:spMk id="24" creationId="{98E8D37B-B528-A794-086D-319C56A08178}"/>
          </ac:spMkLst>
        </pc:spChg>
        <pc:spChg chg="mod">
          <ac:chgData name="Zainalabedeen N Al Naseri" userId="S::zalnas2@lsu.edu::9807e083-1870-42e3-b813-d3919d9d723c" providerId="AD" clId="Web-{A4C369C3-095A-5CE9-0F9E-E63957E58DC5}" dt="2024-04-24T18:58:37.004" v="146" actId="1076"/>
          <ac:spMkLst>
            <pc:docMk/>
            <pc:sldMk cId="1267986695" sldId="263"/>
            <ac:spMk id="26" creationId="{C8AD3FA0-91D1-C89A-BD5C-192A99E78AA9}"/>
          </ac:spMkLst>
        </pc:spChg>
        <pc:spChg chg="mod">
          <ac:chgData name="Zainalabedeen N Al Naseri" userId="S::zalnas2@lsu.edu::9807e083-1870-42e3-b813-d3919d9d723c" providerId="AD" clId="Web-{A4C369C3-095A-5CE9-0F9E-E63957E58DC5}" dt="2024-04-24T18:59:01.379" v="147" actId="1076"/>
          <ac:spMkLst>
            <pc:docMk/>
            <pc:sldMk cId="1267986695" sldId="263"/>
            <ac:spMk id="27" creationId="{E8598A00-C0A7-013C-851B-D8D74B2D51DB}"/>
          </ac:spMkLst>
        </pc:spChg>
        <pc:spChg chg="mod">
          <ac:chgData name="Zainalabedeen N Al Naseri" userId="S::zalnas2@lsu.edu::9807e083-1870-42e3-b813-d3919d9d723c" providerId="AD" clId="Web-{A4C369C3-095A-5CE9-0F9E-E63957E58DC5}" dt="2024-04-24T18:57:57.658" v="142" actId="1076"/>
          <ac:spMkLst>
            <pc:docMk/>
            <pc:sldMk cId="1267986695" sldId="263"/>
            <ac:spMk id="28" creationId="{84F975A6-A238-8411-DA25-164A62D0BA44}"/>
          </ac:spMkLst>
        </pc:spChg>
        <pc:spChg chg="mod">
          <ac:chgData name="Zainalabedeen N Al Naseri" userId="S::zalnas2@lsu.edu::9807e083-1870-42e3-b813-d3919d9d723c" providerId="AD" clId="Web-{A4C369C3-095A-5CE9-0F9E-E63957E58DC5}" dt="2024-04-24T19:04:55.735" v="208" actId="14100"/>
          <ac:spMkLst>
            <pc:docMk/>
            <pc:sldMk cId="1267986695" sldId="263"/>
            <ac:spMk id="34" creationId="{AF943511-BF14-7164-A804-4EE36C99301B}"/>
          </ac:spMkLst>
        </pc:spChg>
        <pc:spChg chg="mod">
          <ac:chgData name="Zainalabedeen N Al Naseri" userId="S::zalnas2@lsu.edu::9807e083-1870-42e3-b813-d3919d9d723c" providerId="AD" clId="Web-{A4C369C3-095A-5CE9-0F9E-E63957E58DC5}" dt="2024-04-24T18:40:39.482" v="13" actId="1076"/>
          <ac:spMkLst>
            <pc:docMk/>
            <pc:sldMk cId="1267986695" sldId="263"/>
            <ac:spMk id="14342" creationId="{00000000-0000-0000-0000-000000000000}"/>
          </ac:spMkLst>
        </pc:spChg>
        <pc:graphicFrameChg chg="mod modGraphic">
          <ac:chgData name="Zainalabedeen N Al Naseri" userId="S::zalnas2@lsu.edu::9807e083-1870-42e3-b813-d3919d9d723c" providerId="AD" clId="Web-{A4C369C3-095A-5CE9-0F9E-E63957E58DC5}" dt="2024-04-24T18:57:54.408" v="141" actId="1076"/>
          <ac:graphicFrameMkLst>
            <pc:docMk/>
            <pc:sldMk cId="1267986695" sldId="263"/>
            <ac:graphicFrameMk id="11" creationId="{65AEACB9-B21E-7C82-A5B3-68920EEDC493}"/>
          </ac:graphicFrameMkLst>
        </pc:graphicFrameChg>
        <pc:picChg chg="mod modCrop">
          <ac:chgData name="Zainalabedeen N Al Naseri" userId="S::zalnas2@lsu.edu::9807e083-1870-42e3-b813-d3919d9d723c" providerId="AD" clId="Web-{A4C369C3-095A-5CE9-0F9E-E63957E58DC5}" dt="2024-04-24T19:02:35.184" v="160"/>
          <ac:picMkLst>
            <pc:docMk/>
            <pc:sldMk cId="1267986695" sldId="263"/>
            <ac:picMk id="8" creationId="{5B0D1962-0B43-CF5F-45F3-9A9D490074A5}"/>
          </ac:picMkLst>
        </pc:picChg>
        <pc:picChg chg="mod">
          <ac:chgData name="Zainalabedeen N Al Naseri" userId="S::zalnas2@lsu.edu::9807e083-1870-42e3-b813-d3919d9d723c" providerId="AD" clId="Web-{A4C369C3-095A-5CE9-0F9E-E63957E58DC5}" dt="2024-04-24T18:58:09.049" v="143" actId="1076"/>
          <ac:picMkLst>
            <pc:docMk/>
            <pc:sldMk cId="1267986695" sldId="263"/>
            <ac:picMk id="10" creationId="{6BF1A5FE-F89A-88D7-93B9-E97A105CC5A6}"/>
          </ac:picMkLst>
        </pc:picChg>
      </pc:sldChg>
    </pc:docChg>
  </pc:docChgLst>
  <pc:docChgLst>
    <pc:chgData name="Zainalabedeen N Al Naseri" userId="S::zalnas2@lsu.edu::9807e083-1870-42e3-b813-d3919d9d723c" providerId="AD" clId="Web-{E2C00BC5-611D-A2D1-624D-5363A92191BA}"/>
    <pc:docChg chg="modSld">
      <pc:chgData name="Zainalabedeen N Al Naseri" userId="S::zalnas2@lsu.edu::9807e083-1870-42e3-b813-d3919d9d723c" providerId="AD" clId="Web-{E2C00BC5-611D-A2D1-624D-5363A92191BA}" dt="2024-04-24T17:52:10.943" v="107"/>
      <pc:docMkLst>
        <pc:docMk/>
      </pc:docMkLst>
      <pc:sldChg chg="modSp">
        <pc:chgData name="Zainalabedeen N Al Naseri" userId="S::zalnas2@lsu.edu::9807e083-1870-42e3-b813-d3919d9d723c" providerId="AD" clId="Web-{E2C00BC5-611D-A2D1-624D-5363A92191BA}" dt="2024-04-24T17:52:10.943" v="107"/>
        <pc:sldMkLst>
          <pc:docMk/>
          <pc:sldMk cId="1267986695" sldId="263"/>
        </pc:sldMkLst>
        <pc:spChg chg="mod">
          <ac:chgData name="Zainalabedeen N Al Naseri" userId="S::zalnas2@lsu.edu::9807e083-1870-42e3-b813-d3919d9d723c" providerId="AD" clId="Web-{E2C00BC5-611D-A2D1-624D-5363A92191BA}" dt="2024-04-24T17:51:16.708" v="98" actId="20577"/>
          <ac:spMkLst>
            <pc:docMk/>
            <pc:sldMk cId="1267986695" sldId="263"/>
            <ac:spMk id="26" creationId="{C8AD3FA0-91D1-C89A-BD5C-192A99E78AA9}"/>
          </ac:spMkLst>
        </pc:spChg>
        <pc:spChg chg="mod">
          <ac:chgData name="Zainalabedeen N Al Naseri" userId="S::zalnas2@lsu.edu::9807e083-1870-42e3-b813-d3919d9d723c" providerId="AD" clId="Web-{E2C00BC5-611D-A2D1-624D-5363A92191BA}" dt="2024-04-24T17:52:10.943" v="107"/>
          <ac:spMkLst>
            <pc:docMk/>
            <pc:sldMk cId="1267986695" sldId="263"/>
            <ac:spMk id="27" creationId="{E8598A00-C0A7-013C-851B-D8D74B2D51DB}"/>
          </ac:spMkLst>
        </pc:spChg>
        <pc:picChg chg="mod">
          <ac:chgData name="Zainalabedeen N Al Naseri" userId="S::zalnas2@lsu.edu::9807e083-1870-42e3-b813-d3919d9d723c" providerId="AD" clId="Web-{E2C00BC5-611D-A2D1-624D-5363A92191BA}" dt="2024-04-24T17:48:49.753" v="2" actId="1076"/>
          <ac:picMkLst>
            <pc:docMk/>
            <pc:sldMk cId="1267986695" sldId="263"/>
            <ac:picMk id="8" creationId="{5B0D1962-0B43-CF5F-45F3-9A9D490074A5}"/>
          </ac:picMkLst>
        </pc:picChg>
      </pc:sldChg>
    </pc:docChg>
  </pc:docChgLst>
  <pc:docChgLst>
    <pc:chgData name="Jada Daniels" userId="S::jdani87@lsu.edu::8970acce-57c7-4559-8174-5ce60882e72d" providerId="AD" clId="Web-{D9F428F8-B76F-4CCB-36D7-23EE754D8015}"/>
    <pc:docChg chg="modSld">
      <pc:chgData name="Jada Daniels" userId="S::jdani87@lsu.edu::8970acce-57c7-4559-8174-5ce60882e72d" providerId="AD" clId="Web-{D9F428F8-B76F-4CCB-36D7-23EE754D8015}" dt="2024-04-24T18:26:16.342" v="74" actId="1076"/>
      <pc:docMkLst>
        <pc:docMk/>
      </pc:docMkLst>
      <pc:sldChg chg="delSp modSp">
        <pc:chgData name="Jada Daniels" userId="S::jdani87@lsu.edu::8970acce-57c7-4559-8174-5ce60882e72d" providerId="AD" clId="Web-{D9F428F8-B76F-4CCB-36D7-23EE754D8015}" dt="2024-04-24T18:26:16.342" v="74" actId="1076"/>
        <pc:sldMkLst>
          <pc:docMk/>
          <pc:sldMk cId="1267986695" sldId="263"/>
        </pc:sldMkLst>
        <pc:spChg chg="mod">
          <ac:chgData name="Jada Daniels" userId="S::jdani87@lsu.edu::8970acce-57c7-4559-8174-5ce60882e72d" providerId="AD" clId="Web-{D9F428F8-B76F-4CCB-36D7-23EE754D8015}" dt="2024-04-24T18:26:02.186" v="72" actId="1076"/>
          <ac:spMkLst>
            <pc:docMk/>
            <pc:sldMk cId="1267986695" sldId="263"/>
            <ac:spMk id="9" creationId="{A899D352-40E7-A6C6-BD2E-9467BAA1D812}"/>
          </ac:spMkLst>
        </pc:spChg>
        <pc:spChg chg="mod">
          <ac:chgData name="Jada Daniels" userId="S::jdani87@lsu.edu::8970acce-57c7-4559-8174-5ce60882e72d" providerId="AD" clId="Web-{D9F428F8-B76F-4CCB-36D7-23EE754D8015}" dt="2024-04-24T18:26:11.311" v="73" actId="1076"/>
          <ac:spMkLst>
            <pc:docMk/>
            <pc:sldMk cId="1267986695" sldId="263"/>
            <ac:spMk id="24" creationId="{98E8D37B-B528-A794-086D-319C56A08178}"/>
          </ac:spMkLst>
        </pc:spChg>
        <pc:spChg chg="mod">
          <ac:chgData name="Jada Daniels" userId="S::jdani87@lsu.edu::8970acce-57c7-4559-8174-5ce60882e72d" providerId="AD" clId="Web-{D9F428F8-B76F-4CCB-36D7-23EE754D8015}" dt="2024-04-24T18:25:58.139" v="71" actId="1076"/>
          <ac:spMkLst>
            <pc:docMk/>
            <pc:sldMk cId="1267986695" sldId="263"/>
            <ac:spMk id="26" creationId="{C8AD3FA0-91D1-C89A-BD5C-192A99E78AA9}"/>
          </ac:spMkLst>
        </pc:spChg>
        <pc:spChg chg="mod">
          <ac:chgData name="Jada Daniels" userId="S::jdani87@lsu.edu::8970acce-57c7-4559-8174-5ce60882e72d" providerId="AD" clId="Web-{D9F428F8-B76F-4CCB-36D7-23EE754D8015}" dt="2024-04-24T18:24:10.838" v="64" actId="1076"/>
          <ac:spMkLst>
            <pc:docMk/>
            <pc:sldMk cId="1267986695" sldId="263"/>
            <ac:spMk id="27" creationId="{E8598A00-C0A7-013C-851B-D8D74B2D51DB}"/>
          </ac:spMkLst>
        </pc:spChg>
        <pc:spChg chg="mod">
          <ac:chgData name="Jada Daniels" userId="S::jdani87@lsu.edu::8970acce-57c7-4559-8174-5ce60882e72d" providerId="AD" clId="Web-{D9F428F8-B76F-4CCB-36D7-23EE754D8015}" dt="2024-04-24T18:26:16.342" v="74" actId="1076"/>
          <ac:spMkLst>
            <pc:docMk/>
            <pc:sldMk cId="1267986695" sldId="263"/>
            <ac:spMk id="28" creationId="{84F975A6-A238-8411-DA25-164A62D0BA44}"/>
          </ac:spMkLst>
        </pc:spChg>
        <pc:spChg chg="del mod">
          <ac:chgData name="Jada Daniels" userId="S::jdani87@lsu.edu::8970acce-57c7-4559-8174-5ce60882e72d" providerId="AD" clId="Web-{D9F428F8-B76F-4CCB-36D7-23EE754D8015}" dt="2024-04-24T18:22:58.211" v="47"/>
          <ac:spMkLst>
            <pc:docMk/>
            <pc:sldMk cId="1267986695" sldId="263"/>
            <ac:spMk id="29" creationId="{3B0154AA-D7C9-DE32-B3EA-F9DF027734DD}"/>
          </ac:spMkLst>
        </pc:spChg>
        <pc:spChg chg="mod">
          <ac:chgData name="Jada Daniels" userId="S::jdani87@lsu.edu::8970acce-57c7-4559-8174-5ce60882e72d" providerId="AD" clId="Web-{D9F428F8-B76F-4CCB-36D7-23EE754D8015}" dt="2024-04-24T18:20:58.473" v="42" actId="20577"/>
          <ac:spMkLst>
            <pc:docMk/>
            <pc:sldMk cId="1267986695" sldId="263"/>
            <ac:spMk id="34" creationId="{AF943511-BF14-7164-A804-4EE36C99301B}"/>
          </ac:spMkLst>
        </pc:spChg>
        <pc:spChg chg="mod">
          <ac:chgData name="Jada Daniels" userId="S::jdani87@lsu.edu::8970acce-57c7-4559-8174-5ce60882e72d" providerId="AD" clId="Web-{D9F428F8-B76F-4CCB-36D7-23EE754D8015}" dt="2024-04-24T18:20:36.956" v="40" actId="688"/>
          <ac:spMkLst>
            <pc:docMk/>
            <pc:sldMk cId="1267986695" sldId="263"/>
            <ac:spMk id="37" creationId="{C0F06F95-DEC7-2E2C-5084-BC64E3C17B22}"/>
          </ac:spMkLst>
        </pc:spChg>
        <pc:spChg chg="mod">
          <ac:chgData name="Jada Daniels" userId="S::jdani87@lsu.edu::8970acce-57c7-4559-8174-5ce60882e72d" providerId="AD" clId="Web-{D9F428F8-B76F-4CCB-36D7-23EE754D8015}" dt="2024-04-24T18:25:48.217" v="70" actId="1076"/>
          <ac:spMkLst>
            <pc:docMk/>
            <pc:sldMk cId="1267986695" sldId="263"/>
            <ac:spMk id="14342" creationId="{00000000-0000-0000-0000-000000000000}"/>
          </ac:spMkLst>
        </pc:spChg>
        <pc:spChg chg="mod">
          <ac:chgData name="Jada Daniels" userId="S::jdani87@lsu.edu::8970acce-57c7-4559-8174-5ce60882e72d" providerId="AD" clId="Web-{D9F428F8-B76F-4CCB-36D7-23EE754D8015}" dt="2024-04-24T18:20:33.269" v="38" actId="20577"/>
          <ac:spMkLst>
            <pc:docMk/>
            <pc:sldMk cId="1267986695" sldId="263"/>
            <ac:spMk id="14343" creationId="{00000000-0000-0000-0000-000000000000}"/>
          </ac:spMkLst>
        </pc:spChg>
        <pc:graphicFrameChg chg="mod modGraphic">
          <ac:chgData name="Jada Daniels" userId="S::jdani87@lsu.edu::8970acce-57c7-4559-8174-5ce60882e72d" providerId="AD" clId="Web-{D9F428F8-B76F-4CCB-36D7-23EE754D8015}" dt="2024-04-24T18:25:37.451" v="68" actId="1076"/>
          <ac:graphicFrameMkLst>
            <pc:docMk/>
            <pc:sldMk cId="1267986695" sldId="263"/>
            <ac:graphicFrameMk id="11" creationId="{65AEACB9-B21E-7C82-A5B3-68920EEDC493}"/>
          </ac:graphicFrameMkLst>
        </pc:graphicFrameChg>
        <pc:graphicFrameChg chg="del">
          <ac:chgData name="Jada Daniels" userId="S::jdani87@lsu.edu::8970acce-57c7-4559-8174-5ce60882e72d" providerId="AD" clId="Web-{D9F428F8-B76F-4CCB-36D7-23EE754D8015}" dt="2024-04-24T18:22:54.008" v="45"/>
          <ac:graphicFrameMkLst>
            <pc:docMk/>
            <pc:sldMk cId="1267986695" sldId="263"/>
            <ac:graphicFrameMk id="18" creationId="{69054485-4FB5-72F0-B2EE-9B067C9ACEE1}"/>
          </ac:graphicFrameMkLst>
        </pc:graphicFrameChg>
        <pc:picChg chg="mod">
          <ac:chgData name="Jada Daniels" userId="S::jdani87@lsu.edu::8970acce-57c7-4559-8174-5ce60882e72d" providerId="AD" clId="Web-{D9F428F8-B76F-4CCB-36D7-23EE754D8015}" dt="2024-04-24T18:23:14.540" v="54" actId="1076"/>
          <ac:picMkLst>
            <pc:docMk/>
            <pc:sldMk cId="1267986695" sldId="263"/>
            <ac:picMk id="8" creationId="{5B0D1962-0B43-CF5F-45F3-9A9D490074A5}"/>
          </ac:picMkLst>
        </pc:picChg>
        <pc:picChg chg="mod">
          <ac:chgData name="Jada Daniels" userId="S::jdani87@lsu.edu::8970acce-57c7-4559-8174-5ce60882e72d" providerId="AD" clId="Web-{D9F428F8-B76F-4CCB-36D7-23EE754D8015}" dt="2024-04-24T18:23:15.977" v="55" actId="1076"/>
          <ac:picMkLst>
            <pc:docMk/>
            <pc:sldMk cId="1267986695" sldId="263"/>
            <ac:picMk id="10" creationId="{6BF1A5FE-F89A-88D7-93B9-E97A105CC5A6}"/>
          </ac:picMkLst>
        </pc:picChg>
      </pc:sldChg>
    </pc:docChg>
  </pc:docChgLst>
  <pc:docChgLst>
    <pc:chgData name="Charlotte E Robinson" userId="S::crob261@lsu.edu::b04a81f5-e1b9-4faa-b263-388a49954364" providerId="AD" clId="Web-{B0001E76-4EFE-3461-E5AE-039D314BCCD4}"/>
    <pc:docChg chg="modSld">
      <pc:chgData name="Charlotte E Robinson" userId="S::crob261@lsu.edu::b04a81f5-e1b9-4faa-b263-388a49954364" providerId="AD" clId="Web-{B0001E76-4EFE-3461-E5AE-039D314BCCD4}" dt="2024-04-15T21:03:51.101" v="49" actId="1076"/>
      <pc:docMkLst>
        <pc:docMk/>
      </pc:docMkLst>
      <pc:sldChg chg="modSp">
        <pc:chgData name="Charlotte E Robinson" userId="S::crob261@lsu.edu::b04a81f5-e1b9-4faa-b263-388a49954364" providerId="AD" clId="Web-{B0001E76-4EFE-3461-E5AE-039D314BCCD4}" dt="2024-04-15T21:03:51.101" v="49" actId="1076"/>
        <pc:sldMkLst>
          <pc:docMk/>
          <pc:sldMk cId="1267986695" sldId="263"/>
        </pc:sldMkLst>
        <pc:spChg chg="mod">
          <ac:chgData name="Charlotte E Robinson" userId="S::crob261@lsu.edu::b04a81f5-e1b9-4faa-b263-388a49954364" providerId="AD" clId="Web-{B0001E76-4EFE-3461-E5AE-039D314BCCD4}" dt="2024-04-15T21:02:25.035" v="47" actId="1076"/>
          <ac:spMkLst>
            <pc:docMk/>
            <pc:sldMk cId="1267986695" sldId="263"/>
            <ac:spMk id="14" creationId="{00000000-0000-0000-0000-000000000000}"/>
          </ac:spMkLst>
        </pc:spChg>
        <pc:spChg chg="mod">
          <ac:chgData name="Charlotte E Robinson" userId="S::crob261@lsu.edu::b04a81f5-e1b9-4faa-b263-388a49954364" providerId="AD" clId="Web-{B0001E76-4EFE-3461-E5AE-039D314BCCD4}" dt="2024-04-15T21:03:51.101" v="49" actId="1076"/>
          <ac:spMkLst>
            <pc:docMk/>
            <pc:sldMk cId="1267986695" sldId="263"/>
            <ac:spMk id="15" creationId="{00000000-0000-0000-0000-000000000000}"/>
          </ac:spMkLst>
        </pc:spChg>
        <pc:spChg chg="mod">
          <ac:chgData name="Charlotte E Robinson" userId="S::crob261@lsu.edu::b04a81f5-e1b9-4faa-b263-388a49954364" providerId="AD" clId="Web-{B0001E76-4EFE-3461-E5AE-039D314BCCD4}" dt="2024-04-15T20:59:34.857" v="8" actId="20577"/>
          <ac:spMkLst>
            <pc:docMk/>
            <pc:sldMk cId="1267986695" sldId="263"/>
            <ac:spMk id="19" creationId="{00000000-0000-0000-0000-000000000000}"/>
          </ac:spMkLst>
        </pc:spChg>
        <pc:spChg chg="mod">
          <ac:chgData name="Charlotte E Robinson" userId="S::crob261@lsu.edu::b04a81f5-e1b9-4faa-b263-388a49954364" providerId="AD" clId="Web-{B0001E76-4EFE-3461-E5AE-039D314BCCD4}" dt="2024-04-15T20:57:41.212" v="5" actId="14100"/>
          <ac:spMkLst>
            <pc:docMk/>
            <pc:sldMk cId="1267986695" sldId="263"/>
            <ac:spMk id="22" creationId="{00000000-0000-0000-0000-000000000000}"/>
          </ac:spMkLst>
        </pc:spChg>
        <pc:spChg chg="mod">
          <ac:chgData name="Charlotte E Robinson" userId="S::crob261@lsu.edu::b04a81f5-e1b9-4faa-b263-388a49954364" providerId="AD" clId="Web-{B0001E76-4EFE-3461-E5AE-039D314BCCD4}" dt="2024-04-15T21:02:16.847" v="46" actId="14100"/>
          <ac:spMkLst>
            <pc:docMk/>
            <pc:sldMk cId="1267986695" sldId="263"/>
            <ac:spMk id="14339" creationId="{00000000-0000-0000-0000-000000000000}"/>
          </ac:spMkLst>
        </pc:spChg>
        <pc:spChg chg="mod">
          <ac:chgData name="Charlotte E Robinson" userId="S::crob261@lsu.edu::b04a81f5-e1b9-4faa-b263-388a49954364" providerId="AD" clId="Web-{B0001E76-4EFE-3461-E5AE-039D314BCCD4}" dt="2024-04-15T21:02:10.972" v="45" actId="14100"/>
          <ac:spMkLst>
            <pc:docMk/>
            <pc:sldMk cId="1267986695" sldId="263"/>
            <ac:spMk id="14340" creationId="{00000000-0000-0000-0000-000000000000}"/>
          </ac:spMkLst>
        </pc:spChg>
        <pc:spChg chg="mod">
          <ac:chgData name="Charlotte E Robinson" userId="S::crob261@lsu.edu::b04a81f5-e1b9-4faa-b263-388a49954364" providerId="AD" clId="Web-{B0001E76-4EFE-3461-E5AE-039D314BCCD4}" dt="2024-04-15T20:57:31.352" v="4" actId="14100"/>
          <ac:spMkLst>
            <pc:docMk/>
            <pc:sldMk cId="1267986695" sldId="263"/>
            <ac:spMk id="14343" creationId="{00000000-0000-0000-0000-000000000000}"/>
          </ac:spMkLst>
        </pc:spChg>
      </pc:sldChg>
    </pc:docChg>
  </pc:docChgLst>
  <pc:docChgLst>
    <pc:chgData name="Zainalabedeen N Al Naseri" userId="9807e083-1870-42e3-b813-d3919d9d723c" providerId="ADAL" clId="{FA808040-3F2B-4FC1-BDD2-9095003EE8F3}"/>
    <pc:docChg chg="undo redo custSel addSld delSld modSld">
      <pc:chgData name="Zainalabedeen N Al Naseri" userId="9807e083-1870-42e3-b813-d3919d9d723c" providerId="ADAL" clId="{FA808040-3F2B-4FC1-BDD2-9095003EE8F3}" dt="2024-04-16T01:44:46.480" v="1250" actId="1076"/>
      <pc:docMkLst>
        <pc:docMk/>
      </pc:docMkLst>
      <pc:sldChg chg="addSp delSp modSp mod">
        <pc:chgData name="Zainalabedeen N Al Naseri" userId="9807e083-1870-42e3-b813-d3919d9d723c" providerId="ADAL" clId="{FA808040-3F2B-4FC1-BDD2-9095003EE8F3}" dt="2024-04-16T01:36:14.570" v="1186" actId="14100"/>
        <pc:sldMkLst>
          <pc:docMk/>
          <pc:sldMk cId="1267986695" sldId="263"/>
        </pc:sldMkLst>
        <pc:spChg chg="add del mod">
          <ac:chgData name="Zainalabedeen N Al Naseri" userId="9807e083-1870-42e3-b813-d3919d9d723c" providerId="ADAL" clId="{FA808040-3F2B-4FC1-BDD2-9095003EE8F3}" dt="2024-04-16T00:04:49.196" v="39" actId="478"/>
          <ac:spMkLst>
            <pc:docMk/>
            <pc:sldMk cId="1267986695" sldId="263"/>
            <ac:spMk id="10" creationId="{B66D5675-4B93-6876-C68A-0FE3003F4177}"/>
          </ac:spMkLst>
        </pc:spChg>
        <pc:spChg chg="mod">
          <ac:chgData name="Zainalabedeen N Al Naseri" userId="9807e083-1870-42e3-b813-d3919d9d723c" providerId="ADAL" clId="{FA808040-3F2B-4FC1-BDD2-9095003EE8F3}" dt="2024-04-16T00:36:33.909" v="88" actId="1076"/>
          <ac:spMkLst>
            <pc:docMk/>
            <pc:sldMk cId="1267986695" sldId="263"/>
            <ac:spMk id="14" creationId="{00000000-0000-0000-0000-000000000000}"/>
          </ac:spMkLst>
        </pc:spChg>
        <pc:spChg chg="mod">
          <ac:chgData name="Zainalabedeen N Al Naseri" userId="9807e083-1870-42e3-b813-d3919d9d723c" providerId="ADAL" clId="{FA808040-3F2B-4FC1-BDD2-9095003EE8F3}" dt="2024-04-16T00:36:12.332" v="85" actId="1076"/>
          <ac:spMkLst>
            <pc:docMk/>
            <pc:sldMk cId="1267986695" sldId="263"/>
            <ac:spMk id="15" creationId="{00000000-0000-0000-0000-000000000000}"/>
          </ac:spMkLst>
        </pc:spChg>
        <pc:spChg chg="mod">
          <ac:chgData name="Zainalabedeen N Al Naseri" userId="9807e083-1870-42e3-b813-d3919d9d723c" providerId="ADAL" clId="{FA808040-3F2B-4FC1-BDD2-9095003EE8F3}" dt="2024-04-16T01:02:20.800" v="203" actId="1076"/>
          <ac:spMkLst>
            <pc:docMk/>
            <pc:sldMk cId="1267986695" sldId="263"/>
            <ac:spMk id="16" creationId="{00000000-0000-0000-0000-000000000000}"/>
          </ac:spMkLst>
        </pc:spChg>
        <pc:spChg chg="add mod">
          <ac:chgData name="Zainalabedeen N Al Naseri" userId="9807e083-1870-42e3-b813-d3919d9d723c" providerId="ADAL" clId="{FA808040-3F2B-4FC1-BDD2-9095003EE8F3}" dt="2024-04-16T00:54:58.927" v="173" actId="255"/>
          <ac:spMkLst>
            <pc:docMk/>
            <pc:sldMk cId="1267986695" sldId="263"/>
            <ac:spMk id="26" creationId="{C8AD3FA0-91D1-C89A-BD5C-192A99E78AA9}"/>
          </ac:spMkLst>
        </pc:spChg>
        <pc:spChg chg="add mod">
          <ac:chgData name="Zainalabedeen N Al Naseri" userId="9807e083-1870-42e3-b813-d3919d9d723c" providerId="ADAL" clId="{FA808040-3F2B-4FC1-BDD2-9095003EE8F3}" dt="2024-04-16T00:55:05.976" v="174" actId="255"/>
          <ac:spMkLst>
            <pc:docMk/>
            <pc:sldMk cId="1267986695" sldId="263"/>
            <ac:spMk id="27" creationId="{E8598A00-C0A7-013C-851B-D8D74B2D51DB}"/>
          </ac:spMkLst>
        </pc:spChg>
        <pc:spChg chg="add mod">
          <ac:chgData name="Zainalabedeen N Al Naseri" userId="9807e083-1870-42e3-b813-d3919d9d723c" providerId="ADAL" clId="{FA808040-3F2B-4FC1-BDD2-9095003EE8F3}" dt="2024-04-16T00:54:47.092" v="172" actId="1076"/>
          <ac:spMkLst>
            <pc:docMk/>
            <pc:sldMk cId="1267986695" sldId="263"/>
            <ac:spMk id="28" creationId="{84F975A6-A238-8411-DA25-164A62D0BA44}"/>
          </ac:spMkLst>
        </pc:spChg>
        <pc:spChg chg="add mod">
          <ac:chgData name="Zainalabedeen N Al Naseri" userId="9807e083-1870-42e3-b813-d3919d9d723c" providerId="ADAL" clId="{FA808040-3F2B-4FC1-BDD2-9095003EE8F3}" dt="2024-04-16T00:59:55.529" v="182" actId="20577"/>
          <ac:spMkLst>
            <pc:docMk/>
            <pc:sldMk cId="1267986695" sldId="263"/>
            <ac:spMk id="29" creationId="{3B0154AA-D7C9-DE32-B3EA-F9DF027734DD}"/>
          </ac:spMkLst>
        </pc:spChg>
        <pc:spChg chg="add del mod">
          <ac:chgData name="Zainalabedeen N Al Naseri" userId="9807e083-1870-42e3-b813-d3919d9d723c" providerId="ADAL" clId="{FA808040-3F2B-4FC1-BDD2-9095003EE8F3}" dt="2024-04-16T01:00:41.745" v="186" actId="478"/>
          <ac:spMkLst>
            <pc:docMk/>
            <pc:sldMk cId="1267986695" sldId="263"/>
            <ac:spMk id="30" creationId="{B7406DC8-EFA0-CB34-71C7-BD8A9B7CCBA9}"/>
          </ac:spMkLst>
        </pc:spChg>
        <pc:spChg chg="add mod">
          <ac:chgData name="Zainalabedeen N Al Naseri" userId="9807e083-1870-42e3-b813-d3919d9d723c" providerId="ADAL" clId="{FA808040-3F2B-4FC1-BDD2-9095003EE8F3}" dt="2024-04-16T01:36:14.570" v="1186" actId="14100"/>
          <ac:spMkLst>
            <pc:docMk/>
            <pc:sldMk cId="1267986695" sldId="263"/>
            <ac:spMk id="31" creationId="{7F2FB729-B800-3746-3C27-976B0D44BD25}"/>
          </ac:spMkLst>
        </pc:spChg>
        <pc:spChg chg="add mod">
          <ac:chgData name="Zainalabedeen N Al Naseri" userId="9807e083-1870-42e3-b813-d3919d9d723c" providerId="ADAL" clId="{FA808040-3F2B-4FC1-BDD2-9095003EE8F3}" dt="2024-04-16T01:08:25.852" v="471" actId="20577"/>
          <ac:spMkLst>
            <pc:docMk/>
            <pc:sldMk cId="1267986695" sldId="263"/>
            <ac:spMk id="32" creationId="{44B01CFD-FD60-D4B8-9DB0-913901421BEE}"/>
          </ac:spMkLst>
        </pc:spChg>
        <pc:spChg chg="add mod">
          <ac:chgData name="Zainalabedeen N Al Naseri" userId="9807e083-1870-42e3-b813-d3919d9d723c" providerId="ADAL" clId="{FA808040-3F2B-4FC1-BDD2-9095003EE8F3}" dt="2024-04-16T01:09:27.324" v="492" actId="20577"/>
          <ac:spMkLst>
            <pc:docMk/>
            <pc:sldMk cId="1267986695" sldId="263"/>
            <ac:spMk id="33" creationId="{18B5C642-0B11-8A65-D021-2231F52627AA}"/>
          </ac:spMkLst>
        </pc:spChg>
        <pc:spChg chg="add mod">
          <ac:chgData name="Zainalabedeen N Al Naseri" userId="9807e083-1870-42e3-b813-d3919d9d723c" providerId="ADAL" clId="{FA808040-3F2B-4FC1-BDD2-9095003EE8F3}" dt="2024-04-16T01:11:34.740" v="656" actId="20577"/>
          <ac:spMkLst>
            <pc:docMk/>
            <pc:sldMk cId="1267986695" sldId="263"/>
            <ac:spMk id="34" creationId="{AF943511-BF14-7164-A804-4EE36C99301B}"/>
          </ac:spMkLst>
        </pc:spChg>
        <pc:spChg chg="add mod">
          <ac:chgData name="Zainalabedeen N Al Naseri" userId="9807e083-1870-42e3-b813-d3919d9d723c" providerId="ADAL" clId="{FA808040-3F2B-4FC1-BDD2-9095003EE8F3}" dt="2024-04-16T01:12:20.913" v="676" actId="20577"/>
          <ac:spMkLst>
            <pc:docMk/>
            <pc:sldMk cId="1267986695" sldId="263"/>
            <ac:spMk id="35" creationId="{69D7526D-8EC8-0C82-A5C3-7D255A0126AF}"/>
          </ac:spMkLst>
        </pc:spChg>
        <pc:spChg chg="add mod">
          <ac:chgData name="Zainalabedeen N Al Naseri" userId="9807e083-1870-42e3-b813-d3919d9d723c" providerId="ADAL" clId="{FA808040-3F2B-4FC1-BDD2-9095003EE8F3}" dt="2024-04-16T01:14:30.243" v="802" actId="208"/>
          <ac:spMkLst>
            <pc:docMk/>
            <pc:sldMk cId="1267986695" sldId="263"/>
            <ac:spMk id="36" creationId="{30EAF356-4807-BAF3-0908-80002FAFCE7E}"/>
          </ac:spMkLst>
        </pc:spChg>
        <pc:spChg chg="add mod">
          <ac:chgData name="Zainalabedeen N Al Naseri" userId="9807e083-1870-42e3-b813-d3919d9d723c" providerId="ADAL" clId="{FA808040-3F2B-4FC1-BDD2-9095003EE8F3}" dt="2024-04-16T01:18:22.376" v="1169" actId="122"/>
          <ac:spMkLst>
            <pc:docMk/>
            <pc:sldMk cId="1267986695" sldId="263"/>
            <ac:spMk id="37" creationId="{C0F06F95-DEC7-2E2C-5084-BC64E3C17B22}"/>
          </ac:spMkLst>
        </pc:spChg>
        <pc:spChg chg="mod">
          <ac:chgData name="Zainalabedeen N Al Naseri" userId="9807e083-1870-42e3-b813-d3919d9d723c" providerId="ADAL" clId="{FA808040-3F2B-4FC1-BDD2-9095003EE8F3}" dt="2024-04-16T00:36:37.658" v="89" actId="14100"/>
          <ac:spMkLst>
            <pc:docMk/>
            <pc:sldMk cId="1267986695" sldId="263"/>
            <ac:spMk id="14339" creationId="{00000000-0000-0000-0000-000000000000}"/>
          </ac:spMkLst>
        </pc:spChg>
        <pc:spChg chg="mod">
          <ac:chgData name="Zainalabedeen N Al Naseri" userId="9807e083-1870-42e3-b813-d3919d9d723c" providerId="ADAL" clId="{FA808040-3F2B-4FC1-BDD2-9095003EE8F3}" dt="2024-04-16T00:36:22.357" v="87" actId="14100"/>
          <ac:spMkLst>
            <pc:docMk/>
            <pc:sldMk cId="1267986695" sldId="263"/>
            <ac:spMk id="14340" creationId="{00000000-0000-0000-0000-000000000000}"/>
          </ac:spMkLst>
        </pc:spChg>
        <pc:spChg chg="mod">
          <ac:chgData name="Zainalabedeen N Al Naseri" userId="9807e083-1870-42e3-b813-d3919d9d723c" providerId="ADAL" clId="{FA808040-3F2B-4FC1-BDD2-9095003EE8F3}" dt="2024-04-11T17:53:28.466" v="27" actId="255"/>
          <ac:spMkLst>
            <pc:docMk/>
            <pc:sldMk cId="1267986695" sldId="263"/>
            <ac:spMk id="14341" creationId="{00000000-0000-0000-0000-000000000000}"/>
          </ac:spMkLst>
        </pc:spChg>
        <pc:spChg chg="mod">
          <ac:chgData name="Zainalabedeen N Al Naseri" userId="9807e083-1870-42e3-b813-d3919d9d723c" providerId="ADAL" clId="{FA808040-3F2B-4FC1-BDD2-9095003EE8F3}" dt="2024-04-16T01:08:32.969" v="473" actId="1076"/>
          <ac:spMkLst>
            <pc:docMk/>
            <pc:sldMk cId="1267986695" sldId="263"/>
            <ac:spMk id="14342" creationId="{00000000-0000-0000-0000-000000000000}"/>
          </ac:spMkLst>
        </pc:spChg>
        <pc:graphicFrameChg chg="add del mod modGraphic">
          <ac:chgData name="Zainalabedeen N Al Naseri" userId="9807e083-1870-42e3-b813-d3919d9d723c" providerId="ADAL" clId="{FA808040-3F2B-4FC1-BDD2-9095003EE8F3}" dt="2024-04-16T00:05:15.008" v="45" actId="478"/>
          <ac:graphicFrameMkLst>
            <pc:docMk/>
            <pc:sldMk cId="1267986695" sldId="263"/>
            <ac:graphicFrameMk id="8" creationId="{2806DF3F-4DEF-C4F1-465A-2D0A63F88AD0}"/>
          </ac:graphicFrameMkLst>
        </pc:graphicFrameChg>
        <pc:graphicFrameChg chg="add mod modGraphic">
          <ac:chgData name="Zainalabedeen N Al Naseri" userId="9807e083-1870-42e3-b813-d3919d9d723c" providerId="ADAL" clId="{FA808040-3F2B-4FC1-BDD2-9095003EE8F3}" dt="2024-04-16T00:41:18.056" v="116" actId="12385"/>
          <ac:graphicFrameMkLst>
            <pc:docMk/>
            <pc:sldMk cId="1267986695" sldId="263"/>
            <ac:graphicFrameMk id="11" creationId="{65AEACB9-B21E-7C82-A5B3-68920EEDC493}"/>
          </ac:graphicFrameMkLst>
        </pc:graphicFrameChg>
        <pc:graphicFrameChg chg="add mod modGraphic">
          <ac:chgData name="Zainalabedeen N Al Naseri" userId="9807e083-1870-42e3-b813-d3919d9d723c" providerId="ADAL" clId="{FA808040-3F2B-4FC1-BDD2-9095003EE8F3}" dt="2024-04-16T00:44:56.329" v="139" actId="1076"/>
          <ac:graphicFrameMkLst>
            <pc:docMk/>
            <pc:sldMk cId="1267986695" sldId="263"/>
            <ac:graphicFrameMk id="18" creationId="{69054485-4FB5-72F0-B2EE-9B067C9ACEE1}"/>
          </ac:graphicFrameMkLst>
        </pc:graphicFrameChg>
        <pc:picChg chg="add mod">
          <ac:chgData name="Zainalabedeen N Al Naseri" userId="9807e083-1870-42e3-b813-d3919d9d723c" providerId="ADAL" clId="{FA808040-3F2B-4FC1-BDD2-9095003EE8F3}" dt="2024-04-16T01:16:51.140" v="1119" actId="14100"/>
          <ac:picMkLst>
            <pc:docMk/>
            <pc:sldMk cId="1267986695" sldId="263"/>
            <ac:picMk id="6" creationId="{BF51E4AA-6805-7671-496A-A433D6BF0AD4}"/>
          </ac:picMkLst>
        </pc:picChg>
        <pc:picChg chg="add mod">
          <ac:chgData name="Zainalabedeen N Al Naseri" userId="9807e083-1870-42e3-b813-d3919d9d723c" providerId="ADAL" clId="{FA808040-3F2B-4FC1-BDD2-9095003EE8F3}" dt="2024-04-16T01:16:38.364" v="1118" actId="29295"/>
          <ac:picMkLst>
            <pc:docMk/>
            <pc:sldMk cId="1267986695" sldId="263"/>
            <ac:picMk id="7" creationId="{F8C19FE8-4253-EE09-6259-892CD191FD7C}"/>
          </ac:picMkLst>
        </pc:picChg>
        <pc:picChg chg="add mod modCrop">
          <ac:chgData name="Zainalabedeen N Al Naseri" userId="9807e083-1870-42e3-b813-d3919d9d723c" providerId="ADAL" clId="{FA808040-3F2B-4FC1-BDD2-9095003EE8F3}" dt="2024-04-16T01:08:40.995" v="475" actId="14100"/>
          <ac:picMkLst>
            <pc:docMk/>
            <pc:sldMk cId="1267986695" sldId="263"/>
            <ac:picMk id="25" creationId="{BD4A9A9A-18D7-AEFC-10D6-3D1B4532728C}"/>
          </ac:picMkLst>
        </pc:picChg>
      </pc:sldChg>
      <pc:sldChg chg="addSp delSp modSp new add del mod">
        <pc:chgData name="Zainalabedeen N Al Naseri" userId="9807e083-1870-42e3-b813-d3919d9d723c" providerId="ADAL" clId="{FA808040-3F2B-4FC1-BDD2-9095003EE8F3}" dt="2024-04-16T01:03:51.937" v="219" actId="47"/>
        <pc:sldMkLst>
          <pc:docMk/>
          <pc:sldMk cId="3055152021" sldId="264"/>
        </pc:sldMkLst>
        <pc:spChg chg="add mod">
          <ac:chgData name="Zainalabedeen N Al Naseri" userId="9807e083-1870-42e3-b813-d3919d9d723c" providerId="ADAL" clId="{FA808040-3F2B-4FC1-BDD2-9095003EE8F3}" dt="2024-04-16T01:02:46.606" v="209" actId="14100"/>
          <ac:spMkLst>
            <pc:docMk/>
            <pc:sldMk cId="3055152021" sldId="264"/>
            <ac:spMk id="2" creationId="{5BC3C987-F5B2-CC4D-0783-7A67FCEC607F}"/>
          </ac:spMkLst>
        </pc:spChg>
        <pc:spChg chg="add del mod">
          <ac:chgData name="Zainalabedeen N Al Naseri" userId="9807e083-1870-42e3-b813-d3919d9d723c" providerId="ADAL" clId="{FA808040-3F2B-4FC1-BDD2-9095003EE8F3}" dt="2024-04-16T01:03:17.525" v="214" actId="478"/>
          <ac:spMkLst>
            <pc:docMk/>
            <pc:sldMk cId="3055152021" sldId="264"/>
            <ac:spMk id="3" creationId="{C34B3573-FA67-ACB3-A2CE-3E867E84EDF9}"/>
          </ac:spMkLst>
        </pc:spChg>
      </pc:sldChg>
      <pc:sldChg chg="addSp modSp new mod">
        <pc:chgData name="Zainalabedeen N Al Naseri" userId="9807e083-1870-42e3-b813-d3919d9d723c" providerId="ADAL" clId="{FA808040-3F2B-4FC1-BDD2-9095003EE8F3}" dt="2024-04-16T01:43:26.543" v="1242" actId="1076"/>
        <pc:sldMkLst>
          <pc:docMk/>
          <pc:sldMk cId="2410079693" sldId="265"/>
        </pc:sldMkLst>
        <pc:spChg chg="add mod">
          <ac:chgData name="Zainalabedeen N Al Naseri" userId="9807e083-1870-42e3-b813-d3919d9d723c" providerId="ADAL" clId="{FA808040-3F2B-4FC1-BDD2-9095003EE8F3}" dt="2024-04-16T01:41:16.599" v="1217" actId="1076"/>
          <ac:spMkLst>
            <pc:docMk/>
            <pc:sldMk cId="2410079693" sldId="265"/>
            <ac:spMk id="2" creationId="{8CB9AEBF-FF5D-0ED4-8A5B-0F50797925AB}"/>
          </ac:spMkLst>
        </pc:spChg>
        <pc:spChg chg="add mod">
          <ac:chgData name="Zainalabedeen N Al Naseri" userId="9807e083-1870-42e3-b813-d3919d9d723c" providerId="ADAL" clId="{FA808040-3F2B-4FC1-BDD2-9095003EE8F3}" dt="2024-04-16T01:39:17.596" v="1197" actId="1076"/>
          <ac:spMkLst>
            <pc:docMk/>
            <pc:sldMk cId="2410079693" sldId="265"/>
            <ac:spMk id="3" creationId="{1B9EEFFF-DCAB-F544-A10F-53E4E8209F5C}"/>
          </ac:spMkLst>
        </pc:spChg>
        <pc:spChg chg="add mod">
          <ac:chgData name="Zainalabedeen N Al Naseri" userId="9807e083-1870-42e3-b813-d3919d9d723c" providerId="ADAL" clId="{FA808040-3F2B-4FC1-BDD2-9095003EE8F3}" dt="2024-04-16T01:40:06.670" v="1204" actId="255"/>
          <ac:spMkLst>
            <pc:docMk/>
            <pc:sldMk cId="2410079693" sldId="265"/>
            <ac:spMk id="4" creationId="{FEA0F5EE-00D1-5C4F-DACA-FCC4AC701A39}"/>
          </ac:spMkLst>
        </pc:spChg>
        <pc:spChg chg="add mod">
          <ac:chgData name="Zainalabedeen N Al Naseri" userId="9807e083-1870-42e3-b813-d3919d9d723c" providerId="ADAL" clId="{FA808040-3F2B-4FC1-BDD2-9095003EE8F3}" dt="2024-04-16T01:41:02.272" v="1214" actId="255"/>
          <ac:spMkLst>
            <pc:docMk/>
            <pc:sldMk cId="2410079693" sldId="265"/>
            <ac:spMk id="5" creationId="{E7AECEDA-AFBD-BA03-13A9-27911C336A1B}"/>
          </ac:spMkLst>
        </pc:spChg>
        <pc:spChg chg="add mod">
          <ac:chgData name="Zainalabedeen N Al Naseri" userId="9807e083-1870-42e3-b813-d3919d9d723c" providerId="ADAL" clId="{FA808040-3F2B-4FC1-BDD2-9095003EE8F3}" dt="2024-04-16T01:43:07.593" v="1239" actId="1076"/>
          <ac:spMkLst>
            <pc:docMk/>
            <pc:sldMk cId="2410079693" sldId="265"/>
            <ac:spMk id="7" creationId="{36227861-131A-20BA-BC97-0AAC3FC461D2}"/>
          </ac:spMkLst>
        </pc:spChg>
        <pc:spChg chg="add mod">
          <ac:chgData name="Zainalabedeen N Al Naseri" userId="9807e083-1870-42e3-b813-d3919d9d723c" providerId="ADAL" clId="{FA808040-3F2B-4FC1-BDD2-9095003EE8F3}" dt="2024-04-16T01:43:11.123" v="1240" actId="1076"/>
          <ac:spMkLst>
            <pc:docMk/>
            <pc:sldMk cId="2410079693" sldId="265"/>
            <ac:spMk id="8" creationId="{C091A293-5955-BDD4-EB44-ACC13EEE429A}"/>
          </ac:spMkLst>
        </pc:spChg>
        <pc:spChg chg="add mod">
          <ac:chgData name="Zainalabedeen N Al Naseri" userId="9807e083-1870-42e3-b813-d3919d9d723c" providerId="ADAL" clId="{FA808040-3F2B-4FC1-BDD2-9095003EE8F3}" dt="2024-04-16T01:43:26.543" v="1242" actId="1076"/>
          <ac:spMkLst>
            <pc:docMk/>
            <pc:sldMk cId="2410079693" sldId="265"/>
            <ac:spMk id="9" creationId="{9AF9471A-1F3C-A298-DB94-95DE43DC522A}"/>
          </ac:spMkLst>
        </pc:spChg>
        <pc:spChg chg="add mod">
          <ac:chgData name="Zainalabedeen N Al Naseri" userId="9807e083-1870-42e3-b813-d3919d9d723c" providerId="ADAL" clId="{FA808040-3F2B-4FC1-BDD2-9095003EE8F3}" dt="2024-04-16T01:42:55.981" v="1237" actId="1076"/>
          <ac:spMkLst>
            <pc:docMk/>
            <pc:sldMk cId="2410079693" sldId="265"/>
            <ac:spMk id="10" creationId="{B3F297D3-653D-89F8-8593-7AE66C8CF6B5}"/>
          </ac:spMkLst>
        </pc:spChg>
        <pc:spChg chg="add mod">
          <ac:chgData name="Zainalabedeen N Al Naseri" userId="9807e083-1870-42e3-b813-d3919d9d723c" providerId="ADAL" clId="{FA808040-3F2B-4FC1-BDD2-9095003EE8F3}" dt="2024-04-16T01:43:01.324" v="1238" actId="1076"/>
          <ac:spMkLst>
            <pc:docMk/>
            <pc:sldMk cId="2410079693" sldId="265"/>
            <ac:spMk id="11" creationId="{033F39E2-2AFC-5B71-69BD-1C9DE3F66E25}"/>
          </ac:spMkLst>
        </pc:spChg>
        <pc:picChg chg="add mod">
          <ac:chgData name="Zainalabedeen N Al Naseri" userId="9807e083-1870-42e3-b813-d3919d9d723c" providerId="ADAL" clId="{FA808040-3F2B-4FC1-BDD2-9095003EE8F3}" dt="2024-04-16T01:43:19.643" v="1241" actId="1076"/>
          <ac:picMkLst>
            <pc:docMk/>
            <pc:sldMk cId="2410079693" sldId="265"/>
            <ac:picMk id="6" creationId="{F40205AE-7330-8D39-FA6D-749E6AA8E399}"/>
          </ac:picMkLst>
        </pc:picChg>
      </pc:sldChg>
      <pc:sldChg chg="addSp modSp new mod">
        <pc:chgData name="Zainalabedeen N Al Naseri" userId="9807e083-1870-42e3-b813-d3919d9d723c" providerId="ADAL" clId="{FA808040-3F2B-4FC1-BDD2-9095003EE8F3}" dt="2024-04-16T01:44:46.480" v="1250" actId="1076"/>
        <pc:sldMkLst>
          <pc:docMk/>
          <pc:sldMk cId="4277929086" sldId="266"/>
        </pc:sldMkLst>
        <pc:picChg chg="add mod">
          <ac:chgData name="Zainalabedeen N Al Naseri" userId="9807e083-1870-42e3-b813-d3919d9d723c" providerId="ADAL" clId="{FA808040-3F2B-4FC1-BDD2-9095003EE8F3}" dt="2024-04-16T01:44:46.480" v="1250" actId="1076"/>
          <ac:picMkLst>
            <pc:docMk/>
            <pc:sldMk cId="4277929086" sldId="266"/>
            <ac:picMk id="3" creationId="{495BFD6B-210F-FA25-64E9-C43B9B0920E8}"/>
          </ac:picMkLst>
        </pc:picChg>
      </pc:sldChg>
    </pc:docChg>
  </pc:docChgLst>
  <pc:docChgLst>
    <pc:chgData name="Kassidy V Herrin" userId="S::kherr17@lsu.edu::78f2563c-1de5-4d7a-85bd-6e884350cb72" providerId="AD" clId="Web-{026673D6-C87B-4BF6-DF41-92561C37DFB0}"/>
    <pc:docChg chg="modSld">
      <pc:chgData name="Kassidy V Herrin" userId="S::kherr17@lsu.edu::78f2563c-1de5-4d7a-85bd-6e884350cb72" providerId="AD" clId="Web-{026673D6-C87B-4BF6-DF41-92561C37DFB0}" dt="2024-04-24T19:06:50.876" v="336" actId="1076"/>
      <pc:docMkLst>
        <pc:docMk/>
      </pc:docMkLst>
      <pc:sldChg chg="modSp">
        <pc:chgData name="Kassidy V Herrin" userId="S::kherr17@lsu.edu::78f2563c-1de5-4d7a-85bd-6e884350cb72" providerId="AD" clId="Web-{026673D6-C87B-4BF6-DF41-92561C37DFB0}" dt="2024-04-24T19:06:50.876" v="336" actId="1076"/>
        <pc:sldMkLst>
          <pc:docMk/>
          <pc:sldMk cId="1267986695" sldId="263"/>
        </pc:sldMkLst>
        <pc:spChg chg="mod">
          <ac:chgData name="Kassidy V Herrin" userId="S::kherr17@lsu.edu::78f2563c-1de5-4d7a-85bd-6e884350cb72" providerId="AD" clId="Web-{026673D6-C87B-4BF6-DF41-92561C37DFB0}" dt="2024-04-24T19:05:32.076" v="329" actId="1076"/>
          <ac:spMkLst>
            <pc:docMk/>
            <pc:sldMk cId="1267986695" sldId="263"/>
            <ac:spMk id="7" creationId="{EE761138-33B1-0299-BC55-977C0A61093D}"/>
          </ac:spMkLst>
        </pc:spChg>
        <pc:spChg chg="mod">
          <ac:chgData name="Kassidy V Herrin" userId="S::kherr17@lsu.edu::78f2563c-1de5-4d7a-85bd-6e884350cb72" providerId="AD" clId="Web-{026673D6-C87B-4BF6-DF41-92561C37DFB0}" dt="2024-04-24T18:59:12.578" v="252" actId="1076"/>
          <ac:spMkLst>
            <pc:docMk/>
            <pc:sldMk cId="1267986695" sldId="263"/>
            <ac:spMk id="9" creationId="{A899D352-40E7-A6C6-BD2E-9467BAA1D812}"/>
          </ac:spMkLst>
        </pc:spChg>
        <pc:spChg chg="mod">
          <ac:chgData name="Kassidy V Herrin" userId="S::kherr17@lsu.edu::78f2563c-1de5-4d7a-85bd-6e884350cb72" providerId="AD" clId="Web-{026673D6-C87B-4BF6-DF41-92561C37DFB0}" dt="2024-04-24T18:46:04.486" v="3" actId="1076"/>
          <ac:spMkLst>
            <pc:docMk/>
            <pc:sldMk cId="1267986695" sldId="263"/>
            <ac:spMk id="14" creationId="{00000000-0000-0000-0000-000000000000}"/>
          </ac:spMkLst>
        </pc:spChg>
        <pc:spChg chg="mod">
          <ac:chgData name="Kassidy V Herrin" userId="S::kherr17@lsu.edu::78f2563c-1de5-4d7a-85bd-6e884350cb72" providerId="AD" clId="Web-{026673D6-C87B-4BF6-DF41-92561C37DFB0}" dt="2024-04-24T19:06:46.611" v="334" actId="1076"/>
          <ac:spMkLst>
            <pc:docMk/>
            <pc:sldMk cId="1267986695" sldId="263"/>
            <ac:spMk id="20" creationId="{00000000-0000-0000-0000-000000000000}"/>
          </ac:spMkLst>
        </pc:spChg>
        <pc:spChg chg="mod">
          <ac:chgData name="Kassidy V Herrin" userId="S::kherr17@lsu.edu::78f2563c-1de5-4d7a-85bd-6e884350cb72" providerId="AD" clId="Web-{026673D6-C87B-4BF6-DF41-92561C37DFB0}" dt="2024-04-24T19:06:50.814" v="335" actId="1076"/>
          <ac:spMkLst>
            <pc:docMk/>
            <pc:sldMk cId="1267986695" sldId="263"/>
            <ac:spMk id="22" creationId="{00000000-0000-0000-0000-000000000000}"/>
          </ac:spMkLst>
        </pc:spChg>
        <pc:spChg chg="mod">
          <ac:chgData name="Kassidy V Herrin" userId="S::kherr17@lsu.edu::78f2563c-1de5-4d7a-85bd-6e884350cb72" providerId="AD" clId="Web-{026673D6-C87B-4BF6-DF41-92561C37DFB0}" dt="2024-04-24T19:06:50.876" v="336" actId="1076"/>
          <ac:spMkLst>
            <pc:docMk/>
            <pc:sldMk cId="1267986695" sldId="263"/>
            <ac:spMk id="23" creationId="{00000000-0000-0000-0000-000000000000}"/>
          </ac:spMkLst>
        </pc:spChg>
        <pc:spChg chg="mod">
          <ac:chgData name="Kassidy V Herrin" userId="S::kherr17@lsu.edu::78f2563c-1de5-4d7a-85bd-6e884350cb72" providerId="AD" clId="Web-{026673D6-C87B-4BF6-DF41-92561C37DFB0}" dt="2024-04-24T19:03:41.041" v="295" actId="1076"/>
          <ac:spMkLst>
            <pc:docMk/>
            <pc:sldMk cId="1267986695" sldId="263"/>
            <ac:spMk id="24" creationId="{98E8D37B-B528-A794-086D-319C56A08178}"/>
          </ac:spMkLst>
        </pc:spChg>
        <pc:spChg chg="mod">
          <ac:chgData name="Kassidy V Herrin" userId="S::kherr17@lsu.edu::78f2563c-1de5-4d7a-85bd-6e884350cb72" providerId="AD" clId="Web-{026673D6-C87B-4BF6-DF41-92561C37DFB0}" dt="2024-04-24T19:00:42.675" v="264" actId="20577"/>
          <ac:spMkLst>
            <pc:docMk/>
            <pc:sldMk cId="1267986695" sldId="263"/>
            <ac:spMk id="26" creationId="{C8AD3FA0-91D1-C89A-BD5C-192A99E78AA9}"/>
          </ac:spMkLst>
        </pc:spChg>
        <pc:spChg chg="mod">
          <ac:chgData name="Kassidy V Herrin" userId="S::kherr17@lsu.edu::78f2563c-1de5-4d7a-85bd-6e884350cb72" providerId="AD" clId="Web-{026673D6-C87B-4BF6-DF41-92561C37DFB0}" dt="2024-04-24T19:00:47.019" v="265" actId="20577"/>
          <ac:spMkLst>
            <pc:docMk/>
            <pc:sldMk cId="1267986695" sldId="263"/>
            <ac:spMk id="27" creationId="{E8598A00-C0A7-013C-851B-D8D74B2D51DB}"/>
          </ac:spMkLst>
        </pc:spChg>
        <pc:spChg chg="mod">
          <ac:chgData name="Kassidy V Herrin" userId="S::kherr17@lsu.edu::78f2563c-1de5-4d7a-85bd-6e884350cb72" providerId="AD" clId="Web-{026673D6-C87B-4BF6-DF41-92561C37DFB0}" dt="2024-04-24T19:05:21.967" v="328" actId="1076"/>
          <ac:spMkLst>
            <pc:docMk/>
            <pc:sldMk cId="1267986695" sldId="263"/>
            <ac:spMk id="28" creationId="{84F975A6-A238-8411-DA25-164A62D0BA44}"/>
          </ac:spMkLst>
        </pc:spChg>
        <pc:spChg chg="mod">
          <ac:chgData name="Kassidy V Herrin" userId="S::kherr17@lsu.edu::78f2563c-1de5-4d7a-85bd-6e884350cb72" providerId="AD" clId="Web-{026673D6-C87B-4BF6-DF41-92561C37DFB0}" dt="2024-04-24T19:02:22.069" v="282" actId="1076"/>
          <ac:spMkLst>
            <pc:docMk/>
            <pc:sldMk cId="1267986695" sldId="263"/>
            <ac:spMk id="31" creationId="{7F2FB729-B800-3746-3C27-976B0D44BD25}"/>
          </ac:spMkLst>
        </pc:spChg>
        <pc:spChg chg="mod">
          <ac:chgData name="Kassidy V Herrin" userId="S::kherr17@lsu.edu::78f2563c-1de5-4d7a-85bd-6e884350cb72" providerId="AD" clId="Web-{026673D6-C87B-4BF6-DF41-92561C37DFB0}" dt="2024-04-24T19:02:23.585" v="283" actId="1076"/>
          <ac:spMkLst>
            <pc:docMk/>
            <pc:sldMk cId="1267986695" sldId="263"/>
            <ac:spMk id="33" creationId="{18B5C642-0B11-8A65-D021-2231F52627AA}"/>
          </ac:spMkLst>
        </pc:spChg>
        <pc:spChg chg="mod">
          <ac:chgData name="Kassidy V Herrin" userId="S::kherr17@lsu.edu::78f2563c-1de5-4d7a-85bd-6e884350cb72" providerId="AD" clId="Web-{026673D6-C87B-4BF6-DF41-92561C37DFB0}" dt="2024-04-24T19:05:46.780" v="330" actId="14100"/>
          <ac:spMkLst>
            <pc:docMk/>
            <pc:sldMk cId="1267986695" sldId="263"/>
            <ac:spMk id="34" creationId="{AF943511-BF14-7164-A804-4EE36C99301B}"/>
          </ac:spMkLst>
        </pc:spChg>
        <pc:spChg chg="mod">
          <ac:chgData name="Kassidy V Herrin" userId="S::kherr17@lsu.edu::78f2563c-1de5-4d7a-85bd-6e884350cb72" providerId="AD" clId="Web-{026673D6-C87B-4BF6-DF41-92561C37DFB0}" dt="2024-04-24T19:02:26.726" v="284" actId="1076"/>
          <ac:spMkLst>
            <pc:docMk/>
            <pc:sldMk cId="1267986695" sldId="263"/>
            <ac:spMk id="35" creationId="{69D7526D-8EC8-0C82-A5C3-7D255A0126AF}"/>
          </ac:spMkLst>
        </pc:spChg>
        <pc:spChg chg="mod">
          <ac:chgData name="Kassidy V Herrin" userId="S::kherr17@lsu.edu::78f2563c-1de5-4d7a-85bd-6e884350cb72" providerId="AD" clId="Web-{026673D6-C87B-4BF6-DF41-92561C37DFB0}" dt="2024-04-24T19:02:11.506" v="280" actId="1076"/>
          <ac:spMkLst>
            <pc:docMk/>
            <pc:sldMk cId="1267986695" sldId="263"/>
            <ac:spMk id="37" creationId="{C0F06F95-DEC7-2E2C-5084-BC64E3C17B22}"/>
          </ac:spMkLst>
        </pc:spChg>
        <pc:spChg chg="mod">
          <ac:chgData name="Kassidy V Herrin" userId="S::kherr17@lsu.edu::78f2563c-1de5-4d7a-85bd-6e884350cb72" providerId="AD" clId="Web-{026673D6-C87B-4BF6-DF41-92561C37DFB0}" dt="2024-04-24T19:06:42.329" v="333" actId="20577"/>
          <ac:spMkLst>
            <pc:docMk/>
            <pc:sldMk cId="1267986695" sldId="263"/>
            <ac:spMk id="14341" creationId="{00000000-0000-0000-0000-000000000000}"/>
          </ac:spMkLst>
        </pc:spChg>
        <pc:spChg chg="mod">
          <ac:chgData name="Kassidy V Herrin" userId="S::kherr17@lsu.edu::78f2563c-1de5-4d7a-85bd-6e884350cb72" providerId="AD" clId="Web-{026673D6-C87B-4BF6-DF41-92561C37DFB0}" dt="2024-04-24T18:45:41.251" v="0" actId="1076"/>
          <ac:spMkLst>
            <pc:docMk/>
            <pc:sldMk cId="1267986695" sldId="263"/>
            <ac:spMk id="14343" creationId="{00000000-0000-0000-0000-000000000000}"/>
          </ac:spMkLst>
        </pc:spChg>
        <pc:graphicFrameChg chg="mod modGraphic">
          <ac:chgData name="Kassidy V Herrin" userId="S::kherr17@lsu.edu::78f2563c-1de5-4d7a-85bd-6e884350cb72" providerId="AD" clId="Web-{026673D6-C87B-4BF6-DF41-92561C37DFB0}" dt="2024-04-24T19:05:18.076" v="327" actId="1076"/>
          <ac:graphicFrameMkLst>
            <pc:docMk/>
            <pc:sldMk cId="1267986695" sldId="263"/>
            <ac:graphicFrameMk id="11" creationId="{65AEACB9-B21E-7C82-A5B3-68920EEDC493}"/>
          </ac:graphicFrameMkLst>
        </pc:graphicFrameChg>
        <pc:picChg chg="mod">
          <ac:chgData name="Kassidy V Herrin" userId="S::kherr17@lsu.edu::78f2563c-1de5-4d7a-85bd-6e884350cb72" providerId="AD" clId="Web-{026673D6-C87B-4BF6-DF41-92561C37DFB0}" dt="2024-04-24T19:03:08.930" v="292" actId="1076"/>
          <ac:picMkLst>
            <pc:docMk/>
            <pc:sldMk cId="1267986695" sldId="263"/>
            <ac:picMk id="8" creationId="{5B0D1962-0B43-CF5F-45F3-9A9D490074A5}"/>
          </ac:picMkLst>
        </pc:picChg>
        <pc:picChg chg="mod">
          <ac:chgData name="Kassidy V Herrin" userId="S::kherr17@lsu.edu::78f2563c-1de5-4d7a-85bd-6e884350cb72" providerId="AD" clId="Web-{026673D6-C87B-4BF6-DF41-92561C37DFB0}" dt="2024-04-24T18:59:06.656" v="251" actId="1076"/>
          <ac:picMkLst>
            <pc:docMk/>
            <pc:sldMk cId="1267986695" sldId="263"/>
            <ac:picMk id="10" creationId="{6BF1A5FE-F89A-88D7-93B9-E97A105CC5A6}"/>
          </ac:picMkLst>
        </pc:picChg>
        <pc:picChg chg="mod modCrop">
          <ac:chgData name="Kassidy V Herrin" userId="S::kherr17@lsu.edu::78f2563c-1de5-4d7a-85bd-6e884350cb72" providerId="AD" clId="Web-{026673D6-C87B-4BF6-DF41-92561C37DFB0}" dt="2024-04-24T19:02:15.319" v="281" actId="1076"/>
          <ac:picMkLst>
            <pc:docMk/>
            <pc:sldMk cId="1267986695" sldId="263"/>
            <ac:picMk id="25" creationId="{BD4A9A9A-18D7-AEFC-10D6-3D1B4532728C}"/>
          </ac:picMkLst>
        </pc:picChg>
      </pc:sldChg>
    </pc:docChg>
  </pc:docChgLst>
  <pc:docChgLst>
    <pc:chgData name="Charlotte E Robinson" userId="S::crob261@lsu.edu::b04a81f5-e1b9-4faa-b263-388a49954364" providerId="AD" clId="Web-{400B19F5-A940-FD2A-3832-B8F1D1476D18}"/>
    <pc:docChg chg="modSld">
      <pc:chgData name="Charlotte E Robinson" userId="S::crob261@lsu.edu::b04a81f5-e1b9-4faa-b263-388a49954364" providerId="AD" clId="Web-{400B19F5-A940-FD2A-3832-B8F1D1476D18}" dt="2024-04-24T17:48:44.348" v="120" actId="14100"/>
      <pc:docMkLst>
        <pc:docMk/>
      </pc:docMkLst>
      <pc:sldChg chg="modSp">
        <pc:chgData name="Charlotte E Robinson" userId="S::crob261@lsu.edu::b04a81f5-e1b9-4faa-b263-388a49954364" providerId="AD" clId="Web-{400B19F5-A940-FD2A-3832-B8F1D1476D18}" dt="2024-04-24T17:48:44.348" v="120" actId="14100"/>
        <pc:sldMkLst>
          <pc:docMk/>
          <pc:sldMk cId="1267986695" sldId="263"/>
        </pc:sldMkLst>
        <pc:spChg chg="mod">
          <ac:chgData name="Charlotte E Robinson" userId="S::crob261@lsu.edu::b04a81f5-e1b9-4faa-b263-388a49954364" providerId="AD" clId="Web-{400B19F5-A940-FD2A-3832-B8F1D1476D18}" dt="2024-04-24T17:26:25.129" v="31" actId="1076"/>
          <ac:spMkLst>
            <pc:docMk/>
            <pc:sldMk cId="1267986695" sldId="263"/>
            <ac:spMk id="2" creationId="{C391A11A-2981-C111-5347-6F129B8F65AF}"/>
          </ac:spMkLst>
        </pc:spChg>
        <pc:spChg chg="mod">
          <ac:chgData name="Charlotte E Robinson" userId="S::crob261@lsu.edu::b04a81f5-e1b9-4faa-b263-388a49954364" providerId="AD" clId="Web-{400B19F5-A940-FD2A-3832-B8F1D1476D18}" dt="2024-04-24T17:24:01.060" v="13" actId="1076"/>
          <ac:spMkLst>
            <pc:docMk/>
            <pc:sldMk cId="1267986695" sldId="263"/>
            <ac:spMk id="5" creationId="{F32B9F2F-C767-75A6-AE69-6C7D0946C632}"/>
          </ac:spMkLst>
        </pc:spChg>
        <pc:spChg chg="mod">
          <ac:chgData name="Charlotte E Robinson" userId="S::crob261@lsu.edu::b04a81f5-e1b9-4faa-b263-388a49954364" providerId="AD" clId="Web-{400B19F5-A940-FD2A-3832-B8F1D1476D18}" dt="2024-04-24T17:24:29.764" v="18" actId="1076"/>
          <ac:spMkLst>
            <pc:docMk/>
            <pc:sldMk cId="1267986695" sldId="263"/>
            <ac:spMk id="14" creationId="{00000000-0000-0000-0000-000000000000}"/>
          </ac:spMkLst>
        </pc:spChg>
        <pc:spChg chg="mod">
          <ac:chgData name="Charlotte E Robinson" userId="S::crob261@lsu.edu::b04a81f5-e1b9-4faa-b263-388a49954364" providerId="AD" clId="Web-{400B19F5-A940-FD2A-3832-B8F1D1476D18}" dt="2024-04-24T17:27:41.820" v="38" actId="1076"/>
          <ac:spMkLst>
            <pc:docMk/>
            <pc:sldMk cId="1267986695" sldId="263"/>
            <ac:spMk id="15" creationId="{00000000-0000-0000-0000-000000000000}"/>
          </ac:spMkLst>
        </pc:spChg>
        <pc:spChg chg="mod">
          <ac:chgData name="Charlotte E Robinson" userId="S::crob261@lsu.edu::b04a81f5-e1b9-4faa-b263-388a49954364" providerId="AD" clId="Web-{400B19F5-A940-FD2A-3832-B8F1D1476D18}" dt="2024-04-24T17:41:57.079" v="109" actId="1076"/>
          <ac:spMkLst>
            <pc:docMk/>
            <pc:sldMk cId="1267986695" sldId="263"/>
            <ac:spMk id="17" creationId="{00000000-0000-0000-0000-000000000000}"/>
          </ac:spMkLst>
        </pc:spChg>
        <pc:spChg chg="mod">
          <ac:chgData name="Charlotte E Robinson" userId="S::crob261@lsu.edu::b04a81f5-e1b9-4faa-b263-388a49954364" providerId="AD" clId="Web-{400B19F5-A940-FD2A-3832-B8F1D1476D18}" dt="2024-04-24T17:28:33.057" v="46" actId="1076"/>
          <ac:spMkLst>
            <pc:docMk/>
            <pc:sldMk cId="1267986695" sldId="263"/>
            <ac:spMk id="20" creationId="{00000000-0000-0000-0000-000000000000}"/>
          </ac:spMkLst>
        </pc:spChg>
        <pc:spChg chg="mod">
          <ac:chgData name="Charlotte E Robinson" userId="S::crob261@lsu.edu::b04a81f5-e1b9-4faa-b263-388a49954364" providerId="AD" clId="Web-{400B19F5-A940-FD2A-3832-B8F1D1476D18}" dt="2024-04-24T17:48:34.832" v="118" actId="14100"/>
          <ac:spMkLst>
            <pc:docMk/>
            <pc:sldMk cId="1267986695" sldId="263"/>
            <ac:spMk id="22" creationId="{00000000-0000-0000-0000-000000000000}"/>
          </ac:spMkLst>
        </pc:spChg>
        <pc:spChg chg="mod">
          <ac:chgData name="Charlotte E Robinson" userId="S::crob261@lsu.edu::b04a81f5-e1b9-4faa-b263-388a49954364" providerId="AD" clId="Web-{400B19F5-A940-FD2A-3832-B8F1D1476D18}" dt="2024-04-24T17:48:39.082" v="119" actId="1076"/>
          <ac:spMkLst>
            <pc:docMk/>
            <pc:sldMk cId="1267986695" sldId="263"/>
            <ac:spMk id="23" creationId="{00000000-0000-0000-0000-000000000000}"/>
          </ac:spMkLst>
        </pc:spChg>
        <pc:spChg chg="mod">
          <ac:chgData name="Charlotte E Robinson" userId="S::crob261@lsu.edu::b04a81f5-e1b9-4faa-b263-388a49954364" providerId="AD" clId="Web-{400B19F5-A940-FD2A-3832-B8F1D1476D18}" dt="2024-04-24T17:26:36.348" v="32" actId="20577"/>
          <ac:spMkLst>
            <pc:docMk/>
            <pc:sldMk cId="1267986695" sldId="263"/>
            <ac:spMk id="14339" creationId="{00000000-0000-0000-0000-000000000000}"/>
          </ac:spMkLst>
        </pc:spChg>
        <pc:spChg chg="mod">
          <ac:chgData name="Charlotte E Robinson" userId="S::crob261@lsu.edu::b04a81f5-e1b9-4faa-b263-388a49954364" providerId="AD" clId="Web-{400B19F5-A940-FD2A-3832-B8F1D1476D18}" dt="2024-04-24T17:27:35.867" v="35" actId="14100"/>
          <ac:spMkLst>
            <pc:docMk/>
            <pc:sldMk cId="1267986695" sldId="263"/>
            <ac:spMk id="14340" creationId="{00000000-0000-0000-0000-000000000000}"/>
          </ac:spMkLst>
        </pc:spChg>
        <pc:spChg chg="mod">
          <ac:chgData name="Charlotte E Robinson" userId="S::crob261@lsu.edu::b04a81f5-e1b9-4faa-b263-388a49954364" providerId="AD" clId="Web-{400B19F5-A940-FD2A-3832-B8F1D1476D18}" dt="2024-04-24T17:22:56.213" v="2" actId="14100"/>
          <ac:spMkLst>
            <pc:docMk/>
            <pc:sldMk cId="1267986695" sldId="263"/>
            <ac:spMk id="14341" creationId="{00000000-0000-0000-0000-000000000000}"/>
          </ac:spMkLst>
        </pc:spChg>
        <pc:spChg chg="mod">
          <ac:chgData name="Charlotte E Robinson" userId="S::crob261@lsu.edu::b04a81f5-e1b9-4faa-b263-388a49954364" providerId="AD" clId="Web-{400B19F5-A940-FD2A-3832-B8F1D1476D18}" dt="2024-04-24T17:48:44.348" v="120" actId="14100"/>
          <ac:spMkLst>
            <pc:docMk/>
            <pc:sldMk cId="1267986695" sldId="263"/>
            <ac:spMk id="14343" creationId="{00000000-0000-0000-0000-000000000000}"/>
          </ac:spMkLst>
        </pc:spChg>
      </pc:sldChg>
    </pc:docChg>
  </pc:docChgLst>
  <pc:docChgLst>
    <pc:chgData name="Jada Daniels" userId="S::jdani87@lsu.edu::8970acce-57c7-4559-8174-5ce60882e72d" providerId="AD" clId="Web-{D8813CDC-A716-DB6C-3C2D-AE3071ECD544}"/>
    <pc:docChg chg="modSld">
      <pc:chgData name="Jada Daniels" userId="S::jdani87@lsu.edu::8970acce-57c7-4559-8174-5ce60882e72d" providerId="AD" clId="Web-{D8813CDC-A716-DB6C-3C2D-AE3071ECD544}" dt="2024-04-25T21:45:51.511" v="7" actId="20577"/>
      <pc:docMkLst>
        <pc:docMk/>
      </pc:docMkLst>
      <pc:sldChg chg="modSp">
        <pc:chgData name="Jada Daniels" userId="S::jdani87@lsu.edu::8970acce-57c7-4559-8174-5ce60882e72d" providerId="AD" clId="Web-{D8813CDC-A716-DB6C-3C2D-AE3071ECD544}" dt="2024-04-25T21:45:51.511" v="7" actId="20577"/>
        <pc:sldMkLst>
          <pc:docMk/>
          <pc:sldMk cId="1267986695" sldId="263"/>
        </pc:sldMkLst>
        <pc:spChg chg="mod">
          <ac:chgData name="Jada Daniels" userId="S::jdani87@lsu.edu::8970acce-57c7-4559-8174-5ce60882e72d" providerId="AD" clId="Web-{D8813CDC-A716-DB6C-3C2D-AE3071ECD544}" dt="2024-04-25T21:45:38.072" v="2" actId="20577"/>
          <ac:spMkLst>
            <pc:docMk/>
            <pc:sldMk cId="1267986695" sldId="263"/>
            <ac:spMk id="26" creationId="{C8AD3FA0-91D1-C89A-BD5C-192A99E78AA9}"/>
          </ac:spMkLst>
        </pc:spChg>
        <pc:spChg chg="mod">
          <ac:chgData name="Jada Daniels" userId="S::jdani87@lsu.edu::8970acce-57c7-4559-8174-5ce60882e72d" providerId="AD" clId="Web-{D8813CDC-A716-DB6C-3C2D-AE3071ECD544}" dt="2024-04-25T21:45:47.776" v="5" actId="20577"/>
          <ac:spMkLst>
            <pc:docMk/>
            <pc:sldMk cId="1267986695" sldId="263"/>
            <ac:spMk id="27" creationId="{E8598A00-C0A7-013C-851B-D8D74B2D51DB}"/>
          </ac:spMkLst>
        </pc:spChg>
        <pc:spChg chg="mod">
          <ac:chgData name="Jada Daniels" userId="S::jdani87@lsu.edu::8970acce-57c7-4559-8174-5ce60882e72d" providerId="AD" clId="Web-{D8813CDC-A716-DB6C-3C2D-AE3071ECD544}" dt="2024-04-25T21:45:51.511" v="7" actId="20577"/>
          <ac:spMkLst>
            <pc:docMk/>
            <pc:sldMk cId="1267986695" sldId="263"/>
            <ac:spMk id="28" creationId="{84F975A6-A238-8411-DA25-164A62D0BA44}"/>
          </ac:spMkLst>
        </pc:spChg>
        <pc:spChg chg="mod">
          <ac:chgData name="Jada Daniels" userId="S::jdani87@lsu.edu::8970acce-57c7-4559-8174-5ce60882e72d" providerId="AD" clId="Web-{D8813CDC-A716-DB6C-3C2D-AE3071ECD544}" dt="2024-04-25T21:45:41.010" v="4" actId="20577"/>
          <ac:spMkLst>
            <pc:docMk/>
            <pc:sldMk cId="1267986695" sldId="263"/>
            <ac:spMk id="37" creationId="{C0F06F95-DEC7-2E2C-5084-BC64E3C17B22}"/>
          </ac:spMkLst>
        </pc:spChg>
      </pc:sldChg>
    </pc:docChg>
  </pc:docChgLst>
  <pc:docChgLst>
    <pc:chgData name="Kassidy V Herrin" userId="S::kherr17@lsu.edu::78f2563c-1de5-4d7a-85bd-6e884350cb72" providerId="AD" clId="Web-{51BBB194-D393-3D79-4612-E8E7D13A9CF6}"/>
    <pc:docChg chg="modSld">
      <pc:chgData name="Kassidy V Herrin" userId="S::kherr17@lsu.edu::78f2563c-1de5-4d7a-85bd-6e884350cb72" providerId="AD" clId="Web-{51BBB194-D393-3D79-4612-E8E7D13A9CF6}" dt="2024-04-15T15:43:17.792" v="420" actId="20577"/>
      <pc:docMkLst>
        <pc:docMk/>
      </pc:docMkLst>
      <pc:sldChg chg="modSp">
        <pc:chgData name="Kassidy V Herrin" userId="S::kherr17@lsu.edu::78f2563c-1de5-4d7a-85bd-6e884350cb72" providerId="AD" clId="Web-{51BBB194-D393-3D79-4612-E8E7D13A9CF6}" dt="2024-04-15T15:43:17.792" v="420" actId="20577"/>
        <pc:sldMkLst>
          <pc:docMk/>
          <pc:sldMk cId="1267986695" sldId="263"/>
        </pc:sldMkLst>
        <pc:spChg chg="mod">
          <ac:chgData name="Kassidy V Herrin" userId="S::kherr17@lsu.edu::78f2563c-1de5-4d7a-85bd-6e884350cb72" providerId="AD" clId="Web-{51BBB194-D393-3D79-4612-E8E7D13A9CF6}" dt="2024-04-15T15:30:44.014" v="8" actId="20577"/>
          <ac:spMkLst>
            <pc:docMk/>
            <pc:sldMk cId="1267986695" sldId="263"/>
            <ac:spMk id="14339" creationId="{00000000-0000-0000-0000-000000000000}"/>
          </ac:spMkLst>
        </pc:spChg>
        <pc:spChg chg="mod">
          <ac:chgData name="Kassidy V Herrin" userId="S::kherr17@lsu.edu::78f2563c-1de5-4d7a-85bd-6e884350cb72" providerId="AD" clId="Web-{51BBB194-D393-3D79-4612-E8E7D13A9CF6}" dt="2024-04-15T15:42:08.868" v="313" actId="20577"/>
          <ac:spMkLst>
            <pc:docMk/>
            <pc:sldMk cId="1267986695" sldId="263"/>
            <ac:spMk id="14340" creationId="{00000000-0000-0000-0000-000000000000}"/>
          </ac:spMkLst>
        </pc:spChg>
        <pc:spChg chg="mod">
          <ac:chgData name="Kassidy V Herrin" userId="S::kherr17@lsu.edu::78f2563c-1de5-4d7a-85bd-6e884350cb72" providerId="AD" clId="Web-{51BBB194-D393-3D79-4612-E8E7D13A9CF6}" dt="2024-04-15T15:43:17.792" v="420" actId="20577"/>
          <ac:spMkLst>
            <pc:docMk/>
            <pc:sldMk cId="1267986695" sldId="263"/>
            <ac:spMk id="14341" creationId="{00000000-0000-0000-0000-000000000000}"/>
          </ac:spMkLst>
        </pc:spChg>
        <pc:spChg chg="mod">
          <ac:chgData name="Kassidy V Herrin" userId="S::kherr17@lsu.edu::78f2563c-1de5-4d7a-85bd-6e884350cb72" providerId="AD" clId="Web-{51BBB194-D393-3D79-4612-E8E7D13A9CF6}" dt="2024-04-15T15:30:15.669" v="0" actId="14100"/>
          <ac:spMkLst>
            <pc:docMk/>
            <pc:sldMk cId="1267986695" sldId="263"/>
            <ac:spMk id="14343" creationId="{00000000-0000-0000-0000-000000000000}"/>
          </ac:spMkLst>
        </pc:spChg>
      </pc:sldChg>
    </pc:docChg>
  </pc:docChgLst>
  <pc:docChgLst>
    <pc:chgData name="Jada Daniels" userId="S::jdani87@lsu.edu::8970acce-57c7-4559-8174-5ce60882e72d" providerId="AD" clId="Web-{B9990D41-6DCA-05F2-A32C-A787C17485CB}"/>
    <pc:docChg chg="modSld">
      <pc:chgData name="Jada Daniels" userId="S::jdani87@lsu.edu::8970acce-57c7-4559-8174-5ce60882e72d" providerId="AD" clId="Web-{B9990D41-6DCA-05F2-A32C-A787C17485CB}" dt="2024-04-25T21:40:13.500" v="43" actId="1076"/>
      <pc:docMkLst>
        <pc:docMk/>
      </pc:docMkLst>
      <pc:sldChg chg="addSp delSp modSp">
        <pc:chgData name="Jada Daniels" userId="S::jdani87@lsu.edu::8970acce-57c7-4559-8174-5ce60882e72d" providerId="AD" clId="Web-{B9990D41-6DCA-05F2-A32C-A787C17485CB}" dt="2024-04-25T21:40:13.500" v="43" actId="1076"/>
        <pc:sldMkLst>
          <pc:docMk/>
          <pc:sldMk cId="1267986695" sldId="263"/>
        </pc:sldMkLst>
        <pc:spChg chg="del">
          <ac:chgData name="Jada Daniels" userId="S::jdani87@lsu.edu::8970acce-57c7-4559-8174-5ce60882e72d" providerId="AD" clId="Web-{B9990D41-6DCA-05F2-A32C-A787C17485CB}" dt="2024-04-25T21:36:30.103" v="9"/>
          <ac:spMkLst>
            <pc:docMk/>
            <pc:sldMk cId="1267986695" sldId="263"/>
            <ac:spMk id="9" creationId="{A899D352-40E7-A6C6-BD2E-9467BAA1D812}"/>
          </ac:spMkLst>
        </pc:spChg>
        <pc:spChg chg="mod">
          <ac:chgData name="Jada Daniels" userId="S::jdani87@lsu.edu::8970acce-57c7-4559-8174-5ce60882e72d" providerId="AD" clId="Web-{B9990D41-6DCA-05F2-A32C-A787C17485CB}" dt="2024-04-25T21:40:13.500" v="43" actId="1076"/>
          <ac:spMkLst>
            <pc:docMk/>
            <pc:sldMk cId="1267986695" sldId="263"/>
            <ac:spMk id="18" creationId="{12298693-8928-0338-4994-9067E573FBAD}"/>
          </ac:spMkLst>
        </pc:spChg>
        <pc:spChg chg="del">
          <ac:chgData name="Jada Daniels" userId="S::jdani87@lsu.edu::8970acce-57c7-4559-8174-5ce60882e72d" providerId="AD" clId="Web-{B9990D41-6DCA-05F2-A32C-A787C17485CB}" dt="2024-04-25T21:36:26.838" v="7"/>
          <ac:spMkLst>
            <pc:docMk/>
            <pc:sldMk cId="1267986695" sldId="263"/>
            <ac:spMk id="24" creationId="{98E8D37B-B528-A794-086D-319C56A08178}"/>
          </ac:spMkLst>
        </pc:spChg>
        <pc:spChg chg="mod">
          <ac:chgData name="Jada Daniels" userId="S::jdani87@lsu.edu::8970acce-57c7-4559-8174-5ce60882e72d" providerId="AD" clId="Web-{B9990D41-6DCA-05F2-A32C-A787C17485CB}" dt="2024-04-25T21:36:57.526" v="18" actId="14100"/>
          <ac:spMkLst>
            <pc:docMk/>
            <pc:sldMk cId="1267986695" sldId="263"/>
            <ac:spMk id="26" creationId="{C8AD3FA0-91D1-C89A-BD5C-192A99E78AA9}"/>
          </ac:spMkLst>
        </pc:spChg>
        <pc:spChg chg="mod">
          <ac:chgData name="Jada Daniels" userId="S::jdani87@lsu.edu::8970acce-57c7-4559-8174-5ce60882e72d" providerId="AD" clId="Web-{B9990D41-6DCA-05F2-A32C-A787C17485CB}" dt="2024-04-25T21:37:02.745" v="19" actId="1076"/>
          <ac:spMkLst>
            <pc:docMk/>
            <pc:sldMk cId="1267986695" sldId="263"/>
            <ac:spMk id="27" creationId="{E8598A00-C0A7-013C-851B-D8D74B2D51DB}"/>
          </ac:spMkLst>
        </pc:spChg>
        <pc:spChg chg="mod">
          <ac:chgData name="Jada Daniels" userId="S::jdani87@lsu.edu::8970acce-57c7-4559-8174-5ce60882e72d" providerId="AD" clId="Web-{B9990D41-6DCA-05F2-A32C-A787C17485CB}" dt="2024-04-25T21:39:47.952" v="38" actId="20577"/>
          <ac:spMkLst>
            <pc:docMk/>
            <pc:sldMk cId="1267986695" sldId="263"/>
            <ac:spMk id="28" creationId="{84F975A6-A238-8411-DA25-164A62D0BA44}"/>
          </ac:spMkLst>
        </pc:spChg>
        <pc:graphicFrameChg chg="mod modGraphic">
          <ac:chgData name="Jada Daniels" userId="S::jdani87@lsu.edu::8970acce-57c7-4559-8174-5ce60882e72d" providerId="AD" clId="Web-{B9990D41-6DCA-05F2-A32C-A787C17485CB}" dt="2024-04-25T21:39:55.609" v="42"/>
          <ac:graphicFrameMkLst>
            <pc:docMk/>
            <pc:sldMk cId="1267986695" sldId="263"/>
            <ac:graphicFrameMk id="11" creationId="{65AEACB9-B21E-7C82-A5B3-68920EEDC493}"/>
          </ac:graphicFrameMkLst>
        </pc:graphicFrameChg>
        <pc:picChg chg="del">
          <ac:chgData name="Jada Daniels" userId="S::jdani87@lsu.edu::8970acce-57c7-4559-8174-5ce60882e72d" providerId="AD" clId="Web-{B9990D41-6DCA-05F2-A32C-A787C17485CB}" dt="2024-04-25T21:35:57.696" v="1"/>
          <ac:picMkLst>
            <pc:docMk/>
            <pc:sldMk cId="1267986695" sldId="263"/>
            <ac:picMk id="8" creationId="{5B0D1962-0B43-CF5F-45F3-9A9D490074A5}"/>
          </ac:picMkLst>
        </pc:picChg>
        <pc:picChg chg="del">
          <ac:chgData name="Jada Daniels" userId="S::jdani87@lsu.edu::8970acce-57c7-4559-8174-5ce60882e72d" providerId="AD" clId="Web-{B9990D41-6DCA-05F2-A32C-A787C17485CB}" dt="2024-04-25T21:36:18.494" v="5"/>
          <ac:picMkLst>
            <pc:docMk/>
            <pc:sldMk cId="1267986695" sldId="263"/>
            <ac:picMk id="10" creationId="{6BF1A5FE-F89A-88D7-93B9-E97A105CC5A6}"/>
          </ac:picMkLst>
        </pc:picChg>
        <pc:picChg chg="add mod modCrop">
          <ac:chgData name="Jada Daniels" userId="S::jdani87@lsu.edu::8970acce-57c7-4559-8174-5ce60882e72d" providerId="AD" clId="Web-{B9990D41-6DCA-05F2-A32C-A787C17485CB}" dt="2024-04-25T21:37:30.652" v="33" actId="14100"/>
          <ac:picMkLst>
            <pc:docMk/>
            <pc:sldMk cId="1267986695" sldId="263"/>
            <ac:picMk id="38" creationId="{58956C0E-CCF6-6E08-81C6-1B7D33AEA13B}"/>
          </ac:picMkLst>
        </pc:picChg>
        <pc:picChg chg="add mod modCrop">
          <ac:chgData name="Jada Daniels" userId="S::jdani87@lsu.edu::8970acce-57c7-4559-8174-5ce60882e72d" providerId="AD" clId="Web-{B9990D41-6DCA-05F2-A32C-A787C17485CB}" dt="2024-04-25T21:37:13.120" v="21"/>
          <ac:picMkLst>
            <pc:docMk/>
            <pc:sldMk cId="1267986695" sldId="263"/>
            <ac:picMk id="41" creationId="{C51EC121-3A0B-D731-4AF6-3305293DC0A1}"/>
          </ac:picMkLst>
        </pc:picChg>
      </pc:sldChg>
    </pc:docChg>
  </pc:docChgLst>
  <pc:docChgLst>
    <pc:chgData name="Kassidy V Herrin" userId="78f2563c-1de5-4d7a-85bd-6e884350cb72" providerId="ADAL" clId="{A0D37651-25E5-064B-9A2C-A9D007F1356F}"/>
    <pc:docChg chg="undo custSel addSld delSld modSld sldOrd delMainMaster">
      <pc:chgData name="Kassidy V Herrin" userId="78f2563c-1de5-4d7a-85bd-6e884350cb72" providerId="ADAL" clId="{A0D37651-25E5-064B-9A2C-A9D007F1356F}" dt="2024-04-16T03:16:56.168" v="2505" actId="403"/>
      <pc:docMkLst>
        <pc:docMk/>
      </pc:docMkLst>
      <pc:sldChg chg="del">
        <pc:chgData name="Kassidy V Herrin" userId="78f2563c-1de5-4d7a-85bd-6e884350cb72" providerId="ADAL" clId="{A0D37651-25E5-064B-9A2C-A9D007F1356F}" dt="2024-04-11T17:42:00.366" v="14" actId="2696"/>
        <pc:sldMkLst>
          <pc:docMk/>
          <pc:sldMk cId="2104965537" sldId="258"/>
        </pc:sldMkLst>
      </pc:sldChg>
      <pc:sldChg chg="del">
        <pc:chgData name="Kassidy V Herrin" userId="78f2563c-1de5-4d7a-85bd-6e884350cb72" providerId="ADAL" clId="{A0D37651-25E5-064B-9A2C-A9D007F1356F}" dt="2024-04-11T17:42:01.244" v="15" actId="2696"/>
        <pc:sldMkLst>
          <pc:docMk/>
          <pc:sldMk cId="3704958123" sldId="259"/>
        </pc:sldMkLst>
      </pc:sldChg>
      <pc:sldChg chg="del">
        <pc:chgData name="Kassidy V Herrin" userId="78f2563c-1de5-4d7a-85bd-6e884350cb72" providerId="ADAL" clId="{A0D37651-25E5-064B-9A2C-A9D007F1356F}" dt="2024-04-11T17:41:59.130" v="13" actId="2696"/>
        <pc:sldMkLst>
          <pc:docMk/>
          <pc:sldMk cId="3827295177" sldId="260"/>
        </pc:sldMkLst>
      </pc:sldChg>
      <pc:sldChg chg="del">
        <pc:chgData name="Kassidy V Herrin" userId="78f2563c-1de5-4d7a-85bd-6e884350cb72" providerId="ADAL" clId="{A0D37651-25E5-064B-9A2C-A9D007F1356F}" dt="2024-04-11T17:42:02.128" v="16" actId="2696"/>
        <pc:sldMkLst>
          <pc:docMk/>
          <pc:sldMk cId="2656503344" sldId="261"/>
        </pc:sldMkLst>
      </pc:sldChg>
      <pc:sldChg chg="del">
        <pc:chgData name="Kassidy V Herrin" userId="78f2563c-1de5-4d7a-85bd-6e884350cb72" providerId="ADAL" clId="{A0D37651-25E5-064B-9A2C-A9D007F1356F}" dt="2024-04-16T01:22:55.482" v="2063" actId="2696"/>
        <pc:sldMkLst>
          <pc:docMk/>
          <pc:sldMk cId="3001941816" sldId="262"/>
        </pc:sldMkLst>
      </pc:sldChg>
      <pc:sldChg chg="addSp delSp modSp mod">
        <pc:chgData name="Kassidy V Herrin" userId="78f2563c-1de5-4d7a-85bd-6e884350cb72" providerId="ADAL" clId="{A0D37651-25E5-064B-9A2C-A9D007F1356F}" dt="2024-04-16T02:00:39.506" v="2124" actId="1035"/>
        <pc:sldMkLst>
          <pc:docMk/>
          <pc:sldMk cId="1267986695" sldId="263"/>
        </pc:sldMkLst>
        <pc:spChg chg="mod">
          <ac:chgData name="Kassidy V Herrin" userId="78f2563c-1de5-4d7a-85bd-6e884350cb72" providerId="ADAL" clId="{A0D37651-25E5-064B-9A2C-A9D007F1356F}" dt="2024-04-15T16:21:17.432" v="1459" actId="1035"/>
          <ac:spMkLst>
            <pc:docMk/>
            <pc:sldMk cId="1267986695" sldId="263"/>
            <ac:spMk id="2" creationId="{C391A11A-2981-C111-5347-6F129B8F65AF}"/>
          </ac:spMkLst>
        </pc:spChg>
        <pc:spChg chg="add mod">
          <ac:chgData name="Kassidy V Herrin" userId="78f2563c-1de5-4d7a-85bd-6e884350cb72" providerId="ADAL" clId="{A0D37651-25E5-064B-9A2C-A9D007F1356F}" dt="2024-04-15T20:43:32.553" v="1914" actId="1037"/>
          <ac:spMkLst>
            <pc:docMk/>
            <pc:sldMk cId="1267986695" sldId="263"/>
            <ac:spMk id="3" creationId="{57203A09-E0E1-3B0B-8F2F-EDFB121ED264}"/>
          </ac:spMkLst>
        </pc:spChg>
        <pc:spChg chg="add mod">
          <ac:chgData name="Kassidy V Herrin" userId="78f2563c-1de5-4d7a-85bd-6e884350cb72" providerId="ADAL" clId="{A0D37651-25E5-064B-9A2C-A9D007F1356F}" dt="2024-04-16T01:19:17.757" v="1941" actId="20577"/>
          <ac:spMkLst>
            <pc:docMk/>
            <pc:sldMk cId="1267986695" sldId="263"/>
            <ac:spMk id="4" creationId="{217DAC3D-373F-6075-9EF8-904BF8427108}"/>
          </ac:spMkLst>
        </pc:spChg>
        <pc:spChg chg="add mod">
          <ac:chgData name="Kassidy V Herrin" userId="78f2563c-1de5-4d7a-85bd-6e884350cb72" providerId="ADAL" clId="{A0D37651-25E5-064B-9A2C-A9D007F1356F}" dt="2024-04-15T16:27:27.857" v="1755" actId="1036"/>
          <ac:spMkLst>
            <pc:docMk/>
            <pc:sldMk cId="1267986695" sldId="263"/>
            <ac:spMk id="5" creationId="{F32B9F2F-C767-75A6-AE69-6C7D0946C632}"/>
          </ac:spMkLst>
        </pc:spChg>
        <pc:spChg chg="mod">
          <ac:chgData name="Kassidy V Herrin" userId="78f2563c-1de5-4d7a-85bd-6e884350cb72" providerId="ADAL" clId="{A0D37651-25E5-064B-9A2C-A9D007F1356F}" dt="2024-04-16T01:21:39.268" v="2051" actId="114"/>
          <ac:spMkLst>
            <pc:docMk/>
            <pc:sldMk cId="1267986695" sldId="263"/>
            <ac:spMk id="12" creationId="{00000000-0000-0000-0000-000000000000}"/>
          </ac:spMkLst>
        </pc:spChg>
        <pc:spChg chg="mod">
          <ac:chgData name="Kassidy V Herrin" userId="78f2563c-1de5-4d7a-85bd-6e884350cb72" providerId="ADAL" clId="{A0D37651-25E5-064B-9A2C-A9D007F1356F}" dt="2024-04-15T20:42:29.502" v="1893" actId="14100"/>
          <ac:spMkLst>
            <pc:docMk/>
            <pc:sldMk cId="1267986695" sldId="263"/>
            <ac:spMk id="14" creationId="{00000000-0000-0000-0000-000000000000}"/>
          </ac:spMkLst>
        </pc:spChg>
        <pc:spChg chg="mod">
          <ac:chgData name="Kassidy V Herrin" userId="78f2563c-1de5-4d7a-85bd-6e884350cb72" providerId="ADAL" clId="{A0D37651-25E5-064B-9A2C-A9D007F1356F}" dt="2024-04-16T02:00:39.506" v="2124" actId="1035"/>
          <ac:spMkLst>
            <pc:docMk/>
            <pc:sldMk cId="1267986695" sldId="263"/>
            <ac:spMk id="15" creationId="{00000000-0000-0000-0000-000000000000}"/>
          </ac:spMkLst>
        </pc:spChg>
        <pc:spChg chg="mod">
          <ac:chgData name="Kassidy V Herrin" userId="78f2563c-1de5-4d7a-85bd-6e884350cb72" providerId="ADAL" clId="{A0D37651-25E5-064B-9A2C-A9D007F1356F}" dt="2024-04-15T16:21:04.542" v="1450" actId="1036"/>
          <ac:spMkLst>
            <pc:docMk/>
            <pc:sldMk cId="1267986695" sldId="263"/>
            <ac:spMk id="16" creationId="{00000000-0000-0000-0000-000000000000}"/>
          </ac:spMkLst>
        </pc:spChg>
        <pc:spChg chg="mod">
          <ac:chgData name="Kassidy V Herrin" userId="78f2563c-1de5-4d7a-85bd-6e884350cb72" providerId="ADAL" clId="{A0D37651-25E5-064B-9A2C-A9D007F1356F}" dt="2024-04-15T20:43:09.628" v="1904" actId="1035"/>
          <ac:spMkLst>
            <pc:docMk/>
            <pc:sldMk cId="1267986695" sldId="263"/>
            <ac:spMk id="17" creationId="{00000000-0000-0000-0000-000000000000}"/>
          </ac:spMkLst>
        </pc:spChg>
        <pc:spChg chg="del mod">
          <ac:chgData name="Kassidy V Herrin" userId="78f2563c-1de5-4d7a-85bd-6e884350cb72" providerId="ADAL" clId="{A0D37651-25E5-064B-9A2C-A9D007F1356F}" dt="2024-04-11T17:58:09.781" v="23" actId="478"/>
          <ac:spMkLst>
            <pc:docMk/>
            <pc:sldMk cId="1267986695" sldId="263"/>
            <ac:spMk id="18" creationId="{00000000-0000-0000-0000-000000000000}"/>
          </ac:spMkLst>
        </pc:spChg>
        <pc:spChg chg="mod">
          <ac:chgData name="Kassidy V Herrin" userId="78f2563c-1de5-4d7a-85bd-6e884350cb72" providerId="ADAL" clId="{A0D37651-25E5-064B-9A2C-A9D007F1356F}" dt="2024-04-16T01:18:41.044" v="1935" actId="20577"/>
          <ac:spMkLst>
            <pc:docMk/>
            <pc:sldMk cId="1267986695" sldId="263"/>
            <ac:spMk id="19" creationId="{00000000-0000-0000-0000-000000000000}"/>
          </ac:spMkLst>
        </pc:spChg>
        <pc:spChg chg="mod">
          <ac:chgData name="Kassidy V Herrin" userId="78f2563c-1de5-4d7a-85bd-6e884350cb72" providerId="ADAL" clId="{A0D37651-25E5-064B-9A2C-A9D007F1356F}" dt="2024-04-15T16:23:13.591" v="1563" actId="1036"/>
          <ac:spMkLst>
            <pc:docMk/>
            <pc:sldMk cId="1267986695" sldId="263"/>
            <ac:spMk id="20" creationId="{00000000-0000-0000-0000-000000000000}"/>
          </ac:spMkLst>
        </pc:spChg>
        <pc:spChg chg="mod">
          <ac:chgData name="Kassidy V Herrin" userId="78f2563c-1de5-4d7a-85bd-6e884350cb72" providerId="ADAL" clId="{A0D37651-25E5-064B-9A2C-A9D007F1356F}" dt="2024-04-15T16:23:10.763" v="1560" actId="1035"/>
          <ac:spMkLst>
            <pc:docMk/>
            <pc:sldMk cId="1267986695" sldId="263"/>
            <ac:spMk id="22" creationId="{00000000-0000-0000-0000-000000000000}"/>
          </ac:spMkLst>
        </pc:spChg>
        <pc:spChg chg="mod">
          <ac:chgData name="Kassidy V Herrin" userId="78f2563c-1de5-4d7a-85bd-6e884350cb72" providerId="ADAL" clId="{A0D37651-25E5-064B-9A2C-A9D007F1356F}" dt="2024-04-15T20:42:18.702" v="1891" actId="14100"/>
          <ac:spMkLst>
            <pc:docMk/>
            <pc:sldMk cId="1267986695" sldId="263"/>
            <ac:spMk id="23" creationId="{00000000-0000-0000-0000-000000000000}"/>
          </ac:spMkLst>
        </pc:spChg>
        <pc:spChg chg="mod">
          <ac:chgData name="Kassidy V Herrin" userId="78f2563c-1de5-4d7a-85bd-6e884350cb72" providerId="ADAL" clId="{A0D37651-25E5-064B-9A2C-A9D007F1356F}" dt="2024-04-16T01:19:43.052" v="1944" actId="20577"/>
          <ac:spMkLst>
            <pc:docMk/>
            <pc:sldMk cId="1267986695" sldId="263"/>
            <ac:spMk id="32" creationId="{44B01CFD-FD60-D4B8-9DB0-913901421BEE}"/>
          </ac:spMkLst>
        </pc:spChg>
        <pc:spChg chg="mod">
          <ac:chgData name="Kassidy V Herrin" userId="78f2563c-1de5-4d7a-85bd-6e884350cb72" providerId="ADAL" clId="{A0D37651-25E5-064B-9A2C-A9D007F1356F}" dt="2024-04-16T01:19:52.316" v="1946" actId="20577"/>
          <ac:spMkLst>
            <pc:docMk/>
            <pc:sldMk cId="1267986695" sldId="263"/>
            <ac:spMk id="36" creationId="{30EAF356-4807-BAF3-0908-80002FAFCE7E}"/>
          </ac:spMkLst>
        </pc:spChg>
        <pc:spChg chg="mod">
          <ac:chgData name="Kassidy V Herrin" userId="78f2563c-1de5-4d7a-85bd-6e884350cb72" providerId="ADAL" clId="{A0D37651-25E5-064B-9A2C-A9D007F1356F}" dt="2024-04-16T01:18:54.480" v="1936" actId="114"/>
          <ac:spMkLst>
            <pc:docMk/>
            <pc:sldMk cId="1267986695" sldId="263"/>
            <ac:spMk id="14339" creationId="{00000000-0000-0000-0000-000000000000}"/>
          </ac:spMkLst>
        </pc:spChg>
        <pc:spChg chg="mod">
          <ac:chgData name="Kassidy V Herrin" userId="78f2563c-1de5-4d7a-85bd-6e884350cb72" providerId="ADAL" clId="{A0D37651-25E5-064B-9A2C-A9D007F1356F}" dt="2024-04-16T02:00:39.506" v="2124" actId="1035"/>
          <ac:spMkLst>
            <pc:docMk/>
            <pc:sldMk cId="1267986695" sldId="263"/>
            <ac:spMk id="14340" creationId="{00000000-0000-0000-0000-000000000000}"/>
          </ac:spMkLst>
        </pc:spChg>
        <pc:spChg chg="mod">
          <ac:chgData name="Kassidy V Herrin" userId="78f2563c-1de5-4d7a-85bd-6e884350cb72" providerId="ADAL" clId="{A0D37651-25E5-064B-9A2C-A9D007F1356F}" dt="2024-04-15T16:28:16.721" v="1785" actId="1036"/>
          <ac:spMkLst>
            <pc:docMk/>
            <pc:sldMk cId="1267986695" sldId="263"/>
            <ac:spMk id="14341" creationId="{00000000-0000-0000-0000-000000000000}"/>
          </ac:spMkLst>
        </pc:spChg>
        <pc:spChg chg="mod">
          <ac:chgData name="Kassidy V Herrin" userId="78f2563c-1de5-4d7a-85bd-6e884350cb72" providerId="ADAL" clId="{A0D37651-25E5-064B-9A2C-A9D007F1356F}" dt="2024-04-15T16:23:00.679" v="1555" actId="14100"/>
          <ac:spMkLst>
            <pc:docMk/>
            <pc:sldMk cId="1267986695" sldId="263"/>
            <ac:spMk id="14342" creationId="{00000000-0000-0000-0000-000000000000}"/>
          </ac:spMkLst>
        </pc:spChg>
        <pc:spChg chg="mod">
          <ac:chgData name="Kassidy V Herrin" userId="78f2563c-1de5-4d7a-85bd-6e884350cb72" providerId="ADAL" clId="{A0D37651-25E5-064B-9A2C-A9D007F1356F}" dt="2024-04-16T01:19:59.525" v="1950" actId="20577"/>
          <ac:spMkLst>
            <pc:docMk/>
            <pc:sldMk cId="1267986695" sldId="263"/>
            <ac:spMk id="14343" creationId="{00000000-0000-0000-0000-000000000000}"/>
          </ac:spMkLst>
        </pc:spChg>
        <pc:picChg chg="mod">
          <ac:chgData name="Kassidy V Herrin" userId="78f2563c-1de5-4d7a-85bd-6e884350cb72" providerId="ADAL" clId="{A0D37651-25E5-064B-9A2C-A9D007F1356F}" dt="2024-04-16T01:21:52.688" v="2062" actId="1038"/>
          <ac:picMkLst>
            <pc:docMk/>
            <pc:sldMk cId="1267986695" sldId="263"/>
            <ac:picMk id="13" creationId="{0D970357-180A-4FD6-82C1-FA8CE267D04C}"/>
          </ac:picMkLst>
        </pc:picChg>
        <pc:picChg chg="mod">
          <ac:chgData name="Kassidy V Herrin" userId="78f2563c-1de5-4d7a-85bd-6e884350cb72" providerId="ADAL" clId="{A0D37651-25E5-064B-9A2C-A9D007F1356F}" dt="2024-04-16T01:21:48.784" v="2059" actId="1037"/>
          <ac:picMkLst>
            <pc:docMk/>
            <pc:sldMk cId="1267986695" sldId="263"/>
            <ac:picMk id="21" creationId="{00000000-0000-0000-0000-000000000000}"/>
          </ac:picMkLst>
        </pc:picChg>
      </pc:sldChg>
      <pc:sldChg chg="del">
        <pc:chgData name="Kassidy V Herrin" userId="78f2563c-1de5-4d7a-85bd-6e884350cb72" providerId="ADAL" clId="{A0D37651-25E5-064B-9A2C-A9D007F1356F}" dt="2024-04-11T17:42:03.890" v="17" actId="2696"/>
        <pc:sldMkLst>
          <pc:docMk/>
          <pc:sldMk cId="1616418881" sldId="264"/>
        </pc:sldMkLst>
      </pc:sldChg>
      <pc:sldChg chg="addSp delSp modSp new del mod setBg">
        <pc:chgData name="Kassidy V Herrin" userId="78f2563c-1de5-4d7a-85bd-6e884350cb72" providerId="ADAL" clId="{A0D37651-25E5-064B-9A2C-A9D007F1356F}" dt="2024-04-16T01:59:02.912" v="2103" actId="2696"/>
        <pc:sldMkLst>
          <pc:docMk/>
          <pc:sldMk cId="3053693188" sldId="264"/>
        </pc:sldMkLst>
        <pc:spChg chg="add del mod">
          <ac:chgData name="Kassidy V Herrin" userId="78f2563c-1de5-4d7a-85bd-6e884350cb72" providerId="ADAL" clId="{A0D37651-25E5-064B-9A2C-A9D007F1356F}" dt="2024-04-16T01:57:55.945" v="2080"/>
          <ac:spMkLst>
            <pc:docMk/>
            <pc:sldMk cId="3053693188" sldId="264"/>
            <ac:spMk id="4" creationId="{81803E18-77DD-F5F5-D2AA-C89C113B6A92}"/>
          </ac:spMkLst>
        </pc:spChg>
        <pc:spChg chg="add del mod">
          <ac:chgData name="Kassidy V Herrin" userId="78f2563c-1de5-4d7a-85bd-6e884350cb72" providerId="ADAL" clId="{A0D37651-25E5-064B-9A2C-A9D007F1356F}" dt="2024-04-16T01:58:59.987" v="2102"/>
          <ac:spMkLst>
            <pc:docMk/>
            <pc:sldMk cId="3053693188" sldId="264"/>
            <ac:spMk id="5" creationId="{684BFA08-8EB2-FE0F-0E70-6617A5A091DF}"/>
          </ac:spMkLst>
        </pc:spChg>
        <pc:spChg chg="add del">
          <ac:chgData name="Kassidy V Herrin" userId="78f2563c-1de5-4d7a-85bd-6e884350cb72" providerId="ADAL" clId="{A0D37651-25E5-064B-9A2C-A9D007F1356F}" dt="2024-04-16T01:58:44.392" v="2083" actId="26606"/>
          <ac:spMkLst>
            <pc:docMk/>
            <pc:sldMk cId="3053693188" sldId="264"/>
            <ac:spMk id="18" creationId="{8950AD4C-6AF3-49F8-94E1-DBCAFB39478B}"/>
          </ac:spMkLst>
        </pc:spChg>
        <pc:spChg chg="add del">
          <ac:chgData name="Kassidy V Herrin" userId="78f2563c-1de5-4d7a-85bd-6e884350cb72" providerId="ADAL" clId="{A0D37651-25E5-064B-9A2C-A9D007F1356F}" dt="2024-04-16T01:58:44.392" v="2083" actId="26606"/>
          <ac:spMkLst>
            <pc:docMk/>
            <pc:sldMk cId="3053693188" sldId="264"/>
            <ac:spMk id="20" creationId="{0ACBD85E-A404-45CB-B532-1039E479D4C6}"/>
          </ac:spMkLst>
        </pc:spChg>
        <pc:spChg chg="add del">
          <ac:chgData name="Kassidy V Herrin" userId="78f2563c-1de5-4d7a-85bd-6e884350cb72" providerId="ADAL" clId="{A0D37651-25E5-064B-9A2C-A9D007F1356F}" dt="2024-04-16T01:58:44.392" v="2083" actId="26606"/>
          <ac:spMkLst>
            <pc:docMk/>
            <pc:sldMk cId="3053693188" sldId="264"/>
            <ac:spMk id="22" creationId="{DB1626B1-BAC7-4893-A5AC-620597685187}"/>
          </ac:spMkLst>
        </pc:spChg>
        <pc:spChg chg="add del">
          <ac:chgData name="Kassidy V Herrin" userId="78f2563c-1de5-4d7a-85bd-6e884350cb72" providerId="ADAL" clId="{A0D37651-25E5-064B-9A2C-A9D007F1356F}" dt="2024-04-16T01:58:44.392" v="2083" actId="26606"/>
          <ac:spMkLst>
            <pc:docMk/>
            <pc:sldMk cId="3053693188" sldId="264"/>
            <ac:spMk id="24" creationId="{D64E9910-51FE-45BF-973D-9D2401FD3C63}"/>
          </ac:spMkLst>
        </pc:spChg>
        <pc:picChg chg="add mod">
          <ac:chgData name="Kassidy V Herrin" userId="78f2563c-1de5-4d7a-85bd-6e884350cb72" providerId="ADAL" clId="{A0D37651-25E5-064B-9A2C-A9D007F1356F}" dt="2024-04-16T01:58:51.381" v="2099" actId="1036"/>
          <ac:picMkLst>
            <pc:docMk/>
            <pc:sldMk cId="3053693188" sldId="264"/>
            <ac:picMk id="3" creationId="{D40A0352-0235-5F1B-F15B-D17DDD69094E}"/>
          </ac:picMkLst>
        </pc:picChg>
        <pc:cxnChg chg="add del">
          <ac:chgData name="Kassidy V Herrin" userId="78f2563c-1de5-4d7a-85bd-6e884350cb72" providerId="ADAL" clId="{A0D37651-25E5-064B-9A2C-A9D007F1356F}" dt="2024-04-16T01:57:47.153" v="2077" actId="26606"/>
          <ac:cxnSpMkLst>
            <pc:docMk/>
            <pc:sldMk cId="3053693188" sldId="264"/>
            <ac:cxnSpMk id="8" creationId="{22F6364A-B358-4BEE-B158-0734D2C938D4}"/>
          </ac:cxnSpMkLst>
        </pc:cxnChg>
        <pc:cxnChg chg="add del">
          <ac:chgData name="Kassidy V Herrin" userId="78f2563c-1de5-4d7a-85bd-6e884350cb72" providerId="ADAL" clId="{A0D37651-25E5-064B-9A2C-A9D007F1356F}" dt="2024-04-16T01:58:44.400" v="2084" actId="26606"/>
          <ac:cxnSpMkLst>
            <pc:docMk/>
            <pc:sldMk cId="3053693188" sldId="264"/>
            <ac:cxnSpMk id="13" creationId="{22F6364A-B358-4BEE-B158-0734D2C938D4}"/>
          </ac:cxnSpMkLst>
        </pc:cxnChg>
        <pc:cxnChg chg="add">
          <ac:chgData name="Kassidy V Herrin" userId="78f2563c-1de5-4d7a-85bd-6e884350cb72" providerId="ADAL" clId="{A0D37651-25E5-064B-9A2C-A9D007F1356F}" dt="2024-04-16T01:58:44.400" v="2084" actId="26606"/>
          <ac:cxnSpMkLst>
            <pc:docMk/>
            <pc:sldMk cId="3053693188" sldId="264"/>
            <ac:cxnSpMk id="26" creationId="{22F6364A-B358-4BEE-B158-0734D2C938D4}"/>
          </ac:cxnSpMkLst>
        </pc:cxnChg>
      </pc:sldChg>
      <pc:sldChg chg="del">
        <pc:chgData name="Kassidy V Herrin" userId="78f2563c-1de5-4d7a-85bd-6e884350cb72" providerId="ADAL" clId="{A0D37651-25E5-064B-9A2C-A9D007F1356F}" dt="2024-04-11T17:41:57.863" v="0" actId="2696"/>
        <pc:sldMkLst>
          <pc:docMk/>
          <pc:sldMk cId="3442931456" sldId="265"/>
        </pc:sldMkLst>
      </pc:sldChg>
      <pc:sldChg chg="ord">
        <pc:chgData name="Kassidy V Herrin" userId="78f2563c-1de5-4d7a-85bd-6e884350cb72" providerId="ADAL" clId="{A0D37651-25E5-064B-9A2C-A9D007F1356F}" dt="2024-04-16T02:03:04.178" v="2127" actId="20578"/>
        <pc:sldMkLst>
          <pc:docMk/>
          <pc:sldMk cId="4277929086" sldId="266"/>
        </pc:sldMkLst>
      </pc:sldChg>
      <pc:sldChg chg="addSp modSp new mod ord">
        <pc:chgData name="Kassidy V Herrin" userId="78f2563c-1de5-4d7a-85bd-6e884350cb72" providerId="ADAL" clId="{A0D37651-25E5-064B-9A2C-A9D007F1356F}" dt="2024-04-16T01:59:27.156" v="2113" actId="1076"/>
        <pc:sldMkLst>
          <pc:docMk/>
          <pc:sldMk cId="1227497581" sldId="267"/>
        </pc:sldMkLst>
        <pc:picChg chg="add mod">
          <ac:chgData name="Kassidy V Herrin" userId="78f2563c-1de5-4d7a-85bd-6e884350cb72" providerId="ADAL" clId="{A0D37651-25E5-064B-9A2C-A9D007F1356F}" dt="2024-04-16T01:59:27.156" v="2113" actId="1076"/>
          <ac:picMkLst>
            <pc:docMk/>
            <pc:sldMk cId="1227497581" sldId="267"/>
            <ac:picMk id="3" creationId="{DF1DE1BE-89AF-E601-DF57-44B104AFEF60}"/>
          </ac:picMkLst>
        </pc:picChg>
      </pc:sldChg>
      <pc:sldChg chg="addSp modSp new mod">
        <pc:chgData name="Kassidy V Herrin" userId="78f2563c-1de5-4d7a-85bd-6e884350cb72" providerId="ADAL" clId="{A0D37651-25E5-064B-9A2C-A9D007F1356F}" dt="2024-04-16T01:59:45.593" v="2119" actId="1076"/>
        <pc:sldMkLst>
          <pc:docMk/>
          <pc:sldMk cId="4151853014" sldId="268"/>
        </pc:sldMkLst>
        <pc:picChg chg="add mod">
          <ac:chgData name="Kassidy V Herrin" userId="78f2563c-1de5-4d7a-85bd-6e884350cb72" providerId="ADAL" clId="{A0D37651-25E5-064B-9A2C-A9D007F1356F}" dt="2024-04-16T01:59:45.593" v="2119" actId="1076"/>
          <ac:picMkLst>
            <pc:docMk/>
            <pc:sldMk cId="4151853014" sldId="268"/>
            <ac:picMk id="3" creationId="{0E7495E6-4747-7AEE-2C64-C3FB020A805F}"/>
          </ac:picMkLst>
        </pc:picChg>
      </pc:sldChg>
      <pc:sldChg chg="modSp add mod ord">
        <pc:chgData name="Kassidy V Herrin" userId="78f2563c-1de5-4d7a-85bd-6e884350cb72" providerId="ADAL" clId="{A0D37651-25E5-064B-9A2C-A9D007F1356F}" dt="2024-04-16T02:04:19.861" v="2140" actId="255"/>
        <pc:sldMkLst>
          <pc:docMk/>
          <pc:sldMk cId="3452841041" sldId="269"/>
        </pc:sldMkLst>
        <pc:spChg chg="mod">
          <ac:chgData name="Kassidy V Herrin" userId="78f2563c-1de5-4d7a-85bd-6e884350cb72" providerId="ADAL" clId="{A0D37651-25E5-064B-9A2C-A9D007F1356F}" dt="2024-04-16T02:04:19.861" v="2140" actId="255"/>
          <ac:spMkLst>
            <pc:docMk/>
            <pc:sldMk cId="3452841041" sldId="269"/>
            <ac:spMk id="14341" creationId="{00000000-0000-0000-0000-000000000000}"/>
          </ac:spMkLst>
        </pc:spChg>
      </pc:sldChg>
      <pc:sldChg chg="new">
        <pc:chgData name="Kassidy V Herrin" userId="78f2563c-1de5-4d7a-85bd-6e884350cb72" providerId="ADAL" clId="{A0D37651-25E5-064B-9A2C-A9D007F1356F}" dt="2024-04-16T02:03:11.624" v="2128" actId="680"/>
        <pc:sldMkLst>
          <pc:docMk/>
          <pc:sldMk cId="1964245774" sldId="270"/>
        </pc:sldMkLst>
      </pc:sldChg>
      <pc:sldChg chg="modSp new mod">
        <pc:chgData name="Kassidy V Herrin" userId="78f2563c-1de5-4d7a-85bd-6e884350cb72" providerId="ADAL" clId="{A0D37651-25E5-064B-9A2C-A9D007F1356F}" dt="2024-04-16T03:16:56.168" v="2505" actId="403"/>
        <pc:sldMkLst>
          <pc:docMk/>
          <pc:sldMk cId="402720778" sldId="271"/>
        </pc:sldMkLst>
        <pc:spChg chg="mod">
          <ac:chgData name="Kassidy V Herrin" userId="78f2563c-1de5-4d7a-85bd-6e884350cb72" providerId="ADAL" clId="{A0D37651-25E5-064B-9A2C-A9D007F1356F}" dt="2024-04-16T03:16:56.168" v="2505" actId="403"/>
          <ac:spMkLst>
            <pc:docMk/>
            <pc:sldMk cId="402720778" sldId="271"/>
            <ac:spMk id="5" creationId="{38583EFD-9386-D037-4718-750BE378D7AD}"/>
          </ac:spMkLst>
        </pc:spChg>
      </pc:sldChg>
      <pc:sldChg chg="addSp modSp new mod">
        <pc:chgData name="Kassidy V Herrin" userId="78f2563c-1de5-4d7a-85bd-6e884350cb72" providerId="ADAL" clId="{A0D37651-25E5-064B-9A2C-A9D007F1356F}" dt="2024-04-16T02:04:59.818" v="2156" actId="1076"/>
        <pc:sldMkLst>
          <pc:docMk/>
          <pc:sldMk cId="1488488167" sldId="272"/>
        </pc:sldMkLst>
        <pc:picChg chg="add mod">
          <ac:chgData name="Kassidy V Herrin" userId="78f2563c-1de5-4d7a-85bd-6e884350cb72" providerId="ADAL" clId="{A0D37651-25E5-064B-9A2C-A9D007F1356F}" dt="2024-04-16T02:04:57.518" v="2155" actId="1076"/>
          <ac:picMkLst>
            <pc:docMk/>
            <pc:sldMk cId="1488488167" sldId="272"/>
            <ac:picMk id="3" creationId="{771F45C9-BB0C-09C9-484E-A17D643C2D49}"/>
          </ac:picMkLst>
        </pc:picChg>
        <pc:picChg chg="add mod">
          <ac:chgData name="Kassidy V Herrin" userId="78f2563c-1de5-4d7a-85bd-6e884350cb72" providerId="ADAL" clId="{A0D37651-25E5-064B-9A2C-A9D007F1356F}" dt="2024-04-16T02:04:59.818" v="2156" actId="1076"/>
          <ac:picMkLst>
            <pc:docMk/>
            <pc:sldMk cId="1488488167" sldId="272"/>
            <ac:picMk id="5" creationId="{3C7E7A74-6C72-B358-022B-FDA8B3EFBC0F}"/>
          </ac:picMkLst>
        </pc:picChg>
      </pc:sldChg>
      <pc:sldChg chg="new del">
        <pc:chgData name="Kassidy V Herrin" userId="78f2563c-1de5-4d7a-85bd-6e884350cb72" providerId="ADAL" clId="{A0D37651-25E5-064B-9A2C-A9D007F1356F}" dt="2024-04-16T02:05:32.005" v="2158" actId="2696"/>
        <pc:sldMkLst>
          <pc:docMk/>
          <pc:sldMk cId="528204081" sldId="273"/>
        </pc:sldMkLst>
      </pc:sldChg>
      <pc:sldChg chg="addSp delSp modSp new mod modClrScheme chgLayout">
        <pc:chgData name="Kassidy V Herrin" userId="78f2563c-1de5-4d7a-85bd-6e884350cb72" providerId="ADAL" clId="{A0D37651-25E5-064B-9A2C-A9D007F1356F}" dt="2024-04-16T02:10:18.733" v="2502" actId="115"/>
        <pc:sldMkLst>
          <pc:docMk/>
          <pc:sldMk cId="2959281206" sldId="273"/>
        </pc:sldMkLst>
        <pc:spChg chg="add del mod ord">
          <ac:chgData name="Kassidy V Herrin" userId="78f2563c-1de5-4d7a-85bd-6e884350cb72" providerId="ADAL" clId="{A0D37651-25E5-064B-9A2C-A9D007F1356F}" dt="2024-04-16T02:05:57.024" v="2161" actId="700"/>
          <ac:spMkLst>
            <pc:docMk/>
            <pc:sldMk cId="2959281206" sldId="273"/>
            <ac:spMk id="2" creationId="{1D1D35F9-6C28-FB8C-BE64-E4E2F7A7ACF7}"/>
          </ac:spMkLst>
        </pc:spChg>
        <pc:spChg chg="add del mod ord">
          <ac:chgData name="Kassidy V Herrin" userId="78f2563c-1de5-4d7a-85bd-6e884350cb72" providerId="ADAL" clId="{A0D37651-25E5-064B-9A2C-A9D007F1356F}" dt="2024-04-16T02:05:57.024" v="2161" actId="700"/>
          <ac:spMkLst>
            <pc:docMk/>
            <pc:sldMk cId="2959281206" sldId="273"/>
            <ac:spMk id="3" creationId="{2974AC5F-7626-4469-5CC1-9F24EAE55628}"/>
          </ac:spMkLst>
        </pc:spChg>
        <pc:spChg chg="add del mod ord">
          <ac:chgData name="Kassidy V Herrin" userId="78f2563c-1de5-4d7a-85bd-6e884350cb72" providerId="ADAL" clId="{A0D37651-25E5-064B-9A2C-A9D007F1356F}" dt="2024-04-16T02:07:31.689" v="2186" actId="700"/>
          <ac:spMkLst>
            <pc:docMk/>
            <pc:sldMk cId="2959281206" sldId="273"/>
            <ac:spMk id="4" creationId="{03708787-211F-40B7-D590-AD8C1F1E7221}"/>
          </ac:spMkLst>
        </pc:spChg>
        <pc:spChg chg="add del mod ord">
          <ac:chgData name="Kassidy V Herrin" userId="78f2563c-1de5-4d7a-85bd-6e884350cb72" providerId="ADAL" clId="{A0D37651-25E5-064B-9A2C-A9D007F1356F}" dt="2024-04-16T02:07:31.689" v="2186" actId="700"/>
          <ac:spMkLst>
            <pc:docMk/>
            <pc:sldMk cId="2959281206" sldId="273"/>
            <ac:spMk id="5" creationId="{5B1A3E70-789E-25DA-39E2-35BED95EDCF7}"/>
          </ac:spMkLst>
        </pc:spChg>
        <pc:spChg chg="add del mod ord">
          <ac:chgData name="Kassidy V Herrin" userId="78f2563c-1de5-4d7a-85bd-6e884350cb72" providerId="ADAL" clId="{A0D37651-25E5-064B-9A2C-A9D007F1356F}" dt="2024-04-16T02:07:31.689" v="2186" actId="700"/>
          <ac:spMkLst>
            <pc:docMk/>
            <pc:sldMk cId="2959281206" sldId="273"/>
            <ac:spMk id="6" creationId="{C4D7F24E-6FC3-4505-E774-FE5DCE8445FA}"/>
          </ac:spMkLst>
        </pc:spChg>
        <pc:spChg chg="add del mod">
          <ac:chgData name="Kassidy V Herrin" userId="78f2563c-1de5-4d7a-85bd-6e884350cb72" providerId="ADAL" clId="{A0D37651-25E5-064B-9A2C-A9D007F1356F}" dt="2024-04-16T02:07:25.238" v="2185" actId="478"/>
          <ac:spMkLst>
            <pc:docMk/>
            <pc:sldMk cId="2959281206" sldId="273"/>
            <ac:spMk id="7" creationId="{D1E50CDF-96A7-0FB9-75C2-4D8717DF028D}"/>
          </ac:spMkLst>
        </pc:spChg>
        <pc:spChg chg="add mod ord">
          <ac:chgData name="Kassidy V Herrin" userId="78f2563c-1de5-4d7a-85bd-6e884350cb72" providerId="ADAL" clId="{A0D37651-25E5-064B-9A2C-A9D007F1356F}" dt="2024-04-16T02:10:09.754" v="2499" actId="207"/>
          <ac:spMkLst>
            <pc:docMk/>
            <pc:sldMk cId="2959281206" sldId="273"/>
            <ac:spMk id="8" creationId="{9F28D495-6CE1-AB41-DCCE-049E7617355A}"/>
          </ac:spMkLst>
        </pc:spChg>
        <pc:spChg chg="add mod ord">
          <ac:chgData name="Kassidy V Herrin" userId="78f2563c-1de5-4d7a-85bd-6e884350cb72" providerId="ADAL" clId="{A0D37651-25E5-064B-9A2C-A9D007F1356F}" dt="2024-04-16T02:10:18.733" v="2502" actId="115"/>
          <ac:spMkLst>
            <pc:docMk/>
            <pc:sldMk cId="2959281206" sldId="273"/>
            <ac:spMk id="9" creationId="{720C8693-2A99-DB3C-A2D1-786163DD4C3E}"/>
          </ac:spMkLst>
        </pc:spChg>
      </pc:sldChg>
      <pc:sldMasterChg chg="del delSldLayout">
        <pc:chgData name="Kassidy V Herrin" userId="78f2563c-1de5-4d7a-85bd-6e884350cb72" providerId="ADAL" clId="{A0D37651-25E5-064B-9A2C-A9D007F1356F}" dt="2024-04-11T17:41:57.890" v="12" actId="2696"/>
        <pc:sldMasterMkLst>
          <pc:docMk/>
          <pc:sldMasterMk cId="0" sldId="2147483660"/>
        </pc:sldMasterMkLst>
        <pc:sldLayoutChg chg="del">
          <pc:chgData name="Kassidy V Herrin" userId="78f2563c-1de5-4d7a-85bd-6e884350cb72" providerId="ADAL" clId="{A0D37651-25E5-064B-9A2C-A9D007F1356F}" dt="2024-04-11T17:41:57.867" v="1" actId="2696"/>
          <pc:sldLayoutMkLst>
            <pc:docMk/>
            <pc:sldMasterMk cId="0" sldId="2147483660"/>
            <pc:sldLayoutMk cId="3207200429" sldId="2147483649"/>
          </pc:sldLayoutMkLst>
        </pc:sldLayoutChg>
        <pc:sldLayoutChg chg="del">
          <pc:chgData name="Kassidy V Herrin" userId="78f2563c-1de5-4d7a-85bd-6e884350cb72" providerId="ADAL" clId="{A0D37651-25E5-064B-9A2C-A9D007F1356F}" dt="2024-04-11T17:41:57.871" v="2" actId="2696"/>
          <pc:sldLayoutMkLst>
            <pc:docMk/>
            <pc:sldMasterMk cId="0" sldId="2147483660"/>
            <pc:sldLayoutMk cId="1859749385" sldId="2147483650"/>
          </pc:sldLayoutMkLst>
        </pc:sldLayoutChg>
        <pc:sldLayoutChg chg="del">
          <pc:chgData name="Kassidy V Herrin" userId="78f2563c-1de5-4d7a-85bd-6e884350cb72" providerId="ADAL" clId="{A0D37651-25E5-064B-9A2C-A9D007F1356F}" dt="2024-04-11T17:41:57.872" v="3" actId="2696"/>
          <pc:sldLayoutMkLst>
            <pc:docMk/>
            <pc:sldMasterMk cId="0" sldId="2147483660"/>
            <pc:sldLayoutMk cId="4156983663" sldId="2147483651"/>
          </pc:sldLayoutMkLst>
        </pc:sldLayoutChg>
        <pc:sldLayoutChg chg="del">
          <pc:chgData name="Kassidy V Herrin" userId="78f2563c-1de5-4d7a-85bd-6e884350cb72" providerId="ADAL" clId="{A0D37651-25E5-064B-9A2C-A9D007F1356F}" dt="2024-04-11T17:41:57.874" v="4" actId="2696"/>
          <pc:sldLayoutMkLst>
            <pc:docMk/>
            <pc:sldMasterMk cId="0" sldId="2147483660"/>
            <pc:sldLayoutMk cId="2625663494" sldId="2147483652"/>
          </pc:sldLayoutMkLst>
        </pc:sldLayoutChg>
        <pc:sldLayoutChg chg="del">
          <pc:chgData name="Kassidy V Herrin" userId="78f2563c-1de5-4d7a-85bd-6e884350cb72" providerId="ADAL" clId="{A0D37651-25E5-064B-9A2C-A9D007F1356F}" dt="2024-04-11T17:41:57.876" v="5" actId="2696"/>
          <pc:sldLayoutMkLst>
            <pc:docMk/>
            <pc:sldMasterMk cId="0" sldId="2147483660"/>
            <pc:sldLayoutMk cId="3100715630" sldId="2147483653"/>
          </pc:sldLayoutMkLst>
        </pc:sldLayoutChg>
        <pc:sldLayoutChg chg="del">
          <pc:chgData name="Kassidy V Herrin" userId="78f2563c-1de5-4d7a-85bd-6e884350cb72" providerId="ADAL" clId="{A0D37651-25E5-064B-9A2C-A9D007F1356F}" dt="2024-04-11T17:41:57.877" v="6" actId="2696"/>
          <pc:sldLayoutMkLst>
            <pc:docMk/>
            <pc:sldMasterMk cId="0" sldId="2147483660"/>
            <pc:sldLayoutMk cId="4194426308" sldId="2147483654"/>
          </pc:sldLayoutMkLst>
        </pc:sldLayoutChg>
        <pc:sldLayoutChg chg="del">
          <pc:chgData name="Kassidy V Herrin" userId="78f2563c-1de5-4d7a-85bd-6e884350cb72" providerId="ADAL" clId="{A0D37651-25E5-064B-9A2C-A9D007F1356F}" dt="2024-04-11T17:41:57.879" v="7" actId="2696"/>
          <pc:sldLayoutMkLst>
            <pc:docMk/>
            <pc:sldMasterMk cId="0" sldId="2147483660"/>
            <pc:sldLayoutMk cId="828529357" sldId="2147483655"/>
          </pc:sldLayoutMkLst>
        </pc:sldLayoutChg>
        <pc:sldLayoutChg chg="del">
          <pc:chgData name="Kassidy V Herrin" userId="78f2563c-1de5-4d7a-85bd-6e884350cb72" providerId="ADAL" clId="{A0D37651-25E5-064B-9A2C-A9D007F1356F}" dt="2024-04-11T17:41:57.880" v="8" actId="2696"/>
          <pc:sldLayoutMkLst>
            <pc:docMk/>
            <pc:sldMasterMk cId="0" sldId="2147483660"/>
            <pc:sldLayoutMk cId="1520098212" sldId="2147483656"/>
          </pc:sldLayoutMkLst>
        </pc:sldLayoutChg>
        <pc:sldLayoutChg chg="del">
          <pc:chgData name="Kassidy V Herrin" userId="78f2563c-1de5-4d7a-85bd-6e884350cb72" providerId="ADAL" clId="{A0D37651-25E5-064B-9A2C-A9D007F1356F}" dt="2024-04-11T17:41:57.882" v="9" actId="2696"/>
          <pc:sldLayoutMkLst>
            <pc:docMk/>
            <pc:sldMasterMk cId="0" sldId="2147483660"/>
            <pc:sldLayoutMk cId="1955191381" sldId="2147483657"/>
          </pc:sldLayoutMkLst>
        </pc:sldLayoutChg>
        <pc:sldLayoutChg chg="del">
          <pc:chgData name="Kassidy V Herrin" userId="78f2563c-1de5-4d7a-85bd-6e884350cb72" providerId="ADAL" clId="{A0D37651-25E5-064B-9A2C-A9D007F1356F}" dt="2024-04-11T17:41:57.883" v="10" actId="2696"/>
          <pc:sldLayoutMkLst>
            <pc:docMk/>
            <pc:sldMasterMk cId="0" sldId="2147483660"/>
            <pc:sldLayoutMk cId="1425318208" sldId="2147483658"/>
          </pc:sldLayoutMkLst>
        </pc:sldLayoutChg>
        <pc:sldLayoutChg chg="del">
          <pc:chgData name="Kassidy V Herrin" userId="78f2563c-1de5-4d7a-85bd-6e884350cb72" providerId="ADAL" clId="{A0D37651-25E5-064B-9A2C-A9D007F1356F}" dt="2024-04-11T17:41:57.884" v="11" actId="2696"/>
          <pc:sldLayoutMkLst>
            <pc:docMk/>
            <pc:sldMasterMk cId="0" sldId="2147483660"/>
            <pc:sldLayoutMk cId="2806090889" sldId="2147483659"/>
          </pc:sldLayoutMkLst>
        </pc:sldLayoutChg>
      </pc:sldMasterChg>
    </pc:docChg>
  </pc:docChgLst>
  <pc:docChgLst>
    <pc:chgData name="Jada Daniels" userId="S::jdani87@lsu.edu::8970acce-57c7-4559-8174-5ce60882e72d" providerId="AD" clId="Web-{A54148CA-EA6B-BA7D-5E8C-CDB3E9B8D088}"/>
    <pc:docChg chg="modSld">
      <pc:chgData name="Jada Daniels" userId="S::jdani87@lsu.edu::8970acce-57c7-4559-8174-5ce60882e72d" providerId="AD" clId="Web-{A54148CA-EA6B-BA7D-5E8C-CDB3E9B8D088}" dt="2024-04-25T16:32:36.880" v="134" actId="1076"/>
      <pc:docMkLst>
        <pc:docMk/>
      </pc:docMkLst>
      <pc:sldChg chg="addSp delSp modSp">
        <pc:chgData name="Jada Daniels" userId="S::jdani87@lsu.edu::8970acce-57c7-4559-8174-5ce60882e72d" providerId="AD" clId="Web-{A54148CA-EA6B-BA7D-5E8C-CDB3E9B8D088}" dt="2024-04-25T16:32:36.880" v="134" actId="1076"/>
        <pc:sldMkLst>
          <pc:docMk/>
          <pc:sldMk cId="1267986695" sldId="263"/>
        </pc:sldMkLst>
        <pc:spChg chg="add mod">
          <ac:chgData name="Jada Daniels" userId="S::jdani87@lsu.edu::8970acce-57c7-4559-8174-5ce60882e72d" providerId="AD" clId="Web-{A54148CA-EA6B-BA7D-5E8C-CDB3E9B8D088}" dt="2024-04-25T16:30:38.783" v="111" actId="1076"/>
          <ac:spMkLst>
            <pc:docMk/>
            <pc:sldMk cId="1267986695" sldId="263"/>
            <ac:spMk id="6" creationId="{48C630A8-F530-223D-9BFB-3CBA8374B4DF}"/>
          </ac:spMkLst>
        </pc:spChg>
        <pc:spChg chg="mod">
          <ac:chgData name="Jada Daniels" userId="S::jdani87@lsu.edu::8970acce-57c7-4559-8174-5ce60882e72d" providerId="AD" clId="Web-{A54148CA-EA6B-BA7D-5E8C-CDB3E9B8D088}" dt="2024-04-25T16:32:36.880" v="134" actId="1076"/>
          <ac:spMkLst>
            <pc:docMk/>
            <pc:sldMk cId="1267986695" sldId="263"/>
            <ac:spMk id="7" creationId="{EE761138-33B1-0299-BC55-977C0A61093D}"/>
          </ac:spMkLst>
        </pc:spChg>
        <pc:spChg chg="add mod">
          <ac:chgData name="Jada Daniels" userId="S::jdani87@lsu.edu::8970acce-57c7-4559-8174-5ce60882e72d" providerId="AD" clId="Web-{A54148CA-EA6B-BA7D-5E8C-CDB3E9B8D088}" dt="2024-04-25T16:30:57.924" v="117" actId="1076"/>
          <ac:spMkLst>
            <pc:docMk/>
            <pc:sldMk cId="1267986695" sldId="263"/>
            <ac:spMk id="18" creationId="{12298693-8928-0338-4994-9067E573FBAD}"/>
          </ac:spMkLst>
        </pc:spChg>
        <pc:spChg chg="mod">
          <ac:chgData name="Jada Daniels" userId="S::jdani87@lsu.edu::8970acce-57c7-4559-8174-5ce60882e72d" providerId="AD" clId="Web-{A54148CA-EA6B-BA7D-5E8C-CDB3E9B8D088}" dt="2024-04-25T16:32:32.379" v="133" actId="14100"/>
          <ac:spMkLst>
            <pc:docMk/>
            <pc:sldMk cId="1267986695" sldId="263"/>
            <ac:spMk id="26" creationId="{C8AD3FA0-91D1-C89A-BD5C-192A99E78AA9}"/>
          </ac:spMkLst>
        </pc:spChg>
        <pc:spChg chg="mod">
          <ac:chgData name="Jada Daniels" userId="S::jdani87@lsu.edu::8970acce-57c7-4559-8174-5ce60882e72d" providerId="AD" clId="Web-{A54148CA-EA6B-BA7D-5E8C-CDB3E9B8D088}" dt="2024-04-25T16:32:22.489" v="131" actId="14100"/>
          <ac:spMkLst>
            <pc:docMk/>
            <pc:sldMk cId="1267986695" sldId="263"/>
            <ac:spMk id="27" creationId="{E8598A00-C0A7-013C-851B-D8D74B2D51DB}"/>
          </ac:spMkLst>
        </pc:spChg>
        <pc:spChg chg="mod">
          <ac:chgData name="Jada Daniels" userId="S::jdani87@lsu.edu::8970acce-57c7-4559-8174-5ce60882e72d" providerId="AD" clId="Web-{A54148CA-EA6B-BA7D-5E8C-CDB3E9B8D088}" dt="2024-04-25T16:25:13.431" v="9" actId="1076"/>
          <ac:spMkLst>
            <pc:docMk/>
            <pc:sldMk cId="1267986695" sldId="263"/>
            <ac:spMk id="28" creationId="{84F975A6-A238-8411-DA25-164A62D0BA44}"/>
          </ac:spMkLst>
        </pc:spChg>
        <pc:spChg chg="add mod">
          <ac:chgData name="Jada Daniels" userId="S::jdani87@lsu.edu::8970acce-57c7-4559-8174-5ce60882e72d" providerId="AD" clId="Web-{A54148CA-EA6B-BA7D-5E8C-CDB3E9B8D088}" dt="2024-04-25T16:32:00.957" v="129" actId="1076"/>
          <ac:spMkLst>
            <pc:docMk/>
            <pc:sldMk cId="1267986695" sldId="263"/>
            <ac:spMk id="29" creationId="{F79C0B08-929E-0C8F-A26D-D1900DFDD2FC}"/>
          </ac:spMkLst>
        </pc:spChg>
        <pc:spChg chg="add mod">
          <ac:chgData name="Jada Daniels" userId="S::jdani87@lsu.edu::8970acce-57c7-4559-8174-5ce60882e72d" providerId="AD" clId="Web-{A54148CA-EA6B-BA7D-5E8C-CDB3E9B8D088}" dt="2024-04-25T16:30:41.252" v="112" actId="1076"/>
          <ac:spMkLst>
            <pc:docMk/>
            <pc:sldMk cId="1267986695" sldId="263"/>
            <ac:spMk id="30" creationId="{40B0296A-E37F-E54D-2BBD-5F2CE3010F1A}"/>
          </ac:spMkLst>
        </pc:spChg>
        <pc:spChg chg="mod">
          <ac:chgData name="Jada Daniels" userId="S::jdani87@lsu.edu::8970acce-57c7-4559-8174-5ce60882e72d" providerId="AD" clId="Web-{A54148CA-EA6B-BA7D-5E8C-CDB3E9B8D088}" dt="2024-04-25T16:30:27.408" v="109" actId="14100"/>
          <ac:spMkLst>
            <pc:docMk/>
            <pc:sldMk cId="1267986695" sldId="263"/>
            <ac:spMk id="34" creationId="{AF943511-BF14-7164-A804-4EE36C99301B}"/>
          </ac:spMkLst>
        </pc:spChg>
        <pc:spChg chg="add mod ord">
          <ac:chgData name="Jada Daniels" userId="S::jdani87@lsu.edu::8970acce-57c7-4559-8174-5ce60882e72d" providerId="AD" clId="Web-{A54148CA-EA6B-BA7D-5E8C-CDB3E9B8D088}" dt="2024-04-25T16:31:50.972" v="128"/>
          <ac:spMkLst>
            <pc:docMk/>
            <pc:sldMk cId="1267986695" sldId="263"/>
            <ac:spMk id="40" creationId="{4BCFE62E-0780-A2EC-1733-A422197FCCCE}"/>
          </ac:spMkLst>
        </pc:spChg>
        <pc:graphicFrameChg chg="mod modGraphic">
          <ac:chgData name="Jada Daniels" userId="S::jdani87@lsu.edu::8970acce-57c7-4559-8174-5ce60882e72d" providerId="AD" clId="Web-{A54148CA-EA6B-BA7D-5E8C-CDB3E9B8D088}" dt="2024-04-25T16:25:57.526" v="31"/>
          <ac:graphicFrameMkLst>
            <pc:docMk/>
            <pc:sldMk cId="1267986695" sldId="263"/>
            <ac:graphicFrameMk id="11" creationId="{65AEACB9-B21E-7C82-A5B3-68920EEDC493}"/>
          </ac:graphicFrameMkLst>
        </pc:graphicFrameChg>
        <pc:cxnChg chg="add del mod">
          <ac:chgData name="Jada Daniels" userId="S::jdani87@lsu.edu::8970acce-57c7-4559-8174-5ce60882e72d" providerId="AD" clId="Web-{A54148CA-EA6B-BA7D-5E8C-CDB3E9B8D088}" dt="2024-04-25T16:29:22.844" v="93"/>
          <ac:cxnSpMkLst>
            <pc:docMk/>
            <pc:sldMk cId="1267986695" sldId="263"/>
            <ac:cxnSpMk id="38" creationId="{C72B1626-5479-34E3-3E1B-3E76BDE0D35D}"/>
          </ac:cxnSpMkLst>
        </pc:cxnChg>
        <pc:cxnChg chg="add mod">
          <ac:chgData name="Jada Daniels" userId="S::jdani87@lsu.edu::8970acce-57c7-4559-8174-5ce60882e72d" providerId="AD" clId="Web-{A54148CA-EA6B-BA7D-5E8C-CDB3E9B8D088}" dt="2024-04-25T16:31:02.830" v="118" actId="1076"/>
          <ac:cxnSpMkLst>
            <pc:docMk/>
            <pc:sldMk cId="1267986695" sldId="263"/>
            <ac:cxnSpMk id="39" creationId="{4754EDF7-2CB3-F2D2-DD76-D4E1907F29D7}"/>
          </ac:cxnSpMkLst>
        </pc:cxnChg>
      </pc:sldChg>
    </pc:docChg>
  </pc:docChgLst>
  <pc:docChgLst>
    <pc:chgData name="Kassidy V Herrin" userId="S::kherr17@lsu.edu::78f2563c-1de5-4d7a-85bd-6e884350cb72" providerId="AD" clId="Web-{DA5006F1-0433-99EB-27FB-19D942191393}"/>
    <pc:docChg chg="modSld">
      <pc:chgData name="Kassidy V Herrin" userId="S::kherr17@lsu.edu::78f2563c-1de5-4d7a-85bd-6e884350cb72" providerId="AD" clId="Web-{DA5006F1-0433-99EB-27FB-19D942191393}" dt="2024-04-12T03:56:51.330" v="58" actId="14100"/>
      <pc:docMkLst>
        <pc:docMk/>
      </pc:docMkLst>
      <pc:sldChg chg="addSp delSp modSp">
        <pc:chgData name="Kassidy V Herrin" userId="S::kherr17@lsu.edu::78f2563c-1de5-4d7a-85bd-6e884350cb72" providerId="AD" clId="Web-{DA5006F1-0433-99EB-27FB-19D942191393}" dt="2024-04-12T03:56:51.330" v="58" actId="14100"/>
        <pc:sldMkLst>
          <pc:docMk/>
          <pc:sldMk cId="1267986695" sldId="263"/>
        </pc:sldMkLst>
        <pc:spChg chg="mod">
          <ac:chgData name="Kassidy V Herrin" userId="S::kherr17@lsu.edu::78f2563c-1de5-4d7a-85bd-6e884350cb72" providerId="AD" clId="Web-{DA5006F1-0433-99EB-27FB-19D942191393}" dt="2024-04-12T03:55:17.470" v="44" actId="1076"/>
          <ac:spMkLst>
            <pc:docMk/>
            <pc:sldMk cId="1267986695" sldId="263"/>
            <ac:spMk id="3" creationId="{57203A09-E0E1-3B0B-8F2F-EDFB121ED264}"/>
          </ac:spMkLst>
        </pc:spChg>
        <pc:spChg chg="add del">
          <ac:chgData name="Kassidy V Herrin" userId="S::kherr17@lsu.edu::78f2563c-1de5-4d7a-85bd-6e884350cb72" providerId="AD" clId="Web-{DA5006F1-0433-99EB-27FB-19D942191393}" dt="2024-04-11T17:48:23.063" v="1"/>
          <ac:spMkLst>
            <pc:docMk/>
            <pc:sldMk cId="1267986695" sldId="263"/>
            <ac:spMk id="3" creationId="{81CB6B3C-4E76-E223-257A-A8636042ACBD}"/>
          </ac:spMkLst>
        </pc:spChg>
        <pc:spChg chg="mod">
          <ac:chgData name="Kassidy V Herrin" userId="S::kherr17@lsu.edu::78f2563c-1de5-4d7a-85bd-6e884350cb72" providerId="AD" clId="Web-{DA5006F1-0433-99EB-27FB-19D942191393}" dt="2024-04-12T03:54:56.673" v="39" actId="1076"/>
          <ac:spMkLst>
            <pc:docMk/>
            <pc:sldMk cId="1267986695" sldId="263"/>
            <ac:spMk id="15" creationId="{00000000-0000-0000-0000-000000000000}"/>
          </ac:spMkLst>
        </pc:spChg>
        <pc:spChg chg="mod">
          <ac:chgData name="Kassidy V Herrin" userId="S::kherr17@lsu.edu::78f2563c-1de5-4d7a-85bd-6e884350cb72" providerId="AD" clId="Web-{DA5006F1-0433-99EB-27FB-19D942191393}" dt="2024-04-12T03:53:32.063" v="21" actId="1076"/>
          <ac:spMkLst>
            <pc:docMk/>
            <pc:sldMk cId="1267986695" sldId="263"/>
            <ac:spMk id="16" creationId="{00000000-0000-0000-0000-000000000000}"/>
          </ac:spMkLst>
        </pc:spChg>
        <pc:spChg chg="mod">
          <ac:chgData name="Kassidy V Herrin" userId="S::kherr17@lsu.edu::78f2563c-1de5-4d7a-85bd-6e884350cb72" providerId="AD" clId="Web-{DA5006F1-0433-99EB-27FB-19D942191393}" dt="2024-04-12T03:56:05.361" v="55" actId="14100"/>
          <ac:spMkLst>
            <pc:docMk/>
            <pc:sldMk cId="1267986695" sldId="263"/>
            <ac:spMk id="19" creationId="{00000000-0000-0000-0000-000000000000}"/>
          </ac:spMkLst>
        </pc:spChg>
        <pc:spChg chg="mod">
          <ac:chgData name="Kassidy V Herrin" userId="S::kherr17@lsu.edu::78f2563c-1de5-4d7a-85bd-6e884350cb72" providerId="AD" clId="Web-{DA5006F1-0433-99EB-27FB-19D942191393}" dt="2024-04-12T03:55:14.048" v="43" actId="1076"/>
          <ac:spMkLst>
            <pc:docMk/>
            <pc:sldMk cId="1267986695" sldId="263"/>
            <ac:spMk id="20" creationId="{00000000-0000-0000-0000-000000000000}"/>
          </ac:spMkLst>
        </pc:spChg>
        <pc:spChg chg="mod">
          <ac:chgData name="Kassidy V Herrin" userId="S::kherr17@lsu.edu::78f2563c-1de5-4d7a-85bd-6e884350cb72" providerId="AD" clId="Web-{DA5006F1-0433-99EB-27FB-19D942191393}" dt="2024-04-12T03:55:51.923" v="52" actId="14100"/>
          <ac:spMkLst>
            <pc:docMk/>
            <pc:sldMk cId="1267986695" sldId="263"/>
            <ac:spMk id="22" creationId="{00000000-0000-0000-0000-000000000000}"/>
          </ac:spMkLst>
        </pc:spChg>
        <pc:spChg chg="mod">
          <ac:chgData name="Kassidy V Herrin" userId="S::kherr17@lsu.edu::78f2563c-1de5-4d7a-85bd-6e884350cb72" providerId="AD" clId="Web-{DA5006F1-0433-99EB-27FB-19D942191393}" dt="2024-04-12T03:56:46.471" v="57" actId="1076"/>
          <ac:spMkLst>
            <pc:docMk/>
            <pc:sldMk cId="1267986695" sldId="263"/>
            <ac:spMk id="23" creationId="{00000000-0000-0000-0000-000000000000}"/>
          </ac:spMkLst>
        </pc:spChg>
        <pc:spChg chg="mod">
          <ac:chgData name="Kassidy V Herrin" userId="S::kherr17@lsu.edu::78f2563c-1de5-4d7a-85bd-6e884350cb72" providerId="AD" clId="Web-{DA5006F1-0433-99EB-27FB-19D942191393}" dt="2024-04-12T03:55:00.876" v="40" actId="14100"/>
          <ac:spMkLst>
            <pc:docMk/>
            <pc:sldMk cId="1267986695" sldId="263"/>
            <ac:spMk id="14339" creationId="{00000000-0000-0000-0000-000000000000}"/>
          </ac:spMkLst>
        </pc:spChg>
        <pc:spChg chg="mod">
          <ac:chgData name="Kassidy V Herrin" userId="S::kherr17@lsu.edu::78f2563c-1de5-4d7a-85bd-6e884350cb72" providerId="AD" clId="Web-{DA5006F1-0433-99EB-27FB-19D942191393}" dt="2024-04-12T03:54:56.657" v="38" actId="1076"/>
          <ac:spMkLst>
            <pc:docMk/>
            <pc:sldMk cId="1267986695" sldId="263"/>
            <ac:spMk id="14340" creationId="{00000000-0000-0000-0000-000000000000}"/>
          </ac:spMkLst>
        </pc:spChg>
        <pc:spChg chg="mod">
          <ac:chgData name="Kassidy V Herrin" userId="S::kherr17@lsu.edu::78f2563c-1de5-4d7a-85bd-6e884350cb72" providerId="AD" clId="Web-{DA5006F1-0433-99EB-27FB-19D942191393}" dt="2024-04-12T03:55:10.251" v="42" actId="1076"/>
          <ac:spMkLst>
            <pc:docMk/>
            <pc:sldMk cId="1267986695" sldId="263"/>
            <ac:spMk id="14341" creationId="{00000000-0000-0000-0000-000000000000}"/>
          </ac:spMkLst>
        </pc:spChg>
        <pc:spChg chg="mod">
          <ac:chgData name="Kassidy V Herrin" userId="S::kherr17@lsu.edu::78f2563c-1de5-4d7a-85bd-6e884350cb72" providerId="AD" clId="Web-{DA5006F1-0433-99EB-27FB-19D942191393}" dt="2024-04-12T03:54:08.610" v="28" actId="1076"/>
          <ac:spMkLst>
            <pc:docMk/>
            <pc:sldMk cId="1267986695" sldId="263"/>
            <ac:spMk id="14342" creationId="{00000000-0000-0000-0000-000000000000}"/>
          </ac:spMkLst>
        </pc:spChg>
        <pc:spChg chg="mod">
          <ac:chgData name="Kassidy V Herrin" userId="S::kherr17@lsu.edu::78f2563c-1de5-4d7a-85bd-6e884350cb72" providerId="AD" clId="Web-{DA5006F1-0433-99EB-27FB-19D942191393}" dt="2024-04-12T03:56:51.330" v="58" actId="14100"/>
          <ac:spMkLst>
            <pc:docMk/>
            <pc:sldMk cId="1267986695" sldId="263"/>
            <ac:spMk id="14343" creationId="{00000000-0000-0000-0000-000000000000}"/>
          </ac:spMkLst>
        </pc:spChg>
        <pc:picChg chg="mod">
          <ac:chgData name="Kassidy V Herrin" userId="S::kherr17@lsu.edu::78f2563c-1de5-4d7a-85bd-6e884350cb72" providerId="AD" clId="Web-{DA5006F1-0433-99EB-27FB-19D942191393}" dt="2024-04-11T17:48:44.579" v="3" actId="1076"/>
          <ac:picMkLst>
            <pc:docMk/>
            <pc:sldMk cId="1267986695" sldId="263"/>
            <ac:picMk id="13" creationId="{0D970357-180A-4FD6-82C1-FA8CE267D04C}"/>
          </ac:picMkLst>
        </pc:picChg>
        <pc:picChg chg="mod">
          <ac:chgData name="Kassidy V Herrin" userId="S::kherr17@lsu.edu::78f2563c-1de5-4d7a-85bd-6e884350cb72" providerId="AD" clId="Web-{DA5006F1-0433-99EB-27FB-19D942191393}" dt="2024-04-11T17:48:43.626" v="2" actId="1076"/>
          <ac:picMkLst>
            <pc:docMk/>
            <pc:sldMk cId="1267986695" sldId="263"/>
            <ac:picMk id="21" creationId="{00000000-0000-0000-0000-000000000000}"/>
          </ac:picMkLst>
        </pc:picChg>
      </pc:sldChg>
    </pc:docChg>
  </pc:docChgLst>
  <pc:docChgLst>
    <pc:chgData name="Charlotte E Robinson" userId="S::crob261@lsu.edu::b04a81f5-e1b9-4faa-b263-388a49954364" providerId="AD" clId="Web-{64854D80-F1FC-C981-60B1-E09AD8605E32}"/>
    <pc:docChg chg="modSld">
      <pc:chgData name="Charlotte E Robinson" userId="S::crob261@lsu.edu::b04a81f5-e1b9-4faa-b263-388a49954364" providerId="AD" clId="Web-{64854D80-F1FC-C981-60B1-E09AD8605E32}" dt="2024-04-24T18:52:36.433" v="109" actId="1076"/>
      <pc:docMkLst>
        <pc:docMk/>
      </pc:docMkLst>
      <pc:sldChg chg="addSp delSp modSp">
        <pc:chgData name="Charlotte E Robinson" userId="S::crob261@lsu.edu::b04a81f5-e1b9-4faa-b263-388a49954364" providerId="AD" clId="Web-{64854D80-F1FC-C981-60B1-E09AD8605E32}" dt="2024-04-24T18:52:36.433" v="109" actId="1076"/>
        <pc:sldMkLst>
          <pc:docMk/>
          <pc:sldMk cId="1267986695" sldId="263"/>
        </pc:sldMkLst>
        <pc:spChg chg="mod">
          <ac:chgData name="Charlotte E Robinson" userId="S::crob261@lsu.edu::b04a81f5-e1b9-4faa-b263-388a49954364" providerId="AD" clId="Web-{64854D80-F1FC-C981-60B1-E09AD8605E32}" dt="2024-04-24T18:41:40.340" v="11" actId="1076"/>
          <ac:spMkLst>
            <pc:docMk/>
            <pc:sldMk cId="1267986695" sldId="263"/>
            <ac:spMk id="2" creationId="{C391A11A-2981-C111-5347-6F129B8F65AF}"/>
          </ac:spMkLst>
        </pc:spChg>
        <pc:spChg chg="mod">
          <ac:chgData name="Charlotte E Robinson" userId="S::crob261@lsu.edu::b04a81f5-e1b9-4faa-b263-388a49954364" providerId="AD" clId="Web-{64854D80-F1FC-C981-60B1-E09AD8605E32}" dt="2024-04-24T18:41:45.168" v="13" actId="1076"/>
          <ac:spMkLst>
            <pc:docMk/>
            <pc:sldMk cId="1267986695" sldId="263"/>
            <ac:spMk id="3" creationId="{57203A09-E0E1-3B0B-8F2F-EDFB121ED264}"/>
          </ac:spMkLst>
        </pc:spChg>
        <pc:spChg chg="add del">
          <ac:chgData name="Charlotte E Robinson" userId="S::crob261@lsu.edu::b04a81f5-e1b9-4faa-b263-388a49954364" providerId="AD" clId="Web-{64854D80-F1FC-C981-60B1-E09AD8605E32}" dt="2024-04-24T18:41:10.542" v="7"/>
          <ac:spMkLst>
            <pc:docMk/>
            <pc:sldMk cId="1267986695" sldId="263"/>
            <ac:spMk id="6" creationId="{568C7BDB-8A8E-1AD7-A469-554FC4E4EB2A}"/>
          </ac:spMkLst>
        </pc:spChg>
        <pc:spChg chg="add mod">
          <ac:chgData name="Charlotte E Robinson" userId="S::crob261@lsu.edu::b04a81f5-e1b9-4faa-b263-388a49954364" providerId="AD" clId="Web-{64854D80-F1FC-C981-60B1-E09AD8605E32}" dt="2024-04-24T18:48:03.974" v="95" actId="20577"/>
          <ac:spMkLst>
            <pc:docMk/>
            <pc:sldMk cId="1267986695" sldId="263"/>
            <ac:spMk id="7" creationId="{EE761138-33B1-0299-BC55-977C0A61093D}"/>
          </ac:spMkLst>
        </pc:spChg>
        <pc:spChg chg="mod">
          <ac:chgData name="Charlotte E Robinson" userId="S::crob261@lsu.edu::b04a81f5-e1b9-4faa-b263-388a49954364" providerId="AD" clId="Web-{64854D80-F1FC-C981-60B1-E09AD8605E32}" dt="2024-04-24T18:41:40.543" v="12" actId="14100"/>
          <ac:spMkLst>
            <pc:docMk/>
            <pc:sldMk cId="1267986695" sldId="263"/>
            <ac:spMk id="16" creationId="{00000000-0000-0000-0000-000000000000}"/>
          </ac:spMkLst>
        </pc:spChg>
        <pc:spChg chg="mod">
          <ac:chgData name="Charlotte E Robinson" userId="S::crob261@lsu.edu::b04a81f5-e1b9-4faa-b263-388a49954364" providerId="AD" clId="Web-{64854D80-F1FC-C981-60B1-E09AD8605E32}" dt="2024-04-24T18:52:36.433" v="109" actId="1076"/>
          <ac:spMkLst>
            <pc:docMk/>
            <pc:sldMk cId="1267986695" sldId="263"/>
            <ac:spMk id="24" creationId="{98E8D37B-B528-A794-086D-319C56A08178}"/>
          </ac:spMkLst>
        </pc:spChg>
        <pc:spChg chg="mod">
          <ac:chgData name="Charlotte E Robinson" userId="S::crob261@lsu.edu::b04a81f5-e1b9-4faa-b263-388a49954364" providerId="AD" clId="Web-{64854D80-F1FC-C981-60B1-E09AD8605E32}" dt="2024-04-24T18:52:35.918" v="107" actId="14100"/>
          <ac:spMkLst>
            <pc:docMk/>
            <pc:sldMk cId="1267986695" sldId="263"/>
            <ac:spMk id="26" creationId="{C8AD3FA0-91D1-C89A-BD5C-192A99E78AA9}"/>
          </ac:spMkLst>
        </pc:spChg>
        <pc:spChg chg="mod">
          <ac:chgData name="Charlotte E Robinson" userId="S::crob261@lsu.edu::b04a81f5-e1b9-4faa-b263-388a49954364" providerId="AD" clId="Web-{64854D80-F1FC-C981-60B1-E09AD8605E32}" dt="2024-04-24T18:51:26.510" v="97" actId="20577"/>
          <ac:spMkLst>
            <pc:docMk/>
            <pc:sldMk cId="1267986695" sldId="263"/>
            <ac:spMk id="27" creationId="{E8598A00-C0A7-013C-851B-D8D74B2D51DB}"/>
          </ac:spMkLst>
        </pc:spChg>
        <pc:spChg chg="mod">
          <ac:chgData name="Charlotte E Robinson" userId="S::crob261@lsu.edu::b04a81f5-e1b9-4faa-b263-388a49954364" providerId="AD" clId="Web-{64854D80-F1FC-C981-60B1-E09AD8605E32}" dt="2024-04-24T18:51:57.120" v="102" actId="1076"/>
          <ac:spMkLst>
            <pc:docMk/>
            <pc:sldMk cId="1267986695" sldId="263"/>
            <ac:spMk id="28" creationId="{84F975A6-A238-8411-DA25-164A62D0BA44}"/>
          </ac:spMkLst>
        </pc:spChg>
        <pc:spChg chg="mod">
          <ac:chgData name="Charlotte E Robinson" userId="S::crob261@lsu.edu::b04a81f5-e1b9-4faa-b263-388a49954364" providerId="AD" clId="Web-{64854D80-F1FC-C981-60B1-E09AD8605E32}" dt="2024-04-24T18:41:20.683" v="9" actId="1076"/>
          <ac:spMkLst>
            <pc:docMk/>
            <pc:sldMk cId="1267986695" sldId="263"/>
            <ac:spMk id="14342" creationId="{00000000-0000-0000-0000-000000000000}"/>
          </ac:spMkLst>
        </pc:spChg>
        <pc:graphicFrameChg chg="mod">
          <ac:chgData name="Charlotte E Robinson" userId="S::crob261@lsu.edu::b04a81f5-e1b9-4faa-b263-388a49954364" providerId="AD" clId="Web-{64854D80-F1FC-C981-60B1-E09AD8605E32}" dt="2024-04-24T18:51:56.917" v="101" actId="1076"/>
          <ac:graphicFrameMkLst>
            <pc:docMk/>
            <pc:sldMk cId="1267986695" sldId="263"/>
            <ac:graphicFrameMk id="11" creationId="{65AEACB9-B21E-7C82-A5B3-68920EEDC493}"/>
          </ac:graphicFrameMkLst>
        </pc:graphicFrameChg>
        <pc:picChg chg="mod">
          <ac:chgData name="Charlotte E Robinson" userId="S::crob261@lsu.edu::b04a81f5-e1b9-4faa-b263-388a49954364" providerId="AD" clId="Web-{64854D80-F1FC-C981-60B1-E09AD8605E32}" dt="2024-04-24T18:51:57.323" v="103" actId="1076"/>
          <ac:picMkLst>
            <pc:docMk/>
            <pc:sldMk cId="1267986695" sldId="263"/>
            <ac:picMk id="8" creationId="{5B0D1962-0B43-CF5F-45F3-9A9D490074A5}"/>
          </ac:picMkLst>
        </pc:picChg>
        <pc:picChg chg="mod">
          <ac:chgData name="Charlotte E Robinson" userId="S::crob261@lsu.edu::b04a81f5-e1b9-4faa-b263-388a49954364" providerId="AD" clId="Web-{64854D80-F1FC-C981-60B1-E09AD8605E32}" dt="2024-04-24T18:52:35.496" v="105" actId="14100"/>
          <ac:picMkLst>
            <pc:docMk/>
            <pc:sldMk cId="1267986695" sldId="263"/>
            <ac:picMk id="10" creationId="{6BF1A5FE-F89A-88D7-93B9-E97A105CC5A6}"/>
          </ac:picMkLst>
        </pc:picChg>
      </pc:sldChg>
    </pc:docChg>
  </pc:docChgLst>
  <pc:docChgLst>
    <pc:chgData name="Zainalabedeen N Al Naseri" userId="S::zalnas2@lsu.edu::9807e083-1870-42e3-b813-d3919d9d723c" providerId="AD" clId="Web-{B8E5C5D3-6B91-541D-2A1F-27C65562E6F8}"/>
    <pc:docChg chg="modSld">
      <pc:chgData name="Zainalabedeen N Al Naseri" userId="S::zalnas2@lsu.edu::9807e083-1870-42e3-b813-d3919d9d723c" providerId="AD" clId="Web-{B8E5C5D3-6B91-541D-2A1F-27C65562E6F8}" dt="2024-04-24T17:41:31.337" v="56" actId="14100"/>
      <pc:docMkLst>
        <pc:docMk/>
      </pc:docMkLst>
      <pc:sldChg chg="modSp">
        <pc:chgData name="Zainalabedeen N Al Naseri" userId="S::zalnas2@lsu.edu::9807e083-1870-42e3-b813-d3919d9d723c" providerId="AD" clId="Web-{B8E5C5D3-6B91-541D-2A1F-27C65562E6F8}" dt="2024-04-24T17:41:31.337" v="56" actId="14100"/>
        <pc:sldMkLst>
          <pc:docMk/>
          <pc:sldMk cId="1267986695" sldId="263"/>
        </pc:sldMkLst>
        <pc:spChg chg="mod">
          <ac:chgData name="Zainalabedeen N Al Naseri" userId="S::zalnas2@lsu.edu::9807e083-1870-42e3-b813-d3919d9d723c" providerId="AD" clId="Web-{B8E5C5D3-6B91-541D-2A1F-27C65562E6F8}" dt="2024-04-24T17:41:10.336" v="54" actId="20577"/>
          <ac:spMkLst>
            <pc:docMk/>
            <pc:sldMk cId="1267986695" sldId="263"/>
            <ac:spMk id="26" creationId="{C8AD3FA0-91D1-C89A-BD5C-192A99E78AA9}"/>
          </ac:spMkLst>
        </pc:spChg>
        <pc:spChg chg="mod">
          <ac:chgData name="Zainalabedeen N Al Naseri" userId="S::zalnas2@lsu.edu::9807e083-1870-42e3-b813-d3919d9d723c" providerId="AD" clId="Web-{B8E5C5D3-6B91-541D-2A1F-27C65562E6F8}" dt="2024-04-24T17:41:31.337" v="56" actId="14100"/>
          <ac:spMkLst>
            <pc:docMk/>
            <pc:sldMk cId="1267986695" sldId="263"/>
            <ac:spMk id="14342" creationId="{00000000-0000-0000-0000-000000000000}"/>
          </ac:spMkLst>
        </pc:spChg>
      </pc:sldChg>
    </pc:docChg>
  </pc:docChgLst>
  <pc:docChgLst>
    <pc:chgData name="Charlotte E Robinson" userId="S::crob261@lsu.edu::b04a81f5-e1b9-4faa-b263-388a49954364" providerId="AD" clId="Web-{F7F77F56-9516-2D52-603C-93039051D928}"/>
    <pc:docChg chg="modSld">
      <pc:chgData name="Charlotte E Robinson" userId="S::crob261@lsu.edu::b04a81f5-e1b9-4faa-b263-388a49954364" providerId="AD" clId="Web-{F7F77F56-9516-2D52-603C-93039051D928}" dt="2024-04-16T03:15:52.585" v="25" actId="20577"/>
      <pc:docMkLst>
        <pc:docMk/>
      </pc:docMkLst>
      <pc:sldChg chg="modSp">
        <pc:chgData name="Charlotte E Robinson" userId="S::crob261@lsu.edu::b04a81f5-e1b9-4faa-b263-388a49954364" providerId="AD" clId="Web-{F7F77F56-9516-2D52-603C-93039051D928}" dt="2024-04-16T03:13:20.008" v="1"/>
        <pc:sldMkLst>
          <pc:docMk/>
          <pc:sldMk cId="1267986695" sldId="263"/>
        </pc:sldMkLst>
        <pc:spChg chg="mod">
          <ac:chgData name="Charlotte E Robinson" userId="S::crob261@lsu.edu::b04a81f5-e1b9-4faa-b263-388a49954364" providerId="AD" clId="Web-{F7F77F56-9516-2D52-603C-93039051D928}" dt="2024-04-16T03:13:20.008" v="1"/>
          <ac:spMkLst>
            <pc:docMk/>
            <pc:sldMk cId="1267986695" sldId="263"/>
            <ac:spMk id="17" creationId="{00000000-0000-0000-0000-000000000000}"/>
          </ac:spMkLst>
        </pc:spChg>
      </pc:sldChg>
      <pc:sldChg chg="addSp modSp">
        <pc:chgData name="Charlotte E Robinson" userId="S::crob261@lsu.edu::b04a81f5-e1b9-4faa-b263-388a49954364" providerId="AD" clId="Web-{F7F77F56-9516-2D52-603C-93039051D928}" dt="2024-04-16T03:15:44.741" v="24" actId="20577"/>
        <pc:sldMkLst>
          <pc:docMk/>
          <pc:sldMk cId="1964245774" sldId="270"/>
        </pc:sldMkLst>
        <pc:spChg chg="add mod">
          <ac:chgData name="Charlotte E Robinson" userId="S::crob261@lsu.edu::b04a81f5-e1b9-4faa-b263-388a49954364" providerId="AD" clId="Web-{F7F77F56-9516-2D52-603C-93039051D928}" dt="2024-04-16T03:15:44.741" v="24" actId="20577"/>
          <ac:spMkLst>
            <pc:docMk/>
            <pc:sldMk cId="1964245774" sldId="270"/>
            <ac:spMk id="3" creationId="{179B9036-029E-2A35-84D0-B56D0CC37303}"/>
          </ac:spMkLst>
        </pc:spChg>
        <pc:spChg chg="add mod">
          <ac:chgData name="Charlotte E Robinson" userId="S::crob261@lsu.edu::b04a81f5-e1b9-4faa-b263-388a49954364" providerId="AD" clId="Web-{F7F77F56-9516-2D52-603C-93039051D928}" dt="2024-04-16T03:14:15.601" v="11" actId="20577"/>
          <ac:spMkLst>
            <pc:docMk/>
            <pc:sldMk cId="1964245774" sldId="270"/>
            <ac:spMk id="5" creationId="{89158900-5EF3-1E27-9692-1CE85BB177AE}"/>
          </ac:spMkLst>
        </pc:spChg>
      </pc:sldChg>
      <pc:sldChg chg="addSp modSp">
        <pc:chgData name="Charlotte E Robinson" userId="S::crob261@lsu.edu::b04a81f5-e1b9-4faa-b263-388a49954364" providerId="AD" clId="Web-{F7F77F56-9516-2D52-603C-93039051D928}" dt="2024-04-16T03:15:52.585" v="25" actId="20577"/>
        <pc:sldMkLst>
          <pc:docMk/>
          <pc:sldMk cId="402720778" sldId="271"/>
        </pc:sldMkLst>
        <pc:spChg chg="add mod">
          <ac:chgData name="Charlotte E Robinson" userId="S::crob261@lsu.edu::b04a81f5-e1b9-4faa-b263-388a49954364" providerId="AD" clId="Web-{F7F77F56-9516-2D52-603C-93039051D928}" dt="2024-04-16T03:15:33.960" v="23" actId="20577"/>
          <ac:spMkLst>
            <pc:docMk/>
            <pc:sldMk cId="402720778" sldId="271"/>
            <ac:spMk id="3" creationId="{2077B458-AD68-5897-CED8-AD0F31F6F46D}"/>
          </ac:spMkLst>
        </pc:spChg>
        <pc:spChg chg="add mod">
          <ac:chgData name="Charlotte E Robinson" userId="S::crob261@lsu.edu::b04a81f5-e1b9-4faa-b263-388a49954364" providerId="AD" clId="Web-{F7F77F56-9516-2D52-603C-93039051D928}" dt="2024-04-16T03:15:52.585" v="25" actId="20577"/>
          <ac:spMkLst>
            <pc:docMk/>
            <pc:sldMk cId="402720778" sldId="271"/>
            <ac:spMk id="5" creationId="{38583EFD-9386-D037-4718-750BE378D7AD}"/>
          </ac:spMkLst>
        </pc:spChg>
      </pc:sldChg>
    </pc:docChg>
  </pc:docChgLst>
  <pc:docChgLst>
    <pc:chgData name="Zainalabedeen N Al Naseri" userId="S::zalnas2@lsu.edu::9807e083-1870-42e3-b813-d3919d9d723c" providerId="AD" clId="Web-{8C72B47E-F14E-A83C-6E39-7F651208D4D6}"/>
    <pc:docChg chg="modSld">
      <pc:chgData name="Zainalabedeen N Al Naseri" userId="S::zalnas2@lsu.edu::9807e083-1870-42e3-b813-d3919d9d723c" providerId="AD" clId="Web-{8C72B47E-F14E-A83C-6E39-7F651208D4D6}" dt="2024-04-11T17:47:53.125" v="2" actId="20577"/>
      <pc:docMkLst>
        <pc:docMk/>
      </pc:docMkLst>
      <pc:sldChg chg="modSp">
        <pc:chgData name="Zainalabedeen N Al Naseri" userId="S::zalnas2@lsu.edu::9807e083-1870-42e3-b813-d3919d9d723c" providerId="AD" clId="Web-{8C72B47E-F14E-A83C-6E39-7F651208D4D6}" dt="2024-04-11T17:47:53.125" v="2" actId="20577"/>
        <pc:sldMkLst>
          <pc:docMk/>
          <pc:sldMk cId="1267986695" sldId="263"/>
        </pc:sldMkLst>
        <pc:spChg chg="mod">
          <ac:chgData name="Zainalabedeen N Al Naseri" userId="S::zalnas2@lsu.edu::9807e083-1870-42e3-b813-d3919d9d723c" providerId="AD" clId="Web-{8C72B47E-F14E-A83C-6E39-7F651208D4D6}" dt="2024-04-11T17:47:53.125" v="2" actId="20577"/>
          <ac:spMkLst>
            <pc:docMk/>
            <pc:sldMk cId="1267986695" sldId="263"/>
            <ac:spMk id="14342" creationId="{00000000-0000-0000-0000-000000000000}"/>
          </ac:spMkLst>
        </pc:spChg>
      </pc:sldChg>
    </pc:docChg>
  </pc:docChgLst>
  <pc:docChgLst>
    <pc:chgData name="Charlotte E Robinson" userId="S::crob261@lsu.edu::b04a81f5-e1b9-4faa-b263-388a49954364" providerId="AD" clId="Web-{F69E66EE-B8B9-38E3-9E1C-1F8F13CDDCB9}"/>
    <pc:docChg chg="modSld">
      <pc:chgData name="Charlotte E Robinson" userId="S::crob261@lsu.edu::b04a81f5-e1b9-4faa-b263-388a49954364" providerId="AD" clId="Web-{F69E66EE-B8B9-38E3-9E1C-1F8F13CDDCB9}" dt="2024-04-15T02:36:38.449" v="1163" actId="20577"/>
      <pc:docMkLst>
        <pc:docMk/>
      </pc:docMkLst>
      <pc:sldChg chg="modSp">
        <pc:chgData name="Charlotte E Robinson" userId="S::crob261@lsu.edu::b04a81f5-e1b9-4faa-b263-388a49954364" providerId="AD" clId="Web-{F69E66EE-B8B9-38E3-9E1C-1F8F13CDDCB9}" dt="2024-04-15T02:36:38.449" v="1163" actId="20577"/>
        <pc:sldMkLst>
          <pc:docMk/>
          <pc:sldMk cId="1267986695" sldId="263"/>
        </pc:sldMkLst>
        <pc:spChg chg="mod">
          <ac:chgData name="Charlotte E Robinson" userId="S::crob261@lsu.edu::b04a81f5-e1b9-4faa-b263-388a49954364" providerId="AD" clId="Web-{F69E66EE-B8B9-38E3-9E1C-1F8F13CDDCB9}" dt="2024-04-15T02:13:46.931" v="662" actId="20577"/>
          <ac:spMkLst>
            <pc:docMk/>
            <pc:sldMk cId="1267986695" sldId="263"/>
            <ac:spMk id="19" creationId="{00000000-0000-0000-0000-000000000000}"/>
          </ac:spMkLst>
        </pc:spChg>
        <pc:spChg chg="mod">
          <ac:chgData name="Charlotte E Robinson" userId="S::crob261@lsu.edu::b04a81f5-e1b9-4faa-b263-388a49954364" providerId="AD" clId="Web-{F69E66EE-B8B9-38E3-9E1C-1F8F13CDDCB9}" dt="2024-04-15T02:16:21.655" v="768" actId="14100"/>
          <ac:spMkLst>
            <pc:docMk/>
            <pc:sldMk cId="1267986695" sldId="263"/>
            <ac:spMk id="22" creationId="{00000000-0000-0000-0000-000000000000}"/>
          </ac:spMkLst>
        </pc:spChg>
        <pc:spChg chg="mod">
          <ac:chgData name="Charlotte E Robinson" userId="S::crob261@lsu.edu::b04a81f5-e1b9-4faa-b263-388a49954364" providerId="AD" clId="Web-{F69E66EE-B8B9-38E3-9E1C-1F8F13CDDCB9}" dt="2024-04-15T02:16:17.420" v="767" actId="1076"/>
          <ac:spMkLst>
            <pc:docMk/>
            <pc:sldMk cId="1267986695" sldId="263"/>
            <ac:spMk id="23" creationId="{00000000-0000-0000-0000-000000000000}"/>
          </ac:spMkLst>
        </pc:spChg>
        <pc:spChg chg="mod">
          <ac:chgData name="Charlotte E Robinson" userId="S::crob261@lsu.edu::b04a81f5-e1b9-4faa-b263-388a49954364" providerId="AD" clId="Web-{F69E66EE-B8B9-38E3-9E1C-1F8F13CDDCB9}" dt="2024-04-11T17:48:37.395" v="25" actId="20577"/>
          <ac:spMkLst>
            <pc:docMk/>
            <pc:sldMk cId="1267986695" sldId="263"/>
            <ac:spMk id="14339" creationId="{00000000-0000-0000-0000-000000000000}"/>
          </ac:spMkLst>
        </pc:spChg>
        <pc:spChg chg="mod">
          <ac:chgData name="Charlotte E Robinson" userId="S::crob261@lsu.edu::b04a81f5-e1b9-4faa-b263-388a49954364" providerId="AD" clId="Web-{F69E66EE-B8B9-38E3-9E1C-1F8F13CDDCB9}" dt="2024-04-15T02:13:59.494" v="663" actId="14100"/>
          <ac:spMkLst>
            <pc:docMk/>
            <pc:sldMk cId="1267986695" sldId="263"/>
            <ac:spMk id="14342" creationId="{00000000-0000-0000-0000-000000000000}"/>
          </ac:spMkLst>
        </pc:spChg>
        <pc:spChg chg="mod">
          <ac:chgData name="Charlotte E Robinson" userId="S::crob261@lsu.edu::b04a81f5-e1b9-4faa-b263-388a49954364" providerId="AD" clId="Web-{F69E66EE-B8B9-38E3-9E1C-1F8F13CDDCB9}" dt="2024-04-15T02:36:38.449" v="1163" actId="20577"/>
          <ac:spMkLst>
            <pc:docMk/>
            <pc:sldMk cId="1267986695" sldId="263"/>
            <ac:spMk id="14343" creationId="{00000000-0000-0000-0000-000000000000}"/>
          </ac:spMkLst>
        </pc:spChg>
      </pc:sldChg>
    </pc:docChg>
  </pc:docChgLst>
  <pc:docChgLst>
    <pc:chgData name="Jada Daniels" userId="S::jdani87@lsu.edu::8970acce-57c7-4559-8174-5ce60882e72d" providerId="AD" clId="Web-{4BCDFB74-4E84-FC41-D991-786349DAD0AD}"/>
    <pc:docChg chg="delSld modSld">
      <pc:chgData name="Jada Daniels" userId="S::jdani87@lsu.edu::8970acce-57c7-4559-8174-5ce60882e72d" providerId="AD" clId="Web-{4BCDFB74-4E84-FC41-D991-786349DAD0AD}" dt="2024-04-22T22:14:27.068" v="416" actId="20577"/>
      <pc:docMkLst>
        <pc:docMk/>
      </pc:docMkLst>
      <pc:sldChg chg="modSp">
        <pc:chgData name="Jada Daniels" userId="S::jdani87@lsu.edu::8970acce-57c7-4559-8174-5ce60882e72d" providerId="AD" clId="Web-{4BCDFB74-4E84-FC41-D991-786349DAD0AD}" dt="2024-04-22T22:14:27.068" v="416" actId="20577"/>
        <pc:sldMkLst>
          <pc:docMk/>
          <pc:sldMk cId="1267986695" sldId="263"/>
        </pc:sldMkLst>
        <pc:spChg chg="mod">
          <ac:chgData name="Jada Daniels" userId="S::jdani87@lsu.edu::8970acce-57c7-4559-8174-5ce60882e72d" providerId="AD" clId="Web-{4BCDFB74-4E84-FC41-D991-786349DAD0AD}" dt="2024-04-22T22:09:33.588" v="133" actId="1076"/>
          <ac:spMkLst>
            <pc:docMk/>
            <pc:sldMk cId="1267986695" sldId="263"/>
            <ac:spMk id="31" creationId="{7F2FB729-B800-3746-3C27-976B0D44BD25}"/>
          </ac:spMkLst>
        </pc:spChg>
        <pc:spChg chg="mod">
          <ac:chgData name="Jada Daniels" userId="S::jdani87@lsu.edu::8970acce-57c7-4559-8174-5ce60882e72d" providerId="AD" clId="Web-{4BCDFB74-4E84-FC41-D991-786349DAD0AD}" dt="2024-04-22T22:13:23.612" v="409" actId="20577"/>
          <ac:spMkLst>
            <pc:docMk/>
            <pc:sldMk cId="1267986695" sldId="263"/>
            <ac:spMk id="32" creationId="{44B01CFD-FD60-D4B8-9DB0-913901421BEE}"/>
          </ac:spMkLst>
        </pc:spChg>
        <pc:spChg chg="mod">
          <ac:chgData name="Jada Daniels" userId="S::jdani87@lsu.edu::8970acce-57c7-4559-8174-5ce60882e72d" providerId="AD" clId="Web-{4BCDFB74-4E84-FC41-D991-786349DAD0AD}" dt="2024-04-22T22:09:38.651" v="134" actId="1076"/>
          <ac:spMkLst>
            <pc:docMk/>
            <pc:sldMk cId="1267986695" sldId="263"/>
            <ac:spMk id="33" creationId="{18B5C642-0B11-8A65-D021-2231F52627AA}"/>
          </ac:spMkLst>
        </pc:spChg>
        <pc:spChg chg="mod">
          <ac:chgData name="Jada Daniels" userId="S::jdani87@lsu.edu::8970acce-57c7-4559-8174-5ce60882e72d" providerId="AD" clId="Web-{4BCDFB74-4E84-FC41-D991-786349DAD0AD}" dt="2024-04-22T22:13:09.190" v="407" actId="14100"/>
          <ac:spMkLst>
            <pc:docMk/>
            <pc:sldMk cId="1267986695" sldId="263"/>
            <ac:spMk id="34" creationId="{AF943511-BF14-7164-A804-4EE36C99301B}"/>
          </ac:spMkLst>
        </pc:spChg>
        <pc:spChg chg="mod">
          <ac:chgData name="Jada Daniels" userId="S::jdani87@lsu.edu::8970acce-57c7-4559-8174-5ce60882e72d" providerId="AD" clId="Web-{4BCDFB74-4E84-FC41-D991-786349DAD0AD}" dt="2024-04-22T22:09:25.932" v="131" actId="1076"/>
          <ac:spMkLst>
            <pc:docMk/>
            <pc:sldMk cId="1267986695" sldId="263"/>
            <ac:spMk id="35" creationId="{69D7526D-8EC8-0C82-A5C3-7D255A0126AF}"/>
          </ac:spMkLst>
        </pc:spChg>
        <pc:spChg chg="mod">
          <ac:chgData name="Jada Daniels" userId="S::jdani87@lsu.edu::8970acce-57c7-4559-8174-5ce60882e72d" providerId="AD" clId="Web-{4BCDFB74-4E84-FC41-D991-786349DAD0AD}" dt="2024-04-22T22:14:27.068" v="416" actId="20577"/>
          <ac:spMkLst>
            <pc:docMk/>
            <pc:sldMk cId="1267986695" sldId="263"/>
            <ac:spMk id="36" creationId="{30EAF356-4807-BAF3-0908-80002FAFCE7E}"/>
          </ac:spMkLst>
        </pc:spChg>
        <pc:spChg chg="mod">
          <ac:chgData name="Jada Daniels" userId="S::jdani87@lsu.edu::8970acce-57c7-4559-8174-5ce60882e72d" providerId="AD" clId="Web-{4BCDFB74-4E84-FC41-D991-786349DAD0AD}" dt="2024-04-22T22:09:18.213" v="129" actId="14100"/>
          <ac:spMkLst>
            <pc:docMk/>
            <pc:sldMk cId="1267986695" sldId="263"/>
            <ac:spMk id="37" creationId="{C0F06F95-DEC7-2E2C-5084-BC64E3C17B22}"/>
          </ac:spMkLst>
        </pc:spChg>
        <pc:spChg chg="mod">
          <ac:chgData name="Jada Daniels" userId="S::jdani87@lsu.edu::8970acce-57c7-4559-8174-5ce60882e72d" providerId="AD" clId="Web-{4BCDFB74-4E84-FC41-D991-786349DAD0AD}" dt="2024-04-22T22:06:51.254" v="46" actId="14100"/>
          <ac:spMkLst>
            <pc:docMk/>
            <pc:sldMk cId="1267986695" sldId="263"/>
            <ac:spMk id="14339" creationId="{00000000-0000-0000-0000-000000000000}"/>
          </ac:spMkLst>
        </pc:spChg>
        <pc:picChg chg="mod modCrop">
          <ac:chgData name="Jada Daniels" userId="S::jdani87@lsu.edu::8970acce-57c7-4559-8174-5ce60882e72d" providerId="AD" clId="Web-{4BCDFB74-4E84-FC41-D991-786349DAD0AD}" dt="2024-04-22T22:08:26.383" v="57" actId="1076"/>
          <ac:picMkLst>
            <pc:docMk/>
            <pc:sldMk cId="1267986695" sldId="263"/>
            <ac:picMk id="25" creationId="{BD4A9A9A-18D7-AEFC-10D6-3D1B4532728C}"/>
          </ac:picMkLst>
        </pc:picChg>
      </pc:sldChg>
      <pc:sldChg chg="del">
        <pc:chgData name="Jada Daniels" userId="S::jdani87@lsu.edu::8970acce-57c7-4559-8174-5ce60882e72d" providerId="AD" clId="Web-{4BCDFB74-4E84-FC41-D991-786349DAD0AD}" dt="2024-04-22T22:05:40.174" v="2"/>
        <pc:sldMkLst>
          <pc:docMk/>
          <pc:sldMk cId="2410079693" sldId="265"/>
        </pc:sldMkLst>
      </pc:sldChg>
      <pc:sldChg chg="del">
        <pc:chgData name="Jada Daniels" userId="S::jdani87@lsu.edu::8970acce-57c7-4559-8174-5ce60882e72d" providerId="AD" clId="Web-{4BCDFB74-4E84-FC41-D991-786349DAD0AD}" dt="2024-04-22T22:05:40.189" v="3"/>
        <pc:sldMkLst>
          <pc:docMk/>
          <pc:sldMk cId="4277929086" sldId="266"/>
        </pc:sldMkLst>
      </pc:sldChg>
      <pc:sldChg chg="del">
        <pc:chgData name="Jada Daniels" userId="S::jdani87@lsu.edu::8970acce-57c7-4559-8174-5ce60882e72d" providerId="AD" clId="Web-{4BCDFB74-4E84-FC41-D991-786349DAD0AD}" dt="2024-04-22T22:05:38.220" v="0"/>
        <pc:sldMkLst>
          <pc:docMk/>
          <pc:sldMk cId="1227497581" sldId="267"/>
        </pc:sldMkLst>
      </pc:sldChg>
      <pc:sldChg chg="del">
        <pc:chgData name="Jada Daniels" userId="S::jdani87@lsu.edu::8970acce-57c7-4559-8174-5ce60882e72d" providerId="AD" clId="Web-{4BCDFB74-4E84-FC41-D991-786349DAD0AD}" dt="2024-04-22T22:05:38.970" v="1"/>
        <pc:sldMkLst>
          <pc:docMk/>
          <pc:sldMk cId="4151853014" sldId="268"/>
        </pc:sldMkLst>
      </pc:sldChg>
      <pc:sldChg chg="del">
        <pc:chgData name="Jada Daniels" userId="S::jdani87@lsu.edu::8970acce-57c7-4559-8174-5ce60882e72d" providerId="AD" clId="Web-{4BCDFB74-4E84-FC41-D991-786349DAD0AD}" dt="2024-04-22T22:05:43.564" v="7"/>
        <pc:sldMkLst>
          <pc:docMk/>
          <pc:sldMk cId="3452841041" sldId="269"/>
        </pc:sldMkLst>
      </pc:sldChg>
      <pc:sldChg chg="del">
        <pc:chgData name="Jada Daniels" userId="S::jdani87@lsu.edu::8970acce-57c7-4559-8174-5ce60882e72d" providerId="AD" clId="Web-{4BCDFB74-4E84-FC41-D991-786349DAD0AD}" dt="2024-04-22T22:05:40.580" v="4"/>
        <pc:sldMkLst>
          <pc:docMk/>
          <pc:sldMk cId="1964245774" sldId="270"/>
        </pc:sldMkLst>
      </pc:sldChg>
      <pc:sldChg chg="del">
        <pc:chgData name="Jada Daniels" userId="S::jdani87@lsu.edu::8970acce-57c7-4559-8174-5ce60882e72d" providerId="AD" clId="Web-{4BCDFB74-4E84-FC41-D991-786349DAD0AD}" dt="2024-04-22T22:05:40.986" v="5"/>
        <pc:sldMkLst>
          <pc:docMk/>
          <pc:sldMk cId="402720778" sldId="271"/>
        </pc:sldMkLst>
      </pc:sldChg>
      <pc:sldChg chg="del">
        <pc:chgData name="Jada Daniels" userId="S::jdani87@lsu.edu::8970acce-57c7-4559-8174-5ce60882e72d" providerId="AD" clId="Web-{4BCDFB74-4E84-FC41-D991-786349DAD0AD}" dt="2024-04-22T22:05:41.924" v="6"/>
        <pc:sldMkLst>
          <pc:docMk/>
          <pc:sldMk cId="1488488167" sldId="272"/>
        </pc:sldMkLst>
      </pc:sldChg>
      <pc:sldChg chg="del">
        <pc:chgData name="Jada Daniels" userId="S::jdani87@lsu.edu::8970acce-57c7-4559-8174-5ce60882e72d" providerId="AD" clId="Web-{4BCDFB74-4E84-FC41-D991-786349DAD0AD}" dt="2024-04-22T22:05:43.580" v="8"/>
        <pc:sldMkLst>
          <pc:docMk/>
          <pc:sldMk cId="2959281206" sldId="273"/>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3038475" cy="465138"/>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lvl1pPr>
              <a:defRPr sz="1200" dirty="0">
                <a:latin typeface="Arial" charset="0"/>
                <a:cs typeface="+mn-cs"/>
              </a:defRPr>
            </a:lvl1pPr>
          </a:lstStyle>
          <a:p>
            <a:pPr>
              <a:defRPr/>
            </a:pPr>
            <a:endParaRPr lang="en-US"/>
          </a:p>
        </p:txBody>
      </p:sp>
      <p:sp>
        <p:nvSpPr>
          <p:cNvPr id="3075" name="Rectangle 3"/>
          <p:cNvSpPr>
            <a:spLocks noGrp="1" noChangeArrowheads="1"/>
          </p:cNvSpPr>
          <p:nvPr>
            <p:ph type="dt" idx="1"/>
          </p:nvPr>
        </p:nvSpPr>
        <p:spPr bwMode="auto">
          <a:xfrm>
            <a:off x="3970338" y="0"/>
            <a:ext cx="3038475" cy="465138"/>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lvl1pPr algn="r">
              <a:defRPr sz="1200" dirty="0">
                <a:latin typeface="Arial" charset="0"/>
                <a:cs typeface="+mn-cs"/>
              </a:defRPr>
            </a:lvl1pPr>
          </a:lstStyle>
          <a:p>
            <a:pPr>
              <a:defRPr/>
            </a:pPr>
            <a:endParaRPr lang="en-US"/>
          </a:p>
        </p:txBody>
      </p:sp>
      <p:sp>
        <p:nvSpPr>
          <p:cNvPr id="13316" name="Rectangle 4"/>
          <p:cNvSpPr>
            <a:spLocks noGrp="1" noRot="1" noChangeAspect="1" noChangeArrowheads="1" noTextEdit="1"/>
          </p:cNvSpPr>
          <p:nvPr>
            <p:ph type="sldImg" idx="2"/>
          </p:nvPr>
        </p:nvSpPr>
        <p:spPr bwMode="auto">
          <a:xfrm>
            <a:off x="1181100" y="696913"/>
            <a:ext cx="4648200" cy="3486150"/>
          </a:xfrm>
          <a:prstGeom prst="rect">
            <a:avLst/>
          </a:prstGeom>
          <a:noFill/>
          <a:ln w="9525">
            <a:solidFill>
              <a:srgbClr val="000000"/>
            </a:solidFill>
            <a:miter lim="800000"/>
            <a:headEnd/>
            <a:tailEnd/>
          </a:ln>
        </p:spPr>
      </p:sp>
      <p:sp>
        <p:nvSpPr>
          <p:cNvPr id="3077" name="Rectangle 5"/>
          <p:cNvSpPr>
            <a:spLocks noGrp="1" noChangeArrowheads="1"/>
          </p:cNvSpPr>
          <p:nvPr>
            <p:ph type="body" sz="quarter" idx="3"/>
          </p:nvPr>
        </p:nvSpPr>
        <p:spPr bwMode="auto">
          <a:xfrm>
            <a:off x="701675" y="4416425"/>
            <a:ext cx="5607050" cy="4183063"/>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3078" name="Rectangle 6"/>
          <p:cNvSpPr>
            <a:spLocks noGrp="1" noChangeArrowheads="1"/>
          </p:cNvSpPr>
          <p:nvPr>
            <p:ph type="ftr" sz="quarter" idx="4"/>
          </p:nvPr>
        </p:nvSpPr>
        <p:spPr bwMode="auto">
          <a:xfrm>
            <a:off x="0" y="8829675"/>
            <a:ext cx="3038475" cy="465138"/>
          </a:xfrm>
          <a:prstGeom prst="rect">
            <a:avLst/>
          </a:prstGeom>
          <a:noFill/>
          <a:ln w="9525">
            <a:noFill/>
            <a:miter lim="800000"/>
            <a:headEnd/>
            <a:tailEnd/>
          </a:ln>
          <a:effectLst/>
        </p:spPr>
        <p:txBody>
          <a:bodyPr vert="horz" wrap="square" lIns="93177" tIns="46589" rIns="93177" bIns="46589" numCol="1" anchor="b" anchorCtr="0" compatLnSpc="1">
            <a:prstTxWarp prst="textNoShape">
              <a:avLst/>
            </a:prstTxWarp>
          </a:bodyPr>
          <a:lstStyle>
            <a:lvl1pPr>
              <a:defRPr sz="1200" dirty="0">
                <a:latin typeface="Arial" charset="0"/>
                <a:cs typeface="+mn-cs"/>
              </a:defRPr>
            </a:lvl1pPr>
          </a:lstStyle>
          <a:p>
            <a:pPr>
              <a:defRPr/>
            </a:pPr>
            <a:endParaRPr lang="en-US"/>
          </a:p>
        </p:txBody>
      </p:sp>
      <p:sp>
        <p:nvSpPr>
          <p:cNvPr id="3079" name="Rectangle 7"/>
          <p:cNvSpPr>
            <a:spLocks noGrp="1" noChangeArrowheads="1"/>
          </p:cNvSpPr>
          <p:nvPr>
            <p:ph type="sldNum" sz="quarter" idx="5"/>
          </p:nvPr>
        </p:nvSpPr>
        <p:spPr bwMode="auto">
          <a:xfrm>
            <a:off x="3970338" y="8829675"/>
            <a:ext cx="3038475" cy="465138"/>
          </a:xfrm>
          <a:prstGeom prst="rect">
            <a:avLst/>
          </a:prstGeom>
          <a:noFill/>
          <a:ln w="9525">
            <a:noFill/>
            <a:miter lim="800000"/>
            <a:headEnd/>
            <a:tailEnd/>
          </a:ln>
          <a:effectLst/>
        </p:spPr>
        <p:txBody>
          <a:bodyPr vert="horz" wrap="square" lIns="93177" tIns="46589" rIns="93177" bIns="46589" numCol="1" anchor="b" anchorCtr="0" compatLnSpc="1">
            <a:prstTxWarp prst="textNoShape">
              <a:avLst/>
            </a:prstTxWarp>
          </a:bodyPr>
          <a:lstStyle>
            <a:lvl1pPr algn="r">
              <a:defRPr sz="1200">
                <a:latin typeface="Arial" charset="0"/>
                <a:cs typeface="+mn-cs"/>
              </a:defRPr>
            </a:lvl1pPr>
          </a:lstStyle>
          <a:p>
            <a:pPr>
              <a:defRPr/>
            </a:pPr>
            <a:fld id="{B920B7D0-28C1-4875-801A-9601F8584225}" type="slidenum">
              <a:rPr lang="en-US"/>
              <a:pPr>
                <a:defRPr/>
              </a:pPr>
              <a:t>‹#›</a:t>
            </a:fld>
            <a:endParaRPr lang="en-US"/>
          </a:p>
        </p:txBody>
      </p:sp>
    </p:spTree>
    <p:extLst>
      <p:ext uri="{BB962C8B-B14F-4D97-AF65-F5344CB8AC3E}">
        <p14:creationId xmlns:p14="http://schemas.microsoft.com/office/powerpoint/2010/main" val="2968393729"/>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Slide Image Placeholder 1"/>
          <p:cNvSpPr>
            <a:spLocks noGrp="1" noRot="1" noChangeAspec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5362"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spcBef>
                <a:spcPct val="0"/>
              </a:spcBef>
            </a:pPr>
            <a:r>
              <a:rPr lang="en-US" altLang="en-US" sz="9600">
                <a:solidFill>
                  <a:srgbClr val="000000"/>
                </a:solidFill>
              </a:rPr>
              <a:t>Copyright Colin </a:t>
            </a:r>
            <a:r>
              <a:rPr lang="en-US" altLang="en-US" sz="9600" err="1">
                <a:solidFill>
                  <a:srgbClr val="000000"/>
                </a:solidFill>
              </a:rPr>
              <a:t>Purrington</a:t>
            </a:r>
            <a:r>
              <a:rPr lang="en-US" altLang="en-US" sz="9600">
                <a:solidFill>
                  <a:srgbClr val="000000"/>
                </a:solidFill>
              </a:rPr>
              <a:t> (</a:t>
            </a:r>
            <a:r>
              <a:rPr lang="en-US" altLang="en-US" sz="9600">
                <a:solidFill>
                  <a:srgbClr val="000000"/>
                </a:solidFill>
                <a:latin typeface="Times New Roman" panose="02020603050405020304" pitchFamily="18" charset="0"/>
                <a:cs typeface="Calibri" panose="020F0502020204030204" pitchFamily="34" charset="0"/>
              </a:rPr>
              <a:t>http://</a:t>
            </a:r>
            <a:r>
              <a:rPr lang="en-US" altLang="en-US" sz="9600" err="1">
                <a:solidFill>
                  <a:srgbClr val="000000"/>
                </a:solidFill>
                <a:latin typeface="Times New Roman" panose="02020603050405020304" pitchFamily="18" charset="0"/>
                <a:cs typeface="Calibri" panose="020F0502020204030204" pitchFamily="34" charset="0"/>
              </a:rPr>
              <a:t>colinpurrington.com</a:t>
            </a:r>
            <a:r>
              <a:rPr lang="en-US" altLang="en-US" sz="9600">
                <a:solidFill>
                  <a:srgbClr val="000000"/>
                </a:solidFill>
                <a:latin typeface="Times New Roman" panose="02020603050405020304" pitchFamily="18" charset="0"/>
                <a:cs typeface="Calibri" panose="020F0502020204030204" pitchFamily="34" charset="0"/>
              </a:rPr>
              <a:t>/tips/academic/</a:t>
            </a:r>
            <a:r>
              <a:rPr lang="en-US" altLang="en-US" sz="9600" err="1">
                <a:solidFill>
                  <a:srgbClr val="000000"/>
                </a:solidFill>
                <a:latin typeface="Times New Roman" panose="02020603050405020304" pitchFamily="18" charset="0"/>
                <a:cs typeface="Calibri" panose="020F0502020204030204" pitchFamily="34" charset="0"/>
              </a:rPr>
              <a:t>posterdesign</a:t>
            </a:r>
            <a:r>
              <a:rPr lang="en-US" altLang="en-US" sz="9600">
                <a:solidFill>
                  <a:srgbClr val="000000"/>
                </a:solidFill>
                <a:latin typeface="Times New Roman" panose="02020603050405020304" pitchFamily="18" charset="0"/>
                <a:cs typeface="Calibri" panose="020F0502020204030204" pitchFamily="34" charset="0"/>
              </a:rPr>
              <a:t>).</a:t>
            </a:r>
            <a:endParaRPr lang="en-US" altLang="en-US" sz="9600">
              <a:solidFill>
                <a:srgbClr val="000000"/>
              </a:solidFill>
            </a:endParaRPr>
          </a:p>
        </p:txBody>
      </p:sp>
      <p:sp>
        <p:nvSpPr>
          <p:cNvPr id="15363"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fld id="{D1B86C04-26CE-440C-976B-D95BF29BEB46}" type="slidenum">
              <a:rPr lang="en-US" altLang="en-US" sz="1200">
                <a:latin typeface="Calibri" panose="020F0502020204030204" pitchFamily="34" charset="0"/>
              </a:rPr>
              <a:pPr eaLnBrk="1" hangingPunct="1"/>
              <a:t>1</a:t>
            </a:fld>
            <a:endParaRPr lang="en-US" altLang="en-US" sz="1200">
              <a:latin typeface="Calibri" panose="020F0502020204030204" pitchFamily="34" charset="0"/>
            </a:endParaRPr>
          </a:p>
        </p:txBody>
      </p:sp>
    </p:spTree>
    <p:extLst>
      <p:ext uri="{BB962C8B-B14F-4D97-AF65-F5344CB8AC3E}">
        <p14:creationId xmlns:p14="http://schemas.microsoft.com/office/powerpoint/2010/main" val="36391967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292475" y="10226675"/>
            <a:ext cx="37306250" cy="7054850"/>
          </a:xfrm>
        </p:spPr>
        <p:txBody>
          <a:bodyPr/>
          <a:lstStyle/>
          <a:p>
            <a:r>
              <a:rPr lang="en-US"/>
              <a:t>Click to edit Master title style</a:t>
            </a:r>
          </a:p>
        </p:txBody>
      </p:sp>
      <p:sp>
        <p:nvSpPr>
          <p:cNvPr id="3" name="Subtitle 2"/>
          <p:cNvSpPr>
            <a:spLocks noGrp="1"/>
          </p:cNvSpPr>
          <p:nvPr>
            <p:ph type="subTitle" idx="1"/>
          </p:nvPr>
        </p:nvSpPr>
        <p:spPr>
          <a:xfrm>
            <a:off x="6583363" y="18653125"/>
            <a:ext cx="30724475" cy="841375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3BBC25F0-0833-4581-8A24-DFC5B60DC0CD}"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DDA5D870-1F2D-4A42-A4CF-8A12D8156CAD}"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1823025" y="1319213"/>
            <a:ext cx="9874250" cy="2808763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195513" y="1319213"/>
            <a:ext cx="29475112" cy="2808763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48C8DB9B-6028-4C82-814C-943A1B49AF9D}"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B34FC422-C20F-4905-A44D-91051989088C}"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467100" y="21153438"/>
            <a:ext cx="37307838" cy="653732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3467100" y="13952538"/>
            <a:ext cx="37307838" cy="720090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1A8BFAD0-37F0-4A01-BB86-91714C3FE2CD}"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195513" y="7681913"/>
            <a:ext cx="19673887"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2021800" y="7681913"/>
            <a:ext cx="19675475"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1790AC80-5F60-43A9-B1EA-E38727478A3B}"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7625"/>
            <a:ext cx="39503350" cy="54864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2193925" y="7369175"/>
            <a:ext cx="19392900"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2193925" y="10439400"/>
            <a:ext cx="19392900"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22296438" y="7369175"/>
            <a:ext cx="19400837"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22296438" y="10439400"/>
            <a:ext cx="19400837"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p:cNvSpPr>
            <a:spLocks noGrp="1" noChangeArrowheads="1"/>
          </p:cNvSpPr>
          <p:nvPr>
            <p:ph type="dt" sz="half" idx="10"/>
          </p:nvPr>
        </p:nvSpPr>
        <p:spPr>
          <a:ln/>
        </p:spPr>
        <p:txBody>
          <a:bodyPr/>
          <a:lstStyle>
            <a:lvl1pPr>
              <a:defRPr/>
            </a:lvl1pPr>
          </a:lstStyle>
          <a:p>
            <a:pPr>
              <a:defRPr/>
            </a:pPr>
            <a:endParaRPr lang="en-US"/>
          </a:p>
        </p:txBody>
      </p:sp>
      <p:sp>
        <p:nvSpPr>
          <p:cNvPr id="8" name="Rectangle 5"/>
          <p:cNvSpPr>
            <a:spLocks noGrp="1" noChangeArrowheads="1"/>
          </p:cNvSpPr>
          <p:nvPr>
            <p:ph type="ftr" sz="quarter" idx="11"/>
          </p:nvPr>
        </p:nvSpPr>
        <p:spPr>
          <a:ln/>
        </p:spPr>
        <p:txBody>
          <a:bodyPr/>
          <a:lstStyle>
            <a:lvl1pPr>
              <a:defRPr/>
            </a:lvl1pPr>
          </a:lstStyle>
          <a:p>
            <a:pPr>
              <a:defRPr/>
            </a:pPr>
            <a:endParaRPr lang="en-US"/>
          </a:p>
        </p:txBody>
      </p:sp>
      <p:sp>
        <p:nvSpPr>
          <p:cNvPr id="9" name="Rectangle 6"/>
          <p:cNvSpPr>
            <a:spLocks noGrp="1" noChangeArrowheads="1"/>
          </p:cNvSpPr>
          <p:nvPr>
            <p:ph type="sldNum" sz="quarter" idx="12"/>
          </p:nvPr>
        </p:nvSpPr>
        <p:spPr>
          <a:ln/>
        </p:spPr>
        <p:txBody>
          <a:bodyPr/>
          <a:lstStyle>
            <a:lvl1pPr>
              <a:defRPr/>
            </a:lvl1pPr>
          </a:lstStyle>
          <a:p>
            <a:pPr>
              <a:defRPr/>
            </a:pPr>
            <a:fld id="{2E192D6F-9714-4E48-8FB9-E12DD809903F}"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p:cNvSpPr>
            <a:spLocks noGrp="1" noChangeArrowheads="1"/>
          </p:cNvSpPr>
          <p:nvPr>
            <p:ph type="dt" sz="half" idx="10"/>
          </p:nvPr>
        </p:nvSpPr>
        <p:spPr>
          <a:ln/>
        </p:spPr>
        <p:txBody>
          <a:bodyPr/>
          <a:lstStyle>
            <a:lvl1pPr>
              <a:defRPr/>
            </a:lvl1pPr>
          </a:lstStyle>
          <a:p>
            <a:pPr>
              <a:defRPr/>
            </a:pPr>
            <a:endParaRPr lang="en-US"/>
          </a:p>
        </p:txBody>
      </p:sp>
      <p:sp>
        <p:nvSpPr>
          <p:cNvPr id="4" name="Rectangle 5"/>
          <p:cNvSpPr>
            <a:spLocks noGrp="1" noChangeArrowheads="1"/>
          </p:cNvSpPr>
          <p:nvPr>
            <p:ph type="ftr" sz="quarter" idx="11"/>
          </p:nvPr>
        </p:nvSpPr>
        <p:spPr>
          <a:ln/>
        </p:spPr>
        <p:txBody>
          <a:bodyPr/>
          <a:lstStyle>
            <a:lvl1pPr>
              <a:defRPr/>
            </a:lvl1pPr>
          </a:lstStyle>
          <a:p>
            <a:pPr>
              <a:defRPr/>
            </a:pPr>
            <a:endParaRPr lang="en-US"/>
          </a:p>
        </p:txBody>
      </p:sp>
      <p:sp>
        <p:nvSpPr>
          <p:cNvPr id="5" name="Rectangle 6"/>
          <p:cNvSpPr>
            <a:spLocks noGrp="1" noChangeArrowheads="1"/>
          </p:cNvSpPr>
          <p:nvPr>
            <p:ph type="sldNum" sz="quarter" idx="12"/>
          </p:nvPr>
        </p:nvSpPr>
        <p:spPr>
          <a:ln/>
        </p:spPr>
        <p:txBody>
          <a:bodyPr/>
          <a:lstStyle>
            <a:lvl1pPr>
              <a:defRPr/>
            </a:lvl1pPr>
          </a:lstStyle>
          <a:p>
            <a:pPr>
              <a:defRPr/>
            </a:pPr>
            <a:fld id="{E0FE8706-92DB-455F-8DF5-E364EF0F981B}"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a:p>
        </p:txBody>
      </p:sp>
      <p:sp>
        <p:nvSpPr>
          <p:cNvPr id="3" name="Rectangle 5"/>
          <p:cNvSpPr>
            <a:spLocks noGrp="1" noChangeArrowheads="1"/>
          </p:cNvSpPr>
          <p:nvPr>
            <p:ph type="ftr" sz="quarter" idx="11"/>
          </p:nvPr>
        </p:nvSpPr>
        <p:spPr>
          <a:ln/>
        </p:spPr>
        <p:txBody>
          <a:bodyPr/>
          <a:lstStyle>
            <a:lvl1pPr>
              <a:defRPr/>
            </a:lvl1pPr>
          </a:lstStyle>
          <a:p>
            <a:pPr>
              <a:defRPr/>
            </a:pPr>
            <a:endParaRPr lang="en-US"/>
          </a:p>
        </p:txBody>
      </p:sp>
      <p:sp>
        <p:nvSpPr>
          <p:cNvPr id="4" name="Rectangle 6"/>
          <p:cNvSpPr>
            <a:spLocks noGrp="1" noChangeArrowheads="1"/>
          </p:cNvSpPr>
          <p:nvPr>
            <p:ph type="sldNum" sz="quarter" idx="12"/>
          </p:nvPr>
        </p:nvSpPr>
        <p:spPr>
          <a:ln/>
        </p:spPr>
        <p:txBody>
          <a:bodyPr/>
          <a:lstStyle>
            <a:lvl1pPr>
              <a:defRPr/>
            </a:lvl1pPr>
          </a:lstStyle>
          <a:p>
            <a:pPr>
              <a:defRPr/>
            </a:pPr>
            <a:fld id="{E3CD7F50-5D49-43C5-973D-AC672AB2FD79}"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1275"/>
            <a:ext cx="14439900" cy="5576888"/>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17160875" y="1311275"/>
            <a:ext cx="24536400" cy="28093988"/>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2193925" y="6888163"/>
            <a:ext cx="14439900" cy="2251710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07A09D3C-21D5-4DA8-B5FA-7FAA718B7982}"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02663" y="23042563"/>
            <a:ext cx="26335037" cy="2720975"/>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8602663" y="2941638"/>
            <a:ext cx="26335037" cy="19750087"/>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8602663" y="25763538"/>
            <a:ext cx="26335037" cy="3862387"/>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56EDB5CB-C045-4A31-81F2-07DFC0A328B3}"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2195513" y="1319213"/>
            <a:ext cx="39501762" cy="5486400"/>
          </a:xfrm>
          <a:prstGeom prst="rect">
            <a:avLst/>
          </a:prstGeom>
          <a:noFill/>
          <a:ln w="9525">
            <a:noFill/>
            <a:miter lim="800000"/>
            <a:headEnd/>
            <a:tailEnd/>
          </a:ln>
        </p:spPr>
        <p:txBody>
          <a:bodyPr vert="horz" wrap="square" lIns="470253" tIns="235127" rIns="470253" bIns="235127" numCol="1" anchor="ctr" anchorCtr="0" compatLnSpc="1">
            <a:prstTxWarp prst="textNoShape">
              <a:avLst/>
            </a:prstTxWarp>
          </a:bodyPr>
          <a:lstStyle/>
          <a:p>
            <a:pPr lvl="0"/>
            <a:r>
              <a:rPr lang="en-US"/>
              <a:t>Click to edit Master title style</a:t>
            </a:r>
          </a:p>
        </p:txBody>
      </p:sp>
      <p:sp>
        <p:nvSpPr>
          <p:cNvPr id="1027" name="Rectangle 3"/>
          <p:cNvSpPr>
            <a:spLocks noGrp="1" noChangeArrowheads="1"/>
          </p:cNvSpPr>
          <p:nvPr>
            <p:ph type="body" idx="1"/>
          </p:nvPr>
        </p:nvSpPr>
        <p:spPr bwMode="auto">
          <a:xfrm>
            <a:off x="2195513" y="7681913"/>
            <a:ext cx="39501762" cy="21724937"/>
          </a:xfrm>
          <a:prstGeom prst="rect">
            <a:avLst/>
          </a:prstGeom>
          <a:noFill/>
          <a:ln w="9525">
            <a:noFill/>
            <a:miter lim="800000"/>
            <a:headEnd/>
            <a:tailEnd/>
          </a:ln>
        </p:spPr>
        <p:txBody>
          <a:bodyPr vert="horz" wrap="square" lIns="470253" tIns="235127" rIns="470253" bIns="235127"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28" name="Rectangle 4"/>
          <p:cNvSpPr>
            <a:spLocks noGrp="1" noChangeArrowheads="1"/>
          </p:cNvSpPr>
          <p:nvPr>
            <p:ph type="dt" sz="half" idx="2"/>
          </p:nvPr>
        </p:nvSpPr>
        <p:spPr bwMode="auto">
          <a:xfrm>
            <a:off x="21955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defRPr sz="7200" dirty="0">
                <a:latin typeface="Arial" pitchFamily="34" charset="0"/>
                <a:cs typeface="Arial" pitchFamily="34" charset="0"/>
              </a:defRPr>
            </a:lvl1pPr>
          </a:lstStyle>
          <a:p>
            <a:pPr>
              <a:defRPr/>
            </a:pPr>
            <a:endParaRPr lang="en-US"/>
          </a:p>
        </p:txBody>
      </p:sp>
      <p:sp>
        <p:nvSpPr>
          <p:cNvPr id="1029" name="Rectangle 5"/>
          <p:cNvSpPr>
            <a:spLocks noGrp="1" noChangeArrowheads="1"/>
          </p:cNvSpPr>
          <p:nvPr>
            <p:ph type="ftr" sz="quarter" idx="3"/>
          </p:nvPr>
        </p:nvSpPr>
        <p:spPr bwMode="auto">
          <a:xfrm>
            <a:off x="14997113" y="29978350"/>
            <a:ext cx="138985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ctr">
              <a:defRPr sz="7200" dirty="0">
                <a:latin typeface="Arial" pitchFamily="34" charset="0"/>
                <a:cs typeface="Arial" pitchFamily="34" charset="0"/>
              </a:defRPr>
            </a:lvl1pPr>
          </a:lstStyle>
          <a:p>
            <a:pPr>
              <a:defRPr/>
            </a:pPr>
            <a:endParaRPr lang="en-US"/>
          </a:p>
        </p:txBody>
      </p:sp>
      <p:sp>
        <p:nvSpPr>
          <p:cNvPr id="1030" name="Rectangle 6"/>
          <p:cNvSpPr>
            <a:spLocks noGrp="1" noChangeArrowheads="1"/>
          </p:cNvSpPr>
          <p:nvPr>
            <p:ph type="sldNum" sz="quarter" idx="4"/>
          </p:nvPr>
        </p:nvSpPr>
        <p:spPr bwMode="auto">
          <a:xfrm>
            <a:off x="314563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r">
              <a:defRPr sz="7200">
                <a:latin typeface="Arial" pitchFamily="34" charset="0"/>
                <a:cs typeface="Arial" pitchFamily="34" charset="0"/>
              </a:defRPr>
            </a:lvl1pPr>
          </a:lstStyle>
          <a:p>
            <a:pPr>
              <a:defRPr/>
            </a:pPr>
            <a:fld id="{D1651698-4BBD-4CA7-A80C-7889A8D2803C}"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71" r:id="rId1"/>
    <p:sldLayoutId id="2147483670" r:id="rId2"/>
    <p:sldLayoutId id="2147483669" r:id="rId3"/>
    <p:sldLayoutId id="2147483668" r:id="rId4"/>
    <p:sldLayoutId id="2147483667" r:id="rId5"/>
    <p:sldLayoutId id="2147483666" r:id="rId6"/>
    <p:sldLayoutId id="2147483665" r:id="rId7"/>
    <p:sldLayoutId id="2147483664" r:id="rId8"/>
    <p:sldLayoutId id="2147483663" r:id="rId9"/>
    <p:sldLayoutId id="2147483662" r:id="rId10"/>
    <p:sldLayoutId id="2147483661" r:id="rId11"/>
  </p:sldLayoutIdLst>
  <p:txStyles>
    <p:titleStyle>
      <a:lvl1pPr algn="ctr" defTabSz="4703763" rtl="0" eaLnBrk="0" fontAlgn="base" hangingPunct="0">
        <a:spcBef>
          <a:spcPct val="0"/>
        </a:spcBef>
        <a:spcAft>
          <a:spcPct val="0"/>
        </a:spcAft>
        <a:defRPr sz="22700">
          <a:solidFill>
            <a:schemeClr val="tx2"/>
          </a:solidFill>
          <a:latin typeface="+mj-lt"/>
          <a:ea typeface="+mj-ea"/>
          <a:cs typeface="+mj-cs"/>
        </a:defRPr>
      </a:lvl1pPr>
      <a:lvl2pPr algn="ctr" defTabSz="4703763" rtl="0" eaLnBrk="0" fontAlgn="base" hangingPunct="0">
        <a:spcBef>
          <a:spcPct val="0"/>
        </a:spcBef>
        <a:spcAft>
          <a:spcPct val="0"/>
        </a:spcAft>
        <a:defRPr sz="22700">
          <a:solidFill>
            <a:schemeClr val="tx2"/>
          </a:solidFill>
          <a:latin typeface="Arial" charset="0"/>
        </a:defRPr>
      </a:lvl2pPr>
      <a:lvl3pPr algn="ctr" defTabSz="4703763" rtl="0" eaLnBrk="0" fontAlgn="base" hangingPunct="0">
        <a:spcBef>
          <a:spcPct val="0"/>
        </a:spcBef>
        <a:spcAft>
          <a:spcPct val="0"/>
        </a:spcAft>
        <a:defRPr sz="22700">
          <a:solidFill>
            <a:schemeClr val="tx2"/>
          </a:solidFill>
          <a:latin typeface="Arial" charset="0"/>
        </a:defRPr>
      </a:lvl3pPr>
      <a:lvl4pPr algn="ctr" defTabSz="4703763" rtl="0" eaLnBrk="0" fontAlgn="base" hangingPunct="0">
        <a:spcBef>
          <a:spcPct val="0"/>
        </a:spcBef>
        <a:spcAft>
          <a:spcPct val="0"/>
        </a:spcAft>
        <a:defRPr sz="22700">
          <a:solidFill>
            <a:schemeClr val="tx2"/>
          </a:solidFill>
          <a:latin typeface="Arial" charset="0"/>
        </a:defRPr>
      </a:lvl4pPr>
      <a:lvl5pPr algn="ctr" defTabSz="4703763" rtl="0" eaLnBrk="0" fontAlgn="base" hangingPunct="0">
        <a:spcBef>
          <a:spcPct val="0"/>
        </a:spcBef>
        <a:spcAft>
          <a:spcPct val="0"/>
        </a:spcAft>
        <a:defRPr sz="22700">
          <a:solidFill>
            <a:schemeClr val="tx2"/>
          </a:solidFill>
          <a:latin typeface="Arial" charset="0"/>
        </a:defRPr>
      </a:lvl5pPr>
      <a:lvl6pPr marL="457200" algn="ctr" defTabSz="4703763" rtl="0" fontAlgn="base">
        <a:spcBef>
          <a:spcPct val="0"/>
        </a:spcBef>
        <a:spcAft>
          <a:spcPct val="0"/>
        </a:spcAft>
        <a:defRPr sz="22700">
          <a:solidFill>
            <a:schemeClr val="tx2"/>
          </a:solidFill>
          <a:latin typeface="Arial" charset="0"/>
        </a:defRPr>
      </a:lvl6pPr>
      <a:lvl7pPr marL="914400" algn="ctr" defTabSz="4703763" rtl="0" fontAlgn="base">
        <a:spcBef>
          <a:spcPct val="0"/>
        </a:spcBef>
        <a:spcAft>
          <a:spcPct val="0"/>
        </a:spcAft>
        <a:defRPr sz="22700">
          <a:solidFill>
            <a:schemeClr val="tx2"/>
          </a:solidFill>
          <a:latin typeface="Arial" charset="0"/>
        </a:defRPr>
      </a:lvl7pPr>
      <a:lvl8pPr marL="1371600" algn="ctr" defTabSz="4703763" rtl="0" fontAlgn="base">
        <a:spcBef>
          <a:spcPct val="0"/>
        </a:spcBef>
        <a:spcAft>
          <a:spcPct val="0"/>
        </a:spcAft>
        <a:defRPr sz="22700">
          <a:solidFill>
            <a:schemeClr val="tx2"/>
          </a:solidFill>
          <a:latin typeface="Arial" charset="0"/>
        </a:defRPr>
      </a:lvl8pPr>
      <a:lvl9pPr marL="1828800" algn="ctr" defTabSz="4703763" rtl="0" fontAlgn="base">
        <a:spcBef>
          <a:spcPct val="0"/>
        </a:spcBef>
        <a:spcAft>
          <a:spcPct val="0"/>
        </a:spcAft>
        <a:defRPr sz="22700">
          <a:solidFill>
            <a:schemeClr val="tx2"/>
          </a:solidFill>
          <a:latin typeface="Arial" charset="0"/>
        </a:defRPr>
      </a:lvl9pPr>
    </p:titleStyle>
    <p:bodyStyle>
      <a:lvl1pPr marL="1765300" indent="-1765300" algn="l" defTabSz="4703763" rtl="0" eaLnBrk="0" fontAlgn="base" hangingPunct="0">
        <a:spcBef>
          <a:spcPct val="20000"/>
        </a:spcBef>
        <a:spcAft>
          <a:spcPct val="0"/>
        </a:spcAft>
        <a:buChar char="•"/>
        <a:defRPr sz="16500">
          <a:solidFill>
            <a:schemeClr val="tx1"/>
          </a:solidFill>
          <a:latin typeface="+mn-lt"/>
          <a:ea typeface="+mn-ea"/>
          <a:cs typeface="+mn-cs"/>
        </a:defRPr>
      </a:lvl1pPr>
      <a:lvl2pPr marL="3822700" indent="-1471613" algn="l" defTabSz="4703763" rtl="0" eaLnBrk="0" fontAlgn="base" hangingPunct="0">
        <a:spcBef>
          <a:spcPct val="20000"/>
        </a:spcBef>
        <a:spcAft>
          <a:spcPct val="0"/>
        </a:spcAft>
        <a:buChar char="–"/>
        <a:defRPr sz="14400">
          <a:solidFill>
            <a:schemeClr val="tx1"/>
          </a:solidFill>
          <a:latin typeface="+mn-lt"/>
        </a:defRPr>
      </a:lvl2pPr>
      <a:lvl3pPr marL="5880100" indent="-1176338" algn="l" defTabSz="4703763" rtl="0" eaLnBrk="0" fontAlgn="base" hangingPunct="0">
        <a:spcBef>
          <a:spcPct val="20000"/>
        </a:spcBef>
        <a:spcAft>
          <a:spcPct val="0"/>
        </a:spcAft>
        <a:buChar char="•"/>
        <a:defRPr sz="12300">
          <a:solidFill>
            <a:schemeClr val="tx1"/>
          </a:solidFill>
          <a:latin typeface="+mn-lt"/>
        </a:defRPr>
      </a:lvl3pPr>
      <a:lvl4pPr marL="8229600" indent="-1176338" algn="l" defTabSz="4703763" rtl="0" eaLnBrk="0" fontAlgn="base" hangingPunct="0">
        <a:spcBef>
          <a:spcPct val="20000"/>
        </a:spcBef>
        <a:spcAft>
          <a:spcPct val="0"/>
        </a:spcAft>
        <a:buChar char="–"/>
        <a:defRPr sz="10400">
          <a:solidFill>
            <a:schemeClr val="tx1"/>
          </a:solidFill>
          <a:latin typeface="+mn-lt"/>
        </a:defRPr>
      </a:lvl4pPr>
      <a:lvl5pPr marL="10580688" indent="-1174750" algn="l" defTabSz="4703763" rtl="0" eaLnBrk="0" fontAlgn="base" hangingPunct="0">
        <a:spcBef>
          <a:spcPct val="20000"/>
        </a:spcBef>
        <a:spcAft>
          <a:spcPct val="0"/>
        </a:spcAft>
        <a:buChar char="»"/>
        <a:defRPr sz="10400">
          <a:solidFill>
            <a:schemeClr val="tx1"/>
          </a:solidFill>
          <a:latin typeface="+mn-lt"/>
        </a:defRPr>
      </a:lvl5pPr>
      <a:lvl6pPr marL="11037888" indent="-1174750" algn="l" defTabSz="4703763" rtl="0" fontAlgn="base">
        <a:spcBef>
          <a:spcPct val="20000"/>
        </a:spcBef>
        <a:spcAft>
          <a:spcPct val="0"/>
        </a:spcAft>
        <a:buChar char="»"/>
        <a:defRPr sz="10400">
          <a:solidFill>
            <a:schemeClr val="tx1"/>
          </a:solidFill>
          <a:latin typeface="+mn-lt"/>
        </a:defRPr>
      </a:lvl6pPr>
      <a:lvl7pPr marL="11495088" indent="-1174750" algn="l" defTabSz="4703763" rtl="0" fontAlgn="base">
        <a:spcBef>
          <a:spcPct val="20000"/>
        </a:spcBef>
        <a:spcAft>
          <a:spcPct val="0"/>
        </a:spcAft>
        <a:buChar char="»"/>
        <a:defRPr sz="10400">
          <a:solidFill>
            <a:schemeClr val="tx1"/>
          </a:solidFill>
          <a:latin typeface="+mn-lt"/>
        </a:defRPr>
      </a:lvl7pPr>
      <a:lvl8pPr marL="11952288" indent="-1174750" algn="l" defTabSz="4703763" rtl="0" fontAlgn="base">
        <a:spcBef>
          <a:spcPct val="20000"/>
        </a:spcBef>
        <a:spcAft>
          <a:spcPct val="0"/>
        </a:spcAft>
        <a:buChar char="»"/>
        <a:defRPr sz="10400">
          <a:solidFill>
            <a:schemeClr val="tx1"/>
          </a:solidFill>
          <a:latin typeface="+mn-lt"/>
        </a:defRPr>
      </a:lvl8pPr>
      <a:lvl9pPr marL="12409488" indent="-1174750" algn="l" defTabSz="4703763" rtl="0" fontAlgn="base">
        <a:spcBef>
          <a:spcPct val="20000"/>
        </a:spcBef>
        <a:spcAft>
          <a:spcPct val="0"/>
        </a:spcAft>
        <a:buChar char="»"/>
        <a:defRPr sz="104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image" Target="../media/image1.png"/><Relationship Id="rId7"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3.jpeg"/><Relationship Id="rId5" Type="http://schemas.openxmlformats.org/officeDocument/2006/relationships/image" Target="../media/image2.jpeg"/><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bg>
      <p:bgPr>
        <a:gradFill flip="none" rotWithShape="1">
          <a:gsLst>
            <a:gs pos="0">
              <a:schemeClr val="accent2">
                <a:lumMod val="67000"/>
              </a:schemeClr>
            </a:gs>
            <a:gs pos="48000">
              <a:schemeClr val="accent2">
                <a:lumMod val="97000"/>
                <a:lumOff val="3000"/>
              </a:schemeClr>
            </a:gs>
            <a:gs pos="100000">
              <a:schemeClr val="accent2">
                <a:lumMod val="60000"/>
                <a:lumOff val="40000"/>
              </a:schemeClr>
            </a:gs>
          </a:gsLst>
          <a:lin ang="16200000" scaled="1"/>
          <a:tileRect/>
        </a:gradFill>
        <a:effectLst/>
      </p:bgPr>
    </p:bg>
    <p:spTree>
      <p:nvGrpSpPr>
        <p:cNvPr id="1" name=""/>
        <p:cNvGrpSpPr/>
        <p:nvPr/>
      </p:nvGrpSpPr>
      <p:grpSpPr>
        <a:xfrm>
          <a:off x="0" y="0"/>
          <a:ext cx="0" cy="0"/>
          <a:chOff x="0" y="0"/>
          <a:chExt cx="0" cy="0"/>
        </a:xfrm>
      </p:grpSpPr>
      <p:sp>
        <p:nvSpPr>
          <p:cNvPr id="22" name="Text Box 16"/>
          <p:cNvSpPr txBox="1">
            <a:spLocks noChangeArrowheads="1"/>
          </p:cNvSpPr>
          <p:nvPr/>
        </p:nvSpPr>
        <p:spPr bwMode="auto">
          <a:xfrm>
            <a:off x="32271919" y="21161158"/>
            <a:ext cx="10836947" cy="7197501"/>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endParaRPr lang="en-US" altLang="en-US" sz="3300">
              <a:latin typeface="Times New Roman"/>
              <a:ea typeface="MS PGothic"/>
              <a:cs typeface="Arial"/>
            </a:endParaRPr>
          </a:p>
          <a:p>
            <a:pPr>
              <a:spcBef>
                <a:spcPct val="50000"/>
              </a:spcBef>
            </a:pPr>
            <a:r>
              <a:rPr lang="en-US" altLang="en-US">
                <a:latin typeface="Times New Roman"/>
                <a:ea typeface="MS PGothic"/>
                <a:cs typeface="Arial"/>
              </a:rPr>
              <a:t>Future directions for this experiment include testing different species of plants. If we find that across-the-board plant growth is suffering immensely from higher temperature conditions, we will need to ramp up our efforts to slow or reverse climate change. If climate change continues to grow at its current rate, it could be detrimental to plant life across numerous ecosystems. Plants are at the center of human and animal life, whether for overall health or food consumption. A vast decrease in healthy plants would have lasting effects on human and animal survival. Impacting food availability across the board. </a:t>
            </a:r>
            <a:endParaRPr lang="en-US" altLang="en-US">
              <a:latin typeface="Times New Roman" panose="02020603050405020304" pitchFamily="18" charset="0"/>
            </a:endParaRPr>
          </a:p>
        </p:txBody>
      </p:sp>
      <p:sp>
        <p:nvSpPr>
          <p:cNvPr id="14339" name="Text Box 7"/>
          <p:cNvSpPr txBox="1">
            <a:spLocks noChangeArrowheads="1"/>
          </p:cNvSpPr>
          <p:nvPr/>
        </p:nvSpPr>
        <p:spPr bwMode="auto">
          <a:xfrm>
            <a:off x="798411" y="4667175"/>
            <a:ext cx="9930685" cy="12990863"/>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tabLst>
                <a:tab pos="500063"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0063"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10000"/>
              </a:spcBef>
            </a:pPr>
            <a:endParaRPr lang="en-US" altLang="en-US">
              <a:latin typeface="Times New Roman" panose="02020603050405020304" pitchFamily="18" charset="0"/>
            </a:endParaRPr>
          </a:p>
          <a:p>
            <a:pPr>
              <a:spcBef>
                <a:spcPct val="10000"/>
              </a:spcBef>
            </a:pPr>
            <a:r>
              <a:rPr lang="en-US" altLang="en-US" sz="3100">
                <a:latin typeface="Times New Roman"/>
                <a:ea typeface="MS PGothic"/>
                <a:cs typeface="Arial"/>
              </a:rPr>
              <a:t>  </a:t>
            </a:r>
            <a:endParaRPr lang="en-US" sz="3100"/>
          </a:p>
          <a:p>
            <a:pPr>
              <a:spcBef>
                <a:spcPct val="10000"/>
              </a:spcBef>
            </a:pPr>
            <a:r>
              <a:rPr lang="en-US" altLang="en-US" sz="3100">
                <a:latin typeface="Times New Roman"/>
                <a:ea typeface="MS PGothic"/>
                <a:cs typeface="Arial"/>
              </a:rPr>
              <a:t> Global warming can revolutionize the aquatic ecosystem by disrupting plants that use turion germination to survive unfavorable conditions for growth. Here, </a:t>
            </a:r>
            <a:r>
              <a:rPr lang="en-US" altLang="en-US" sz="3100" i="1" err="1">
                <a:latin typeface="Times New Roman"/>
                <a:ea typeface="MS PGothic"/>
                <a:cs typeface="Arial"/>
              </a:rPr>
              <a:t>Spirodela</a:t>
            </a:r>
            <a:r>
              <a:rPr lang="en-US" altLang="en-US" sz="3100" i="1">
                <a:latin typeface="Times New Roman"/>
                <a:ea typeface="MS PGothic"/>
                <a:cs typeface="Arial"/>
              </a:rPr>
              <a:t> </a:t>
            </a:r>
            <a:r>
              <a:rPr lang="en-US" altLang="en-US" sz="3100" i="1" err="1">
                <a:latin typeface="Times New Roman"/>
                <a:ea typeface="MS PGothic"/>
                <a:cs typeface="Arial"/>
              </a:rPr>
              <a:t>polyrhiza</a:t>
            </a:r>
            <a:r>
              <a:rPr lang="en-US" altLang="en-US" sz="3100">
                <a:latin typeface="Times New Roman"/>
                <a:ea typeface="MS PGothic"/>
                <a:cs typeface="Arial"/>
              </a:rPr>
              <a:t>, common name giant duckweed, is examined under 3 temperature groups to determine the relationship between temperature and turion germination: 20ºC, 30ºC, &amp; 40ºC. It is predicted that 20ºC will yield the highest turion germination, while heat stress will cause low turion formation in the 40ºC temperature group. After data collection using ImageJ, a Repeated Measures ANOVA was used to determine significant between temperature groups. The control group, kept at 20ºC, mimics the actual temperature in which natural duckweed thrives. Therefore, it allowed for the most turion germination and growth. Shown by the lack of turion germination at 40ºC, the turions had to expend their energy on repairing cell damage due to heat stress, instead of using it towards germination and growth. Heat stress can devastate many species of plants so it is important to see how species will react to this change to prepare for the devastating effects of the Earth’s rising temperature. </a:t>
            </a:r>
            <a:endParaRPr lang="en-US" sz="3100"/>
          </a:p>
        </p:txBody>
      </p:sp>
      <p:sp>
        <p:nvSpPr>
          <p:cNvPr id="14340" name="Text Box 11"/>
          <p:cNvSpPr txBox="1">
            <a:spLocks noChangeArrowheads="1"/>
          </p:cNvSpPr>
          <p:nvPr/>
        </p:nvSpPr>
        <p:spPr bwMode="auto">
          <a:xfrm>
            <a:off x="787234" y="19003793"/>
            <a:ext cx="9871283" cy="10243850"/>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tabLst>
                <a:tab pos="508000"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8000"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10000"/>
              </a:spcBef>
            </a:pPr>
            <a:r>
              <a:rPr lang="en-US" sz="2900">
                <a:latin typeface="Times New Roman"/>
                <a:ea typeface="MS PGothic"/>
                <a:cs typeface="Arial"/>
              </a:rPr>
              <a:t> If global warming continues, we could see a large change in our aquatic ecosystems. Many aquatic plants use turion germination to adapt to environmental stressors and disturbances, specifically low temperatures. Under unfavorable conditions, turions release from their parent plant and become dormant at the bottom of their water source until favorable conditions arise again (</a:t>
            </a:r>
            <a:r>
              <a:rPr lang="en-US" sz="2900" err="1">
                <a:latin typeface="Times New Roman"/>
                <a:ea typeface="MS PGothic"/>
                <a:cs typeface="Arial"/>
              </a:rPr>
              <a:t>Appenroth</a:t>
            </a:r>
            <a:r>
              <a:rPr lang="en-US" sz="2900">
                <a:latin typeface="Times New Roman"/>
                <a:ea typeface="MS PGothic"/>
                <a:cs typeface="Arial"/>
              </a:rPr>
              <a:t> </a:t>
            </a:r>
            <a:r>
              <a:rPr lang="en-US" sz="2900" i="1">
                <a:latin typeface="Times New Roman"/>
                <a:ea typeface="MS PGothic"/>
                <a:cs typeface="Arial"/>
              </a:rPr>
              <a:t>et al. </a:t>
            </a:r>
            <a:r>
              <a:rPr lang="en-US" sz="2900">
                <a:latin typeface="Times New Roman"/>
                <a:ea typeface="MS PGothic"/>
                <a:cs typeface="Arial"/>
              </a:rPr>
              <a:t>1996). Increasing temperatures can cause huge shifts in aquatic environments due to the disruption of turion formation. </a:t>
            </a:r>
          </a:p>
          <a:p>
            <a:pPr>
              <a:spcBef>
                <a:spcPct val="10000"/>
              </a:spcBef>
            </a:pPr>
            <a:r>
              <a:rPr lang="en-US" sz="2900">
                <a:latin typeface="Times New Roman"/>
                <a:ea typeface="MS PGothic"/>
                <a:cs typeface="Arial"/>
              </a:rPr>
              <a:t>	Here, we will explore how temperature affects turion germination in </a:t>
            </a:r>
            <a:r>
              <a:rPr lang="en-US" sz="2900" i="1" err="1">
                <a:latin typeface="Times New Roman"/>
                <a:ea typeface="MS PGothic"/>
                <a:cs typeface="Arial"/>
              </a:rPr>
              <a:t>Spirodela</a:t>
            </a:r>
            <a:r>
              <a:rPr lang="en-US" sz="2900" i="1">
                <a:latin typeface="Times New Roman"/>
                <a:ea typeface="MS PGothic"/>
                <a:cs typeface="Arial"/>
              </a:rPr>
              <a:t> </a:t>
            </a:r>
            <a:r>
              <a:rPr lang="en-US" sz="2900" i="1" err="1">
                <a:latin typeface="Times New Roman"/>
                <a:ea typeface="MS PGothic"/>
                <a:cs typeface="Arial"/>
              </a:rPr>
              <a:t>polyrhiza</a:t>
            </a:r>
            <a:r>
              <a:rPr lang="en-US" sz="2900">
                <a:latin typeface="Times New Roman"/>
                <a:ea typeface="MS PGothic"/>
                <a:cs typeface="Arial"/>
              </a:rPr>
              <a:t>, commonly referred to as giant duckweed. Previous research has not yet used temperature as the only independent variable. Therefore, our results can indicate how populations of duckweed are directly affected by the rise in global temperatures, without discrepencies due to other factors. </a:t>
            </a:r>
          </a:p>
          <a:p>
            <a:pPr>
              <a:spcBef>
                <a:spcPct val="10000"/>
              </a:spcBef>
            </a:pPr>
            <a:r>
              <a:rPr lang="en-US" sz="2900">
                <a:latin typeface="Times New Roman"/>
                <a:ea typeface="MS PGothic"/>
                <a:cs typeface="Arial"/>
              </a:rPr>
              <a:t>	It is predicted that the control group (20ºC) will yield high turion germination, while the 40ºC temperature group will yield low turion germination (</a:t>
            </a:r>
            <a:r>
              <a:rPr lang="en-US" sz="2900" err="1">
                <a:latin typeface="Times New Roman"/>
                <a:ea typeface="MS PGothic"/>
                <a:cs typeface="Arial"/>
              </a:rPr>
              <a:t>Kuehdorf</a:t>
            </a:r>
            <a:r>
              <a:rPr lang="en-US" sz="2900">
                <a:latin typeface="Times New Roman"/>
                <a:ea typeface="MS PGothic"/>
                <a:cs typeface="Arial"/>
              </a:rPr>
              <a:t> &amp; </a:t>
            </a:r>
            <a:r>
              <a:rPr lang="en-US" sz="2900" err="1">
                <a:latin typeface="Times New Roman"/>
                <a:ea typeface="MS PGothic"/>
                <a:cs typeface="Arial"/>
              </a:rPr>
              <a:t>Appenroth</a:t>
            </a:r>
            <a:r>
              <a:rPr lang="en-US" sz="2900">
                <a:latin typeface="Times New Roman"/>
                <a:ea typeface="MS PGothic"/>
                <a:cs typeface="Arial"/>
              </a:rPr>
              <a:t> 2011). </a:t>
            </a:r>
            <a:r>
              <a:rPr lang="en-US" sz="2800">
                <a:latin typeface="Times New Roman"/>
                <a:ea typeface="MS PGothic"/>
                <a:cs typeface="Arial"/>
              </a:rPr>
              <a:t> </a:t>
            </a:r>
            <a:endParaRPr lang="en-US" altLang="en-US" sz="2800">
              <a:latin typeface="Times New Roman"/>
              <a:ea typeface="MS PGothic"/>
              <a:cs typeface="Arial"/>
            </a:endParaRPr>
          </a:p>
        </p:txBody>
      </p:sp>
      <p:sp>
        <p:nvSpPr>
          <p:cNvPr id="14341" name="Text Box 16"/>
          <p:cNvSpPr txBox="1">
            <a:spLocks noChangeArrowheads="1"/>
          </p:cNvSpPr>
          <p:nvPr/>
        </p:nvSpPr>
        <p:spPr bwMode="auto">
          <a:xfrm>
            <a:off x="32278638" y="28978049"/>
            <a:ext cx="10797763" cy="3462463"/>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endParaRPr lang="en-US">
              <a:latin typeface="Roboto"/>
              <a:ea typeface="MS PGothic"/>
              <a:cs typeface="Arial"/>
            </a:endParaRPr>
          </a:p>
          <a:p>
            <a:pPr algn="ctr"/>
            <a:r>
              <a:rPr lang="en-US" sz="3900">
                <a:latin typeface="Times New Roman"/>
                <a:ea typeface="MS PGothic"/>
                <a:cs typeface="Times New Roman"/>
              </a:rPr>
              <a:t>A special thanks to Jada Daniels, Mindy McCallum, Helen Carter, and the LSU College of Science for providing guidance and materials. </a:t>
            </a:r>
            <a:endParaRPr lang="en-US" sz="3900">
              <a:latin typeface="Times New Roman"/>
              <a:cs typeface="Times New Roman"/>
            </a:endParaRPr>
          </a:p>
        </p:txBody>
      </p:sp>
      <p:sp>
        <p:nvSpPr>
          <p:cNvPr id="14342" name="Text Box 12"/>
          <p:cNvSpPr txBox="1">
            <a:spLocks noChangeArrowheads="1"/>
          </p:cNvSpPr>
          <p:nvPr/>
        </p:nvSpPr>
        <p:spPr bwMode="auto">
          <a:xfrm>
            <a:off x="11489422" y="5360890"/>
            <a:ext cx="19869392" cy="22110982"/>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tabLst>
                <a:tab pos="500063"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0063"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9pPr>
          </a:lstStyle>
          <a:p>
            <a:pPr algn="just" eaLnBrk="1" hangingPunct="1"/>
            <a:endParaRPr lang="en-US" altLang="en-US">
              <a:latin typeface="Times New Roman"/>
              <a:ea typeface="MS PGothic"/>
              <a:cs typeface="Arial"/>
            </a:endParaRPr>
          </a:p>
        </p:txBody>
      </p:sp>
      <p:sp>
        <p:nvSpPr>
          <p:cNvPr id="14343" name="Text Box 13"/>
          <p:cNvSpPr txBox="1">
            <a:spLocks noChangeArrowheads="1"/>
          </p:cNvSpPr>
          <p:nvPr/>
        </p:nvSpPr>
        <p:spPr bwMode="auto">
          <a:xfrm>
            <a:off x="32269158" y="5423832"/>
            <a:ext cx="10837889" cy="15181410"/>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tabLst>
                <a:tab pos="635000"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635000"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r>
              <a:rPr lang="en-US" altLang="en-US">
                <a:latin typeface="Times New Roman"/>
                <a:ea typeface="MS PGothic"/>
                <a:cs typeface="Arial"/>
              </a:rPr>
              <a:t>	</a:t>
            </a:r>
            <a:r>
              <a:rPr lang="en-US" altLang="en-US" sz="3300">
                <a:latin typeface="Times New Roman"/>
                <a:ea typeface="MS PGothic"/>
                <a:cs typeface="Arial"/>
              </a:rPr>
              <a:t>Temperature was found to have a significant effect on germination in turions. Turions grown in lower temperatures showed higher levels of germination than turions grown in higher temperatures. </a:t>
            </a:r>
            <a:endParaRPr lang="en-US" altLang="en-US" sz="3300">
              <a:latin typeface="Times New Roman" panose="02020603050405020304" pitchFamily="18" charset="0"/>
            </a:endParaRPr>
          </a:p>
          <a:p>
            <a:pPr>
              <a:spcBef>
                <a:spcPct val="50000"/>
              </a:spcBef>
            </a:pPr>
            <a:r>
              <a:rPr lang="en-US" altLang="en-US" sz="3300">
                <a:latin typeface="Times New Roman"/>
                <a:ea typeface="MS PGothic"/>
                <a:cs typeface="Arial"/>
              </a:rPr>
              <a:t>	20ºC mimics the actual temperature in which duckweed thrives, allowing for optimal germination conditions. The turions growing in 40ºC plates showed little to no turion germination or growth. At this temperature, turions had to expend their energy on repairing cell damage due to heat, instead of using it towards germination and growth. </a:t>
            </a:r>
          </a:p>
          <a:p>
            <a:pPr>
              <a:spcBef>
                <a:spcPct val="50000"/>
              </a:spcBef>
            </a:pPr>
            <a:r>
              <a:rPr lang="en-US" altLang="en-US" sz="3300">
                <a:latin typeface="Times New Roman"/>
                <a:ea typeface="MS PGothic"/>
                <a:cs typeface="Arial"/>
              </a:rPr>
              <a:t>  Some limitations include temperatures fluctuations instead of steady state, presence of environmental microbes from exposure, and error in percent coverage calculations.</a:t>
            </a:r>
          </a:p>
          <a:p>
            <a:pPr>
              <a:spcBef>
                <a:spcPct val="50000"/>
              </a:spcBef>
            </a:pPr>
            <a:r>
              <a:rPr lang="en-US" altLang="en-US" sz="3300">
                <a:latin typeface="Times New Roman"/>
                <a:ea typeface="MS PGothic"/>
                <a:cs typeface="Arial"/>
              </a:rPr>
              <a:t>	This research reflects conditions plants will have to adapt to if climate change continues to cause temperatures on Earth to rise. This bodes for a scary outlook on plant life if climate change continues at the same rate.	 </a:t>
            </a:r>
          </a:p>
          <a:p>
            <a:pPr>
              <a:spcBef>
                <a:spcPct val="50000"/>
              </a:spcBef>
            </a:pPr>
            <a:r>
              <a:rPr lang="en-US" altLang="en-US" sz="3300">
                <a:latin typeface="Times New Roman"/>
                <a:ea typeface="MS PGothic"/>
                <a:cs typeface="Arial"/>
              </a:rPr>
              <a:t>	</a:t>
            </a:r>
            <a:r>
              <a:rPr lang="en-US" altLang="en-US" sz="3300" err="1">
                <a:latin typeface="Times New Roman"/>
                <a:ea typeface="MS PGothic"/>
                <a:cs typeface="Arial"/>
              </a:rPr>
              <a:t>Appenroth</a:t>
            </a:r>
            <a:r>
              <a:rPr lang="en-US" altLang="en-US" sz="3300">
                <a:latin typeface="Times New Roman"/>
                <a:ea typeface="MS PGothic"/>
                <a:cs typeface="Arial"/>
              </a:rPr>
              <a:t> 2002 experimented on </a:t>
            </a:r>
            <a:r>
              <a:rPr lang="en-US" altLang="en-US" sz="3300" i="1" err="1">
                <a:latin typeface="Times New Roman"/>
                <a:ea typeface="MS PGothic"/>
                <a:cs typeface="Arial"/>
              </a:rPr>
              <a:t>Spirodela</a:t>
            </a:r>
            <a:r>
              <a:rPr lang="en-US" altLang="en-US" sz="3300" i="1">
                <a:latin typeface="Times New Roman"/>
                <a:ea typeface="MS PGothic"/>
                <a:cs typeface="Arial"/>
              </a:rPr>
              <a:t> </a:t>
            </a:r>
            <a:r>
              <a:rPr lang="en-US" altLang="en-US" sz="3300" i="1" err="1">
                <a:latin typeface="Times New Roman"/>
                <a:ea typeface="MS PGothic"/>
                <a:cs typeface="Arial"/>
              </a:rPr>
              <a:t>polyrhiza</a:t>
            </a:r>
            <a:r>
              <a:rPr lang="en-US" altLang="en-US" sz="3300" i="1">
                <a:latin typeface="Times New Roman"/>
                <a:ea typeface="MS PGothic"/>
                <a:cs typeface="Arial"/>
              </a:rPr>
              <a:t> </a:t>
            </a:r>
            <a:r>
              <a:rPr lang="en-US" altLang="en-US" sz="3300">
                <a:latin typeface="Times New Roman"/>
                <a:ea typeface="MS PGothic"/>
                <a:cs typeface="Arial"/>
              </a:rPr>
              <a:t>but did not use temperature as their only variable. Contrary to the experiments before this one, temperature was the only independent variable tested in relation with turion germination so that the. Our results will serve as evidence that temperature has significant effects on germination in turions. </a:t>
            </a:r>
            <a:endParaRPr lang="en-US" altLang="en-US" sz="3300">
              <a:latin typeface="Times New Roman" panose="02020603050405020304" pitchFamily="18" charset="0"/>
            </a:endParaRPr>
          </a:p>
        </p:txBody>
      </p:sp>
      <p:sp>
        <p:nvSpPr>
          <p:cNvPr id="12" name="Rectangle 6"/>
          <p:cNvSpPr>
            <a:spLocks noChangeArrowheads="1"/>
          </p:cNvSpPr>
          <p:nvPr/>
        </p:nvSpPr>
        <p:spPr bwMode="auto">
          <a:xfrm>
            <a:off x="0" y="-1"/>
            <a:ext cx="43891200" cy="4086225"/>
          </a:xfrm>
          <a:prstGeom prst="rect">
            <a:avLst/>
          </a:prstGeom>
          <a:gradFill flip="none" rotWithShape="1">
            <a:gsLst>
              <a:gs pos="0">
                <a:schemeClr val="accent2">
                  <a:lumMod val="60000"/>
                  <a:lumOff val="40000"/>
                </a:schemeClr>
              </a:gs>
              <a:gs pos="48000">
                <a:schemeClr val="accent2">
                  <a:lumMod val="97000"/>
                  <a:lumOff val="3000"/>
                </a:schemeClr>
              </a:gs>
              <a:gs pos="100000">
                <a:schemeClr val="accent2">
                  <a:lumMod val="60000"/>
                  <a:lumOff val="40000"/>
                </a:schemeClr>
              </a:gs>
            </a:gsLst>
            <a:lin ang="16200000" scaled="1"/>
            <a:tileRect/>
          </a:gradFill>
          <a:ln w="38100">
            <a:noFill/>
            <a:miter lim="800000"/>
            <a:headEnd/>
            <a:tailEnd/>
          </a:ln>
        </p:spPr>
        <p:txBody>
          <a:bodyPr lIns="137160" tIns="68580" rIns="137160" bIns="68580" anchor="ctr"/>
          <a:lstStyle/>
          <a:p>
            <a:pPr algn="ctr" defTabSz="4703763">
              <a:spcAft>
                <a:spcPts val="600"/>
              </a:spcAft>
              <a:defRPr/>
            </a:pPr>
            <a:r>
              <a:rPr lang="en-US" sz="8800" b="1">
                <a:latin typeface="+mj-lt"/>
              </a:rPr>
              <a:t>Effect of Temperature on Turion Germination in </a:t>
            </a:r>
            <a:r>
              <a:rPr lang="en-US" sz="8800" b="1" i="1">
                <a:latin typeface="+mj-lt"/>
              </a:rPr>
              <a:t>Spirodela Polyrhiza</a:t>
            </a:r>
          </a:p>
          <a:p>
            <a:pPr algn="ctr" defTabSz="4703763">
              <a:spcAft>
                <a:spcPts val="600"/>
              </a:spcAft>
              <a:defRPr/>
            </a:pPr>
            <a:r>
              <a:rPr lang="en-US" sz="3600" b="1">
                <a:latin typeface="+mj-lt"/>
                <a:cs typeface="Times New Roman" pitchFamily="18" charset="0"/>
              </a:rPr>
              <a:t>Charlotte Robinson, Kassidy Herrin, </a:t>
            </a:r>
            <a:r>
              <a:rPr lang="en-US" sz="3600" b="1" err="1">
                <a:latin typeface="+mj-lt"/>
                <a:cs typeface="Times New Roman" pitchFamily="18" charset="0"/>
              </a:rPr>
              <a:t>Zainalabedeen</a:t>
            </a:r>
            <a:r>
              <a:rPr lang="en-US" sz="3600" b="1">
                <a:latin typeface="+mj-lt"/>
                <a:cs typeface="Times New Roman" pitchFamily="18" charset="0"/>
              </a:rPr>
              <a:t> Al </a:t>
            </a:r>
            <a:r>
              <a:rPr lang="en-US" sz="3600" b="1" err="1">
                <a:latin typeface="+mj-lt"/>
                <a:cs typeface="Times New Roman" pitchFamily="18" charset="0"/>
              </a:rPr>
              <a:t>Naseri</a:t>
            </a:r>
            <a:endParaRPr lang="en-US" sz="3600" b="1">
              <a:latin typeface="+mj-lt"/>
              <a:cs typeface="Times New Roman" pitchFamily="18" charset="0"/>
            </a:endParaRPr>
          </a:p>
          <a:p>
            <a:pPr algn="ctr" defTabSz="4703763">
              <a:spcAft>
                <a:spcPts val="600"/>
              </a:spcAft>
              <a:defRPr/>
            </a:pPr>
            <a:r>
              <a:rPr lang="en-US" sz="3600" b="1">
                <a:latin typeface="+mj-lt"/>
                <a:cs typeface="Times New Roman" pitchFamily="18" charset="0"/>
              </a:rPr>
              <a:t>Dept. of Biological Sciences, Louisiana State University, Baton Rouge, LA 70803</a:t>
            </a:r>
          </a:p>
        </p:txBody>
      </p:sp>
      <p:pic>
        <p:nvPicPr>
          <p:cNvPr id="13" name="Picture 12">
            <a:extLst>
              <a:ext uri="{FF2B5EF4-FFF2-40B4-BE49-F238E27FC236}">
                <a16:creationId xmlns:a16="http://schemas.microsoft.com/office/drawing/2014/main" id="{0D970357-180A-4FD6-82C1-FA8CE267D04C}"/>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4000"/>
                    </a14:imgEffect>
                  </a14:imgLayer>
                </a14:imgProps>
              </a:ext>
            </a:extLst>
          </a:blip>
          <a:stretch>
            <a:fillRect/>
          </a:stretch>
        </p:blipFill>
        <p:spPr>
          <a:xfrm>
            <a:off x="40323688" y="902697"/>
            <a:ext cx="2983831" cy="2640603"/>
          </a:xfrm>
          <a:prstGeom prst="rect">
            <a:avLst/>
          </a:prstGeom>
        </p:spPr>
      </p:pic>
      <p:sp>
        <p:nvSpPr>
          <p:cNvPr id="14" name="Rectangle 7"/>
          <p:cNvSpPr>
            <a:spLocks noChangeArrowheads="1"/>
          </p:cNvSpPr>
          <p:nvPr/>
        </p:nvSpPr>
        <p:spPr bwMode="auto">
          <a:xfrm>
            <a:off x="812164" y="4678764"/>
            <a:ext cx="9933322"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Abstract</a:t>
            </a:r>
          </a:p>
        </p:txBody>
      </p:sp>
      <p:sp>
        <p:nvSpPr>
          <p:cNvPr id="15" name="Rectangle 7"/>
          <p:cNvSpPr>
            <a:spLocks noChangeArrowheads="1"/>
          </p:cNvSpPr>
          <p:nvPr/>
        </p:nvSpPr>
        <p:spPr bwMode="auto">
          <a:xfrm>
            <a:off x="800453" y="18164444"/>
            <a:ext cx="9858065"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Introduction</a:t>
            </a:r>
          </a:p>
        </p:txBody>
      </p:sp>
      <p:sp>
        <p:nvSpPr>
          <p:cNvPr id="16" name="Rectangle 7"/>
          <p:cNvSpPr>
            <a:spLocks noChangeArrowheads="1"/>
          </p:cNvSpPr>
          <p:nvPr/>
        </p:nvSpPr>
        <p:spPr bwMode="auto">
          <a:xfrm>
            <a:off x="11489984" y="12527371"/>
            <a:ext cx="19878371" cy="994194"/>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Results</a:t>
            </a:r>
          </a:p>
        </p:txBody>
      </p:sp>
      <p:sp>
        <p:nvSpPr>
          <p:cNvPr id="17" name="Rectangle 7"/>
          <p:cNvSpPr>
            <a:spLocks noChangeArrowheads="1"/>
          </p:cNvSpPr>
          <p:nvPr/>
        </p:nvSpPr>
        <p:spPr bwMode="auto">
          <a:xfrm>
            <a:off x="32264650" y="4656580"/>
            <a:ext cx="10891055"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Conclusions</a:t>
            </a:r>
          </a:p>
        </p:txBody>
      </p:sp>
      <p:sp>
        <p:nvSpPr>
          <p:cNvPr id="19" name="Text Box 16"/>
          <p:cNvSpPr txBox="1">
            <a:spLocks noChangeArrowheads="1"/>
          </p:cNvSpPr>
          <p:nvPr/>
        </p:nvSpPr>
        <p:spPr bwMode="auto">
          <a:xfrm>
            <a:off x="11501902" y="28391715"/>
            <a:ext cx="19881619" cy="4045419"/>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r>
              <a:rPr lang="en-US" sz="3100">
                <a:latin typeface="Times New Roman"/>
                <a:ea typeface="MS PGothic"/>
                <a:cs typeface="Times New Roman"/>
              </a:rPr>
              <a:t>Appenroth, K. J., Teller, S., &amp; Horn, M. (1996). Photophysiology of turion formation and germination in Spirodela 	polyrhiza. </a:t>
            </a:r>
            <a:r>
              <a:rPr lang="en-US" sz="3100" i="1">
                <a:latin typeface="Times New Roman"/>
                <a:ea typeface="MS PGothic"/>
                <a:cs typeface="Times New Roman"/>
              </a:rPr>
              <a:t>Biologia plantarum</a:t>
            </a:r>
            <a:r>
              <a:rPr lang="en-US" sz="3100">
                <a:latin typeface="Times New Roman"/>
                <a:ea typeface="MS PGothic"/>
                <a:cs typeface="Times New Roman"/>
              </a:rPr>
              <a:t>, </a:t>
            </a:r>
            <a:r>
              <a:rPr lang="en-US" sz="3100" i="1">
                <a:latin typeface="Times New Roman"/>
                <a:ea typeface="MS PGothic"/>
                <a:cs typeface="Times New Roman"/>
              </a:rPr>
              <a:t>38</a:t>
            </a:r>
            <a:r>
              <a:rPr lang="en-US" sz="3100">
                <a:latin typeface="Times New Roman"/>
                <a:ea typeface="MS PGothic"/>
                <a:cs typeface="Times New Roman"/>
              </a:rPr>
              <a:t>, 95-106. </a:t>
            </a:r>
            <a:r>
              <a:rPr lang="en-US" sz="3100">
                <a:solidFill>
                  <a:srgbClr val="000000"/>
                </a:solidFill>
                <a:effectLst/>
                <a:latin typeface="Times New Roman"/>
                <a:ea typeface="Aptos" panose="020B0004020202020204" pitchFamily="34" charset="0"/>
                <a:cs typeface="Times New Roman"/>
              </a:rPr>
              <a:t>doi:10.1007/bf02879642</a:t>
            </a:r>
            <a:endParaRPr lang="en-US" sz="3100">
              <a:latin typeface="Times New Roman"/>
              <a:ea typeface="MS PGothic"/>
              <a:cs typeface="Times New Roman"/>
            </a:endParaRPr>
          </a:p>
          <a:p>
            <a:r>
              <a:rPr lang="en-US" sz="3100">
                <a:latin typeface="Times New Roman"/>
                <a:ea typeface="MS PGothic"/>
                <a:cs typeface="Times New Roman"/>
              </a:rPr>
              <a:t>Appenroth, K. J. (2002). Co‐action of temperature and phosphate in inducing turion formation in Spirodela 	polyrhiza (Great 	duckweed). </a:t>
            </a:r>
            <a:r>
              <a:rPr lang="en-US" sz="3100" i="1">
                <a:latin typeface="Times New Roman"/>
                <a:ea typeface="MS PGothic"/>
                <a:cs typeface="Times New Roman"/>
              </a:rPr>
              <a:t>Plant, Cell &amp; Environment</a:t>
            </a:r>
            <a:r>
              <a:rPr lang="en-US" sz="3100">
                <a:latin typeface="Times New Roman"/>
                <a:ea typeface="MS PGothic"/>
                <a:cs typeface="Times New Roman"/>
              </a:rPr>
              <a:t>, </a:t>
            </a:r>
            <a:r>
              <a:rPr lang="en-US" sz="3100" i="1">
                <a:latin typeface="Times New Roman"/>
                <a:ea typeface="MS PGothic"/>
                <a:cs typeface="Times New Roman"/>
              </a:rPr>
              <a:t>25</a:t>
            </a:r>
            <a:r>
              <a:rPr lang="en-US" sz="3100">
                <a:latin typeface="Times New Roman"/>
                <a:ea typeface="MS PGothic"/>
                <a:cs typeface="Times New Roman"/>
              </a:rPr>
              <a:t>(9), 1079-1085. </a:t>
            </a:r>
            <a:r>
              <a:rPr lang="en-US" sz="3100">
                <a:solidFill>
                  <a:srgbClr val="000000"/>
                </a:solidFill>
                <a:effectLst/>
                <a:latin typeface="Times New Roman"/>
                <a:ea typeface="Aptos" panose="020B0004020202020204" pitchFamily="34" charset="0"/>
                <a:cs typeface="Times New Roman"/>
              </a:rPr>
              <a:t>doi:10.1046/j.1365-	3040.2002.00885.x</a:t>
            </a:r>
            <a:endParaRPr lang="en-US" sz="3100">
              <a:latin typeface="Times New Roman"/>
              <a:ea typeface="MS PGothic"/>
              <a:cs typeface="Times New Roman"/>
            </a:endParaRPr>
          </a:p>
          <a:p>
            <a:r>
              <a:rPr lang="en-US" sz="3100">
                <a:solidFill>
                  <a:srgbClr val="000000"/>
                </a:solidFill>
                <a:effectLst/>
                <a:latin typeface="Times New Roman"/>
                <a:ea typeface="Aptos" panose="020B0004020202020204" pitchFamily="34" charset="0"/>
                <a:cs typeface="Times New Roman"/>
              </a:rPr>
              <a:t>Kuehdorf, K., &amp; Appenroth, K.-J. (2011). Influence of salinity and high temperature on Turion formation in the 	duckweed spirodela polyrhiza. </a:t>
            </a:r>
            <a:r>
              <a:rPr lang="en-US" sz="3100" i="1">
                <a:solidFill>
                  <a:srgbClr val="000000"/>
                </a:solidFill>
                <a:effectLst/>
                <a:latin typeface="Times New Roman"/>
                <a:ea typeface="Aptos" panose="020B0004020202020204" pitchFamily="34" charset="0"/>
                <a:cs typeface="Times New Roman"/>
              </a:rPr>
              <a:t>Aquatic Botany</a:t>
            </a:r>
            <a:r>
              <a:rPr lang="en-US" sz="3100">
                <a:solidFill>
                  <a:srgbClr val="000000"/>
                </a:solidFill>
                <a:effectLst/>
                <a:latin typeface="Times New Roman"/>
                <a:ea typeface="Aptos" panose="020B0004020202020204" pitchFamily="34" charset="0"/>
                <a:cs typeface="Times New Roman"/>
              </a:rPr>
              <a:t>, </a:t>
            </a:r>
            <a:r>
              <a:rPr lang="en-US" sz="3100" i="1">
                <a:solidFill>
                  <a:srgbClr val="000000"/>
                </a:solidFill>
                <a:effectLst/>
                <a:latin typeface="Times New Roman"/>
                <a:ea typeface="Aptos" panose="020B0004020202020204" pitchFamily="34" charset="0"/>
                <a:cs typeface="Times New Roman"/>
              </a:rPr>
              <a:t>97</a:t>
            </a:r>
            <a:r>
              <a:rPr lang="en-US" sz="3100">
                <a:solidFill>
                  <a:srgbClr val="000000"/>
                </a:solidFill>
                <a:effectLst/>
                <a:latin typeface="Times New Roman"/>
                <a:ea typeface="Aptos" panose="020B0004020202020204" pitchFamily="34" charset="0"/>
                <a:cs typeface="Times New Roman"/>
              </a:rPr>
              <a:t>(1), 69–72. doi:10.1016/j.aquabot.2011.10.003</a:t>
            </a:r>
            <a:r>
              <a:rPr lang="en-US" sz="3100">
                <a:latin typeface="Times New Roman"/>
                <a:ea typeface="MS PGothic"/>
                <a:cs typeface="Times New Roman"/>
              </a:rPr>
              <a:t> </a:t>
            </a:r>
            <a:endParaRPr lang="en-US" altLang="en-US" sz="3100">
              <a:latin typeface="Times New Roman" panose="02020603050405020304" pitchFamily="18" charset="0"/>
              <a:cs typeface="Times New Roman" panose="02020603050405020304" pitchFamily="18" charset="0"/>
            </a:endParaRPr>
          </a:p>
        </p:txBody>
      </p:sp>
      <p:sp>
        <p:nvSpPr>
          <p:cNvPr id="20" name="Rectangle 7"/>
          <p:cNvSpPr>
            <a:spLocks noChangeArrowheads="1"/>
          </p:cNvSpPr>
          <p:nvPr/>
        </p:nvSpPr>
        <p:spPr bwMode="auto">
          <a:xfrm>
            <a:off x="32292841" y="28908272"/>
            <a:ext cx="10809939" cy="898845"/>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Acknowledgements</a:t>
            </a:r>
          </a:p>
        </p:txBody>
      </p:sp>
      <p:pic>
        <p:nvPicPr>
          <p:cNvPr id="21" name="Picture 4" descr="2colorVertGold"/>
          <p:cNvPicPr>
            <a:picLocks noChangeAspect="1" noChangeArrowheads="1"/>
          </p:cNvPicPr>
          <p:nvPr/>
        </p:nvPicPr>
        <p:blipFill>
          <a:blip r:embed="rId5" cstate="print">
            <a:clrChange>
              <a:clrFrom>
                <a:srgbClr val="FFFFFF"/>
              </a:clrFrom>
              <a:clrTo>
                <a:srgbClr val="FFFFFF">
                  <a:alpha val="0"/>
                </a:srgbClr>
              </a:clrTo>
            </a:clrChange>
          </a:blip>
          <a:srcRect/>
          <a:stretch>
            <a:fillRect/>
          </a:stretch>
        </p:blipFill>
        <p:spPr bwMode="auto">
          <a:xfrm>
            <a:off x="888481" y="461147"/>
            <a:ext cx="2108517" cy="3402821"/>
          </a:xfrm>
          <a:prstGeom prst="rect">
            <a:avLst/>
          </a:prstGeom>
          <a:noFill/>
          <a:ln w="9525">
            <a:noFill/>
            <a:miter lim="800000"/>
            <a:headEnd/>
            <a:tailEnd/>
          </a:ln>
        </p:spPr>
      </p:pic>
      <p:sp>
        <p:nvSpPr>
          <p:cNvPr id="23" name="Rectangle 7"/>
          <p:cNvSpPr>
            <a:spLocks noChangeArrowheads="1"/>
          </p:cNvSpPr>
          <p:nvPr/>
        </p:nvSpPr>
        <p:spPr bwMode="auto">
          <a:xfrm>
            <a:off x="32269158" y="21124324"/>
            <a:ext cx="10836948" cy="985205"/>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Future Directions</a:t>
            </a:r>
          </a:p>
        </p:txBody>
      </p:sp>
      <p:sp>
        <p:nvSpPr>
          <p:cNvPr id="2" name="Rectangle 7">
            <a:extLst>
              <a:ext uri="{FF2B5EF4-FFF2-40B4-BE49-F238E27FC236}">
                <a16:creationId xmlns:a16="http://schemas.microsoft.com/office/drawing/2014/main" id="{C391A11A-2981-C111-5347-6F129B8F65AF}"/>
              </a:ext>
            </a:extLst>
          </p:cNvPr>
          <p:cNvSpPr>
            <a:spLocks noChangeArrowheads="1"/>
          </p:cNvSpPr>
          <p:nvPr/>
        </p:nvSpPr>
        <p:spPr bwMode="auto">
          <a:xfrm>
            <a:off x="11475656" y="4697521"/>
            <a:ext cx="19826301"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Methods</a:t>
            </a:r>
          </a:p>
        </p:txBody>
      </p:sp>
      <p:sp>
        <p:nvSpPr>
          <p:cNvPr id="3" name="Rectangle 7">
            <a:extLst>
              <a:ext uri="{FF2B5EF4-FFF2-40B4-BE49-F238E27FC236}">
                <a16:creationId xmlns:a16="http://schemas.microsoft.com/office/drawing/2014/main" id="{57203A09-E0E1-3B0B-8F2F-EDFB121ED264}"/>
              </a:ext>
            </a:extLst>
          </p:cNvPr>
          <p:cNvSpPr>
            <a:spLocks noChangeArrowheads="1"/>
          </p:cNvSpPr>
          <p:nvPr/>
        </p:nvSpPr>
        <p:spPr bwMode="auto">
          <a:xfrm>
            <a:off x="11473776" y="27451515"/>
            <a:ext cx="19922553"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cs typeface="Arial"/>
              </a:rPr>
              <a:t>References</a:t>
            </a:r>
            <a:endParaRPr lang="en-US" sz="5700" b="1">
              <a:solidFill>
                <a:schemeClr val="bg1"/>
              </a:solidFill>
              <a:latin typeface="Gill Sans"/>
            </a:endParaRPr>
          </a:p>
        </p:txBody>
      </p:sp>
      <p:sp>
        <p:nvSpPr>
          <p:cNvPr id="4" name="Text Box 16">
            <a:extLst>
              <a:ext uri="{FF2B5EF4-FFF2-40B4-BE49-F238E27FC236}">
                <a16:creationId xmlns:a16="http://schemas.microsoft.com/office/drawing/2014/main" id="{217DAC3D-373F-6075-9EF8-904BF8427108}"/>
              </a:ext>
            </a:extLst>
          </p:cNvPr>
          <p:cNvSpPr txBox="1">
            <a:spLocks noChangeArrowheads="1"/>
          </p:cNvSpPr>
          <p:nvPr/>
        </p:nvSpPr>
        <p:spPr bwMode="auto">
          <a:xfrm>
            <a:off x="888481" y="30560209"/>
            <a:ext cx="9792830" cy="1876925"/>
          </a:xfrm>
          <a:prstGeom prst="rect">
            <a:avLst/>
          </a:prstGeom>
          <a:solidFill>
            <a:schemeClr val="bg1"/>
          </a:solidFill>
          <a:ln w="38100">
            <a:solidFill>
              <a:schemeClr val="tx1"/>
            </a:solidFill>
            <a:round/>
            <a:headEnd/>
            <a:tailEnd/>
          </a:ln>
        </p:spPr>
        <p:txBody>
          <a:bodyPr lIns="783771" tIns="391886" rIns="783771" bIns="783771" anchor="t"/>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algn="ctr"/>
            <a:r>
              <a:rPr lang="en-US" sz="4400">
                <a:latin typeface="Times New Roman" panose="02020603050405020304" pitchFamily="18" charset="0"/>
                <a:ea typeface="MS PGothic"/>
                <a:cs typeface="Times New Roman" panose="02020603050405020304" pitchFamily="18" charset="0"/>
              </a:rPr>
              <a:t>How does temperature affect turion germination in </a:t>
            </a:r>
            <a:r>
              <a:rPr lang="en-US" sz="4400" i="1">
                <a:latin typeface="Times New Roman" panose="02020603050405020304" pitchFamily="18" charset="0"/>
                <a:ea typeface="MS PGothic"/>
                <a:cs typeface="Times New Roman" panose="02020603050405020304" pitchFamily="18" charset="0"/>
              </a:rPr>
              <a:t>Spirodela polyrhiza?</a:t>
            </a:r>
            <a:endParaRPr lang="en-US" sz="4400">
              <a:latin typeface="Times New Roman" panose="02020603050405020304" pitchFamily="18" charset="0"/>
              <a:cs typeface="Times New Roman" panose="02020603050405020304" pitchFamily="18" charset="0"/>
            </a:endParaRPr>
          </a:p>
        </p:txBody>
      </p:sp>
      <p:sp>
        <p:nvSpPr>
          <p:cNvPr id="5" name="Rectangle 7">
            <a:extLst>
              <a:ext uri="{FF2B5EF4-FFF2-40B4-BE49-F238E27FC236}">
                <a16:creationId xmlns:a16="http://schemas.microsoft.com/office/drawing/2014/main" id="{F32B9F2F-C767-75A6-AE69-6C7D0946C632}"/>
              </a:ext>
            </a:extLst>
          </p:cNvPr>
          <p:cNvSpPr>
            <a:spLocks noChangeArrowheads="1"/>
          </p:cNvSpPr>
          <p:nvPr/>
        </p:nvSpPr>
        <p:spPr bwMode="auto">
          <a:xfrm>
            <a:off x="888482" y="29872177"/>
            <a:ext cx="9792830"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a:solidFill>
                  <a:schemeClr val="bg1"/>
                </a:solidFill>
                <a:latin typeface="Gill Sans"/>
              </a:rPr>
              <a:t>Research Question</a:t>
            </a:r>
          </a:p>
        </p:txBody>
      </p:sp>
      <p:graphicFrame>
        <p:nvGraphicFramePr>
          <p:cNvPr id="11" name="Table 10">
            <a:extLst>
              <a:ext uri="{FF2B5EF4-FFF2-40B4-BE49-F238E27FC236}">
                <a16:creationId xmlns:a16="http://schemas.microsoft.com/office/drawing/2014/main" id="{65AEACB9-B21E-7C82-A5B3-68920EEDC493}"/>
              </a:ext>
            </a:extLst>
          </p:cNvPr>
          <p:cNvGraphicFramePr>
            <a:graphicFrameLocks noGrp="1"/>
          </p:cNvGraphicFramePr>
          <p:nvPr>
            <p:extLst>
              <p:ext uri="{D42A27DB-BD31-4B8C-83A1-F6EECF244321}">
                <p14:modId xmlns:p14="http://schemas.microsoft.com/office/powerpoint/2010/main" val="2053045883"/>
              </p:ext>
            </p:extLst>
          </p:nvPr>
        </p:nvGraphicFramePr>
        <p:xfrm>
          <a:off x="12685253" y="23696588"/>
          <a:ext cx="7783361" cy="3302329"/>
        </p:xfrm>
        <a:graphic>
          <a:graphicData uri="http://schemas.openxmlformats.org/drawingml/2006/table">
            <a:tbl>
              <a:tblPr firstRow="1" firstCol="1" bandRow="1">
                <a:tableStyleId>{21E4AEA4-8DFA-4A89-87EB-49C32662AFE0}</a:tableStyleId>
              </a:tblPr>
              <a:tblGrid>
                <a:gridCol w="1874345">
                  <a:extLst>
                    <a:ext uri="{9D8B030D-6E8A-4147-A177-3AD203B41FA5}">
                      <a16:colId xmlns:a16="http://schemas.microsoft.com/office/drawing/2014/main" val="1936743591"/>
                    </a:ext>
                  </a:extLst>
                </a:gridCol>
                <a:gridCol w="1290013">
                  <a:extLst>
                    <a:ext uri="{9D8B030D-6E8A-4147-A177-3AD203B41FA5}">
                      <a16:colId xmlns:a16="http://schemas.microsoft.com/office/drawing/2014/main" val="3044420794"/>
                    </a:ext>
                  </a:extLst>
                </a:gridCol>
                <a:gridCol w="1528847">
                  <a:extLst>
                    <a:ext uri="{9D8B030D-6E8A-4147-A177-3AD203B41FA5}">
                      <a16:colId xmlns:a16="http://schemas.microsoft.com/office/drawing/2014/main" val="4294379105"/>
                    </a:ext>
                  </a:extLst>
                </a:gridCol>
                <a:gridCol w="1523436">
                  <a:extLst>
                    <a:ext uri="{9D8B030D-6E8A-4147-A177-3AD203B41FA5}">
                      <a16:colId xmlns:a16="http://schemas.microsoft.com/office/drawing/2014/main" val="1685022549"/>
                    </a:ext>
                  </a:extLst>
                </a:gridCol>
                <a:gridCol w="1566720">
                  <a:extLst>
                    <a:ext uri="{9D8B030D-6E8A-4147-A177-3AD203B41FA5}">
                      <a16:colId xmlns:a16="http://schemas.microsoft.com/office/drawing/2014/main" val="764189798"/>
                    </a:ext>
                  </a:extLst>
                </a:gridCol>
              </a:tblGrid>
              <a:tr h="728102">
                <a:tc>
                  <a:txBody>
                    <a:bodyPr/>
                    <a:lstStyle/>
                    <a:p>
                      <a:pPr marL="0" marR="0" algn="ctr">
                        <a:lnSpc>
                          <a:spcPct val="200000"/>
                        </a:lnSpc>
                        <a:spcBef>
                          <a:spcPts val="0"/>
                        </a:spcBef>
                        <a:spcAft>
                          <a:spcPts val="0"/>
                        </a:spcAft>
                      </a:pPr>
                      <a:endParaRPr lang="en-US" sz="1800">
                        <a:effectLst/>
                        <a:latin typeface="Times New Roman" panose="02020603050405020304" pitchFamily="18" charset="0"/>
                        <a:ea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F-value</a:t>
                      </a:r>
                      <a:endParaRPr lang="en-US" sz="1800" dirty="0" err="1">
                        <a:effectLst/>
                        <a:latin typeface="Times New Roman" panose="02020603050405020304" pitchFamily="18" charset="0"/>
                        <a:ea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Num DF</a:t>
                      </a:r>
                    </a:p>
                  </a:txBody>
                  <a:tcPr marL="68580" marR="68580" marT="0" marB="0"/>
                </a:tc>
                <a:tc>
                  <a:txBody>
                    <a:bodyPr/>
                    <a:lstStyle/>
                    <a:p>
                      <a:pPr marL="0" marR="0" algn="ctr">
                        <a:lnSpc>
                          <a:spcPct val="200000"/>
                        </a:lnSpc>
                        <a:spcBef>
                          <a:spcPts val="0"/>
                        </a:spcBef>
                        <a:spcAft>
                          <a:spcPts val="0"/>
                        </a:spcAft>
                      </a:pPr>
                      <a:r>
                        <a:rPr lang="en-US" sz="1800" dirty="0">
                          <a:effectLst/>
                        </a:rPr>
                        <a:t>Density DF</a:t>
                      </a:r>
                    </a:p>
                  </a:txBody>
                  <a:tcPr marL="68580" marR="68580" marT="0" marB="0"/>
                </a:tc>
                <a:tc>
                  <a:txBody>
                    <a:bodyPr/>
                    <a:lstStyle/>
                    <a:p>
                      <a:pPr marL="0" marR="0" algn="ctr">
                        <a:lnSpc>
                          <a:spcPct val="200000"/>
                        </a:lnSpc>
                        <a:spcBef>
                          <a:spcPts val="0"/>
                        </a:spcBef>
                        <a:spcAft>
                          <a:spcPts val="0"/>
                        </a:spcAft>
                      </a:pPr>
                      <a:r>
                        <a:rPr lang="en-US" sz="1800" dirty="0">
                          <a:effectLst/>
                        </a:rPr>
                        <a:t>PR(&gt;F)</a:t>
                      </a:r>
                      <a:endParaRPr lang="en-US" sz="1800" dirty="0">
                        <a:effectLst/>
                        <a:latin typeface="Times New Roman" panose="02020603050405020304" pitchFamily="18" charset="0"/>
                        <a:ea typeface="Times New Roman" panose="02020603050405020304" pitchFamily="18" charset="0"/>
                      </a:endParaRPr>
                    </a:p>
                  </a:txBody>
                  <a:tcPr marL="68580" marR="68580" marT="0" marB="0"/>
                </a:tc>
                <a:extLst>
                  <a:ext uri="{0D108BD9-81ED-4DB2-BD59-A6C34878D82A}">
                    <a16:rowId xmlns:a16="http://schemas.microsoft.com/office/drawing/2014/main" val="3315152622"/>
                  </a:ext>
                </a:extLst>
              </a:tr>
              <a:tr h="728102">
                <a:tc>
                  <a:txBody>
                    <a:bodyPr/>
                    <a:lstStyle/>
                    <a:p>
                      <a:pPr marL="0" marR="0" algn="ctr">
                        <a:lnSpc>
                          <a:spcPct val="200000"/>
                        </a:lnSpc>
                        <a:spcBef>
                          <a:spcPts val="0"/>
                        </a:spcBef>
                        <a:spcAft>
                          <a:spcPts val="0"/>
                        </a:spcAft>
                      </a:pPr>
                      <a:r>
                        <a:rPr lang="en-US" sz="1800" dirty="0">
                          <a:effectLst/>
                        </a:rPr>
                        <a:t>Day </a:t>
                      </a:r>
                      <a:br>
                        <a:rPr lang="en-US" sz="1800" dirty="0">
                          <a:effectLst/>
                        </a:rPr>
                      </a:br>
                      <a:r>
                        <a:rPr lang="en-US" sz="1800" dirty="0">
                          <a:effectLst/>
                        </a:rPr>
                        <a:t>(Percent Coverage)</a:t>
                      </a:r>
                      <a:endParaRPr lang="en-US" sz="1800" dirty="0">
                        <a:effectLst/>
                        <a:latin typeface="Times New Roman"/>
                        <a:ea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26.7159</a:t>
                      </a:r>
                    </a:p>
                  </a:txBody>
                  <a:tcPr marL="68580" marR="68580" marT="0" marB="0"/>
                </a:tc>
                <a:tc>
                  <a:txBody>
                    <a:bodyPr/>
                    <a:lstStyle/>
                    <a:p>
                      <a:pPr marL="0" marR="0" algn="ctr">
                        <a:lnSpc>
                          <a:spcPct val="200000"/>
                        </a:lnSpc>
                        <a:spcBef>
                          <a:spcPts val="0"/>
                        </a:spcBef>
                        <a:spcAft>
                          <a:spcPts val="0"/>
                        </a:spcAft>
                      </a:pPr>
                      <a:r>
                        <a:rPr lang="en-US" sz="1800" dirty="0">
                          <a:effectLst/>
                        </a:rPr>
                        <a:t>3.000</a:t>
                      </a:r>
                      <a:endParaRPr lang="en-US" sz="1800" dirty="0">
                        <a:effectLst/>
                        <a:latin typeface="Times New Roman" panose="02020603050405020304" pitchFamily="18" charset="0"/>
                        <a:ea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51.000</a:t>
                      </a:r>
                    </a:p>
                  </a:txBody>
                  <a:tcPr marL="68580" marR="68580" marT="0" marB="0"/>
                </a:tc>
                <a:tc>
                  <a:txBody>
                    <a:bodyPr/>
                    <a:lstStyle/>
                    <a:p>
                      <a:pPr marL="0" marR="0" lvl="0" algn="ctr">
                        <a:lnSpc>
                          <a:spcPct val="200000"/>
                        </a:lnSpc>
                        <a:spcBef>
                          <a:spcPts val="0"/>
                        </a:spcBef>
                        <a:spcAft>
                          <a:spcPts val="0"/>
                        </a:spcAft>
                        <a:buNone/>
                      </a:pPr>
                      <a:r>
                        <a:rPr lang="en-US" sz="1800" dirty="0">
                          <a:effectLst/>
                        </a:rPr>
                        <a:t>0.000*</a:t>
                      </a:r>
                    </a:p>
                  </a:txBody>
                  <a:tcPr marL="68580" marR="68580" marT="0" marB="0"/>
                </a:tc>
                <a:extLst>
                  <a:ext uri="{0D108BD9-81ED-4DB2-BD59-A6C34878D82A}">
                    <a16:rowId xmlns:a16="http://schemas.microsoft.com/office/drawing/2014/main" val="510907201"/>
                  </a:ext>
                </a:extLst>
              </a:tr>
              <a:tr h="728102">
                <a:tc>
                  <a:txBody>
                    <a:bodyPr/>
                    <a:lstStyle/>
                    <a:p>
                      <a:pPr marL="0" marR="0" algn="ctr">
                        <a:lnSpc>
                          <a:spcPct val="200000"/>
                        </a:lnSpc>
                        <a:spcBef>
                          <a:spcPts val="0"/>
                        </a:spcBef>
                        <a:spcAft>
                          <a:spcPts val="0"/>
                        </a:spcAft>
                      </a:pPr>
                      <a:r>
                        <a:rPr lang="en-US" sz="1800" dirty="0">
                          <a:effectLst/>
                        </a:rPr>
                        <a:t>Day (Frond Count)</a:t>
                      </a:r>
                      <a:endParaRPr lang="en-US" dirty="0"/>
                    </a:p>
                  </a:txBody>
                  <a:tcPr marL="68580" marR="68580" marT="0" marB="0"/>
                </a:tc>
                <a:tc>
                  <a:txBody>
                    <a:bodyPr/>
                    <a:lstStyle/>
                    <a:p>
                      <a:pPr marL="0" marR="0" lvl="0" algn="ctr">
                        <a:lnSpc>
                          <a:spcPct val="200000"/>
                        </a:lnSpc>
                        <a:spcBef>
                          <a:spcPts val="0"/>
                        </a:spcBef>
                        <a:spcAft>
                          <a:spcPts val="0"/>
                        </a:spcAft>
                        <a:buNone/>
                      </a:pPr>
                      <a:r>
                        <a:rPr lang="en-US" sz="1800" dirty="0">
                          <a:effectLst/>
                        </a:rPr>
                        <a:t>28.8425</a:t>
                      </a:r>
                      <a:endParaRPr lang="en-US" dirty="0"/>
                    </a:p>
                  </a:txBody>
                  <a:tcPr marL="68580" marR="68580" marT="0" marB="0"/>
                </a:tc>
                <a:tc>
                  <a:txBody>
                    <a:bodyPr/>
                    <a:lstStyle/>
                    <a:p>
                      <a:pPr marL="0" marR="0" algn="ctr">
                        <a:lnSpc>
                          <a:spcPct val="200000"/>
                        </a:lnSpc>
                        <a:spcBef>
                          <a:spcPts val="0"/>
                        </a:spcBef>
                        <a:spcAft>
                          <a:spcPts val="0"/>
                        </a:spcAft>
                      </a:pPr>
                      <a:r>
                        <a:rPr lang="en-US" sz="1800" dirty="0">
                          <a:effectLst/>
                        </a:rPr>
                        <a:t>3.000</a:t>
                      </a:r>
                      <a:endParaRPr lang="en-US" sz="1800" dirty="0">
                        <a:effectLst/>
                        <a:latin typeface="Times New Roman" panose="02020603050405020304" pitchFamily="18" charset="0"/>
                        <a:ea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51.00</a:t>
                      </a:r>
                    </a:p>
                  </a:txBody>
                  <a:tcPr marL="68580" marR="68580" marT="0" marB="0"/>
                </a:tc>
                <a:tc>
                  <a:txBody>
                    <a:bodyPr/>
                    <a:lstStyle/>
                    <a:p>
                      <a:pPr marL="0" marR="0" lvl="0" algn="ctr">
                        <a:lnSpc>
                          <a:spcPct val="200000"/>
                        </a:lnSpc>
                        <a:spcBef>
                          <a:spcPts val="0"/>
                        </a:spcBef>
                        <a:spcAft>
                          <a:spcPts val="0"/>
                        </a:spcAft>
                        <a:buNone/>
                      </a:pPr>
                      <a:r>
                        <a:rPr lang="en-US" sz="1800" dirty="0">
                          <a:effectLst/>
                        </a:rPr>
                        <a:t>0.000*</a:t>
                      </a:r>
                      <a:endParaRPr lang="en-US" dirty="0"/>
                    </a:p>
                  </a:txBody>
                  <a:tcPr marL="68580" marR="68580" marT="0" marB="0"/>
                </a:tc>
                <a:extLst>
                  <a:ext uri="{0D108BD9-81ED-4DB2-BD59-A6C34878D82A}">
                    <a16:rowId xmlns:a16="http://schemas.microsoft.com/office/drawing/2014/main" val="495201934"/>
                  </a:ext>
                </a:extLst>
              </a:tr>
            </a:tbl>
          </a:graphicData>
        </a:graphic>
      </p:graphicFrame>
      <p:pic>
        <p:nvPicPr>
          <p:cNvPr id="25" name="Picture 24" descr="A plastic container with small green plants in it">
            <a:extLst>
              <a:ext uri="{FF2B5EF4-FFF2-40B4-BE49-F238E27FC236}">
                <a16:creationId xmlns:a16="http://schemas.microsoft.com/office/drawing/2014/main" id="{BD4A9A9A-18D7-AEFC-10D6-3D1B4532728C}"/>
              </a:ext>
            </a:extLst>
          </p:cNvPr>
          <p:cNvPicPr>
            <a:picLocks noChangeAspect="1"/>
          </p:cNvPicPr>
          <p:nvPr/>
        </p:nvPicPr>
        <p:blipFill rotWithShape="1">
          <a:blip r:embed="rId6">
            <a:extLst>
              <a:ext uri="{28A0092B-C50C-407E-A947-70E740481C1C}">
                <a14:useLocalDpi xmlns:a14="http://schemas.microsoft.com/office/drawing/2010/main" val="0"/>
              </a:ext>
            </a:extLst>
          </a:blip>
          <a:srcRect l="20078" t="19034" r="25988" b="19651"/>
          <a:stretch/>
        </p:blipFill>
        <p:spPr>
          <a:xfrm rot="5400000">
            <a:off x="12613852" y="6227438"/>
            <a:ext cx="3520887" cy="5336792"/>
          </a:xfrm>
          <a:prstGeom prst="rect">
            <a:avLst/>
          </a:prstGeom>
        </p:spPr>
      </p:pic>
      <p:sp>
        <p:nvSpPr>
          <p:cNvPr id="26" name="Text Box 2">
            <a:extLst>
              <a:ext uri="{FF2B5EF4-FFF2-40B4-BE49-F238E27FC236}">
                <a16:creationId xmlns:a16="http://schemas.microsoft.com/office/drawing/2014/main" id="{C8AD3FA0-91D1-C89A-BD5C-192A99E78AA9}"/>
              </a:ext>
            </a:extLst>
          </p:cNvPr>
          <p:cNvSpPr txBox="1">
            <a:spLocks noChangeArrowheads="1"/>
          </p:cNvSpPr>
          <p:nvPr/>
        </p:nvSpPr>
        <p:spPr bwMode="auto">
          <a:xfrm>
            <a:off x="12686987" y="20928974"/>
            <a:ext cx="8280204" cy="1477328"/>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a:spcBef>
                <a:spcPts val="0"/>
              </a:spcBef>
              <a:spcAft>
                <a:spcPts val="0"/>
              </a:spcAft>
            </a:pPr>
            <a:r>
              <a:rPr lang="en-US" sz="2400" b="1" dirty="0">
                <a:solidFill>
                  <a:srgbClr val="000000"/>
                </a:solidFill>
                <a:effectLst/>
                <a:latin typeface="Times New Roman"/>
                <a:ea typeface="Times New Roman" panose="02020603050405020304" pitchFamily="18" charset="0"/>
                <a:cs typeface="Arial"/>
              </a:rPr>
              <a:t>Figure </a:t>
            </a:r>
            <a:r>
              <a:rPr lang="en-US" sz="2400" b="1" dirty="0">
                <a:solidFill>
                  <a:srgbClr val="000000"/>
                </a:solidFill>
                <a:latin typeface="Times New Roman"/>
                <a:ea typeface="Times New Roman" panose="02020603050405020304" pitchFamily="18" charset="0"/>
                <a:cs typeface="Arial"/>
              </a:rPr>
              <a:t>2</a:t>
            </a:r>
            <a:r>
              <a:rPr lang="en-US" sz="2400" b="1" dirty="0">
                <a:solidFill>
                  <a:srgbClr val="000000"/>
                </a:solidFill>
                <a:effectLst/>
                <a:latin typeface="Times New Roman"/>
                <a:ea typeface="Times New Roman" panose="02020603050405020304" pitchFamily="18" charset="0"/>
                <a:cs typeface="Arial"/>
              </a:rPr>
              <a:t>.</a:t>
            </a:r>
            <a:r>
              <a:rPr lang="en-US" sz="2400" dirty="0">
                <a:solidFill>
                  <a:srgbClr val="000000"/>
                </a:solidFill>
                <a:latin typeface="Times New Roman"/>
                <a:ea typeface="Times New Roman" panose="02020603050405020304" pitchFamily="18" charset="0"/>
                <a:cs typeface="Arial"/>
              </a:rPr>
              <a:t> Change in the number of fronds for three treatments of </a:t>
            </a:r>
            <a:r>
              <a:rPr lang="en-US" sz="2400" i="1" dirty="0">
                <a:solidFill>
                  <a:srgbClr val="000000"/>
                </a:solidFill>
                <a:latin typeface="Times New Roman"/>
                <a:ea typeface="Times New Roman" panose="02020603050405020304" pitchFamily="18" charset="0"/>
                <a:cs typeface="Arial"/>
              </a:rPr>
              <a:t>S. </a:t>
            </a:r>
            <a:r>
              <a:rPr lang="en-US" sz="2400" i="1" err="1">
                <a:solidFill>
                  <a:srgbClr val="000000"/>
                </a:solidFill>
                <a:latin typeface="Times New Roman"/>
                <a:ea typeface="Times New Roman" panose="02020603050405020304" pitchFamily="18" charset="0"/>
                <a:cs typeface="Arial"/>
              </a:rPr>
              <a:t>polyrhiza</a:t>
            </a:r>
            <a:r>
              <a:rPr lang="en-US" sz="2400" dirty="0">
                <a:solidFill>
                  <a:srgbClr val="000000"/>
                </a:solidFill>
                <a:latin typeface="Times New Roman"/>
                <a:ea typeface="Times New Roman" panose="02020603050405020304" pitchFamily="18" charset="0"/>
                <a:cs typeface="Arial"/>
              </a:rPr>
              <a:t> all stored at three temperatures over a span of 28 days. A legend and standard error bars are provided. </a:t>
            </a:r>
            <a:endParaRPr lang="en-US" sz="2400" dirty="0">
              <a:effectLst/>
              <a:latin typeface="Times New Roman"/>
              <a:ea typeface="Times New Roman" panose="02020603050405020304" pitchFamily="18" charset="0"/>
            </a:endParaRPr>
          </a:p>
          <a:p>
            <a:pPr algn="ctr">
              <a:spcBef>
                <a:spcPts val="0"/>
              </a:spcBef>
              <a:spcAft>
                <a:spcPts val="0"/>
              </a:spcAft>
            </a:pPr>
            <a:endParaRPr lang="en-US" sz="1800">
              <a:effectLst/>
              <a:latin typeface="Times New Roman" panose="02020603050405020304" pitchFamily="18" charset="0"/>
              <a:ea typeface="Times New Roman" panose="02020603050405020304" pitchFamily="18" charset="0"/>
            </a:endParaRPr>
          </a:p>
        </p:txBody>
      </p:sp>
      <p:sp>
        <p:nvSpPr>
          <p:cNvPr id="27" name="Text Box 2">
            <a:extLst>
              <a:ext uri="{FF2B5EF4-FFF2-40B4-BE49-F238E27FC236}">
                <a16:creationId xmlns:a16="http://schemas.microsoft.com/office/drawing/2014/main" id="{E8598A00-C0A7-013C-851B-D8D74B2D51DB}"/>
              </a:ext>
            </a:extLst>
          </p:cNvPr>
          <p:cNvSpPr txBox="1">
            <a:spLocks noChangeArrowheads="1"/>
          </p:cNvSpPr>
          <p:nvPr/>
        </p:nvSpPr>
        <p:spPr bwMode="auto">
          <a:xfrm>
            <a:off x="22512104" y="20896512"/>
            <a:ext cx="8124783" cy="1273821"/>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Bef>
                <a:spcPts val="0"/>
              </a:spcBef>
              <a:spcAft>
                <a:spcPts val="800"/>
              </a:spcAft>
            </a:pPr>
            <a:r>
              <a:rPr lang="en-US" sz="2400" b="1" dirty="0">
                <a:solidFill>
                  <a:srgbClr val="000000"/>
                </a:solidFill>
                <a:effectLst/>
                <a:latin typeface="Times New Roman"/>
                <a:ea typeface="Calibri"/>
                <a:cs typeface="Arial"/>
              </a:rPr>
              <a:t>Figure </a:t>
            </a:r>
            <a:r>
              <a:rPr lang="en-US" sz="2400" b="1" dirty="0">
                <a:solidFill>
                  <a:srgbClr val="000000"/>
                </a:solidFill>
                <a:latin typeface="Times New Roman"/>
                <a:ea typeface="Calibri"/>
                <a:cs typeface="Arial"/>
              </a:rPr>
              <a:t>3</a:t>
            </a:r>
            <a:r>
              <a:rPr lang="en-US" sz="2400" b="1" dirty="0">
                <a:solidFill>
                  <a:srgbClr val="000000"/>
                </a:solidFill>
                <a:effectLst/>
                <a:latin typeface="Times New Roman"/>
                <a:ea typeface="Calibri"/>
                <a:cs typeface="Arial"/>
              </a:rPr>
              <a:t>.</a:t>
            </a:r>
            <a:r>
              <a:rPr lang="en-US" sz="2400" dirty="0">
                <a:solidFill>
                  <a:srgbClr val="000000"/>
                </a:solidFill>
                <a:latin typeface="Times New Roman"/>
                <a:ea typeface="Calibri"/>
                <a:cs typeface="Arial"/>
              </a:rPr>
              <a:t> Rate of change of percent coverage of </a:t>
            </a:r>
            <a:r>
              <a:rPr lang="en-US" sz="2400" dirty="0">
                <a:solidFill>
                  <a:srgbClr val="000000"/>
                </a:solidFill>
                <a:latin typeface="Times New Roman"/>
                <a:ea typeface="Calibri"/>
                <a:cs typeface="Times New Roman"/>
              </a:rPr>
              <a:t>three treatments of </a:t>
            </a:r>
            <a:r>
              <a:rPr lang="en-US" sz="2400" i="1" dirty="0">
                <a:solidFill>
                  <a:srgbClr val="000000"/>
                </a:solidFill>
                <a:latin typeface="Times New Roman"/>
                <a:ea typeface="Calibri"/>
                <a:cs typeface="Times New Roman"/>
              </a:rPr>
              <a:t>S. </a:t>
            </a:r>
            <a:r>
              <a:rPr lang="en-US" sz="2400" i="1" dirty="0" err="1">
                <a:solidFill>
                  <a:srgbClr val="000000"/>
                </a:solidFill>
                <a:latin typeface="Times New Roman"/>
                <a:ea typeface="Calibri"/>
                <a:cs typeface="Times New Roman"/>
              </a:rPr>
              <a:t>polyrhiza</a:t>
            </a:r>
            <a:r>
              <a:rPr lang="en-US" sz="2400" dirty="0">
                <a:solidFill>
                  <a:srgbClr val="000000"/>
                </a:solidFill>
                <a:latin typeface="Times New Roman"/>
                <a:ea typeface="Calibri"/>
                <a:cs typeface="Times New Roman"/>
              </a:rPr>
              <a:t> all stored at three temperatures over a span of 28 days. A legend and standard error bars are provided. </a:t>
            </a:r>
            <a:endParaRPr lang="en-US" sz="2400" dirty="0">
              <a:effectLst/>
              <a:latin typeface="Times New Roman" panose="02020603050405020304" pitchFamily="18" charset="0"/>
              <a:ea typeface="Times New Roman" panose="02020603050405020304" pitchFamily="18" charset="0"/>
              <a:cs typeface="Arial"/>
            </a:endParaRPr>
          </a:p>
        </p:txBody>
      </p:sp>
      <p:sp>
        <p:nvSpPr>
          <p:cNvPr id="28" name="Text Box 2">
            <a:extLst>
              <a:ext uri="{FF2B5EF4-FFF2-40B4-BE49-F238E27FC236}">
                <a16:creationId xmlns:a16="http://schemas.microsoft.com/office/drawing/2014/main" id="{84F975A6-A238-8411-DA25-164A62D0BA44}"/>
              </a:ext>
            </a:extLst>
          </p:cNvPr>
          <p:cNvSpPr txBox="1">
            <a:spLocks noChangeArrowheads="1"/>
          </p:cNvSpPr>
          <p:nvPr/>
        </p:nvSpPr>
        <p:spPr bwMode="auto">
          <a:xfrm>
            <a:off x="12676265" y="22486836"/>
            <a:ext cx="7800294" cy="1200329"/>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a:spcBef>
                <a:spcPts val="0"/>
              </a:spcBef>
              <a:spcAft>
                <a:spcPts val="0"/>
              </a:spcAft>
            </a:pPr>
            <a:r>
              <a:rPr lang="en-US" sz="2400" b="1" dirty="0">
                <a:effectLst/>
                <a:latin typeface="Times New Roman"/>
                <a:ea typeface="Times New Roman" panose="02020603050405020304" pitchFamily="18" charset="0"/>
                <a:cs typeface="Arial"/>
              </a:rPr>
              <a:t>Table 1.</a:t>
            </a:r>
            <a:r>
              <a:rPr lang="en-US" sz="2400" dirty="0">
                <a:effectLst/>
                <a:latin typeface="Times New Roman"/>
                <a:ea typeface="Times New Roman" panose="02020603050405020304" pitchFamily="18" charset="0"/>
                <a:cs typeface="Arial"/>
              </a:rPr>
              <a:t> </a:t>
            </a:r>
            <a:r>
              <a:rPr lang="en-US" sz="2400" dirty="0">
                <a:latin typeface="Times New Roman"/>
                <a:ea typeface="Times New Roman" panose="02020603050405020304" pitchFamily="18" charset="0"/>
                <a:cs typeface="Arial"/>
              </a:rPr>
              <a:t>Repeated Measures ANOVA</a:t>
            </a:r>
            <a:r>
              <a:rPr lang="en-US" sz="2400" dirty="0">
                <a:effectLst/>
                <a:latin typeface="Times New Roman"/>
                <a:ea typeface="Times New Roman" panose="02020603050405020304" pitchFamily="18" charset="0"/>
                <a:cs typeface="Arial"/>
              </a:rPr>
              <a:t> table comparing the percent coverage </a:t>
            </a:r>
            <a:r>
              <a:rPr lang="en-US" sz="2400" dirty="0">
                <a:latin typeface="Times New Roman"/>
                <a:ea typeface="Times New Roman" panose="02020603050405020304" pitchFamily="18" charset="0"/>
                <a:cs typeface="Arial"/>
              </a:rPr>
              <a:t>and frond count </a:t>
            </a:r>
            <a:r>
              <a:rPr lang="en-US" sz="2400" dirty="0">
                <a:effectLst/>
                <a:latin typeface="Times New Roman"/>
                <a:ea typeface="Times New Roman" panose="02020603050405020304" pitchFamily="18" charset="0"/>
                <a:cs typeface="Arial"/>
              </a:rPr>
              <a:t>of three duckweed frond treatments of 20℃, 30℃, and 40℃. </a:t>
            </a:r>
            <a:r>
              <a:rPr lang="en-US" sz="2400" dirty="0">
                <a:latin typeface="Times New Roman"/>
                <a:ea typeface="Times New Roman" panose="02020603050405020304" pitchFamily="18" charset="0"/>
                <a:cs typeface="Arial"/>
              </a:rPr>
              <a:t>(*</a:t>
            </a:r>
            <a:r>
              <a:rPr lang="en-US" sz="2400" dirty="0">
                <a:effectLst/>
                <a:latin typeface="Times New Roman"/>
                <a:ea typeface="Times New Roman" panose="02020603050405020304" pitchFamily="18" charset="0"/>
                <a:cs typeface="Arial"/>
              </a:rPr>
              <a:t>significance p&lt;0.05)</a:t>
            </a:r>
            <a:endParaRPr lang="en-US" dirty="0"/>
          </a:p>
        </p:txBody>
      </p:sp>
      <p:sp>
        <p:nvSpPr>
          <p:cNvPr id="31" name="Rectangle: Rounded Corners 30">
            <a:extLst>
              <a:ext uri="{FF2B5EF4-FFF2-40B4-BE49-F238E27FC236}">
                <a16:creationId xmlns:a16="http://schemas.microsoft.com/office/drawing/2014/main" id="{7F2FB729-B800-3746-3C27-976B0D44BD25}"/>
              </a:ext>
            </a:extLst>
          </p:cNvPr>
          <p:cNvSpPr/>
          <p:nvPr/>
        </p:nvSpPr>
        <p:spPr bwMode="auto">
          <a:xfrm>
            <a:off x="17324628" y="6125282"/>
            <a:ext cx="3822711" cy="1666101"/>
          </a:xfrm>
          <a:prstGeom prst="roundRect">
            <a:avLst/>
          </a:prstGeom>
          <a:solidFill>
            <a:srgbClr val="DED0D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ctr" defTabSz="4703763" rtl="0" eaLnBrk="1" fontAlgn="base" latinLnBrk="0" hangingPunct="1">
              <a:lnSpc>
                <a:spcPct val="100000"/>
              </a:lnSpc>
              <a:spcBef>
                <a:spcPct val="0"/>
              </a:spcBef>
              <a:spcAft>
                <a:spcPct val="0"/>
              </a:spcAft>
              <a:buClrTx/>
              <a:buSzTx/>
              <a:buFontTx/>
              <a:buNone/>
              <a:tabLst/>
            </a:pPr>
            <a:r>
              <a:rPr lang="en-US" sz="4400" b="1">
                <a:latin typeface="Times New Roman" panose="02020603050405020304" pitchFamily="18" charset="0"/>
                <a:cs typeface="Times New Roman" panose="02020603050405020304" pitchFamily="18" charset="0"/>
              </a:rPr>
              <a:t>Experimental Design</a:t>
            </a:r>
            <a:endParaRPr kumimoji="0" lang="en-US" sz="4400" b="1"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2" name="TextBox 31">
            <a:extLst>
              <a:ext uri="{FF2B5EF4-FFF2-40B4-BE49-F238E27FC236}">
                <a16:creationId xmlns:a16="http://schemas.microsoft.com/office/drawing/2014/main" id="{44B01CFD-FD60-D4B8-9DB0-913901421BEE}"/>
              </a:ext>
            </a:extLst>
          </p:cNvPr>
          <p:cNvSpPr txBox="1"/>
          <p:nvPr/>
        </p:nvSpPr>
        <p:spPr>
          <a:xfrm>
            <a:off x="17292164" y="7881275"/>
            <a:ext cx="3905288" cy="4247317"/>
          </a:xfrm>
          <a:prstGeom prst="rect">
            <a:avLst/>
          </a:prstGeom>
          <a:noFill/>
        </p:spPr>
        <p:txBody>
          <a:bodyPr wrap="square" lIns="91440" tIns="45720" rIns="91440" bIns="45720" rtlCol="0" anchor="t">
            <a:spAutoFit/>
          </a:bodyPr>
          <a:lstStyle/>
          <a:p>
            <a:pPr marL="514350" indent="-514350">
              <a:buAutoNum type="arabicPeriod"/>
            </a:pPr>
            <a:r>
              <a:rPr lang="en-US">
                <a:latin typeface="Times New Roman"/>
                <a:cs typeface="Times New Roman"/>
              </a:rPr>
              <a:t>Add 1:5 carbon free Hoagland's plant growth medium into a 6 well microplate.</a:t>
            </a:r>
            <a:endParaRPr lang="en-US"/>
          </a:p>
          <a:p>
            <a:pPr marL="514350" indent="-514350">
              <a:buAutoNum type="arabicPeriod"/>
            </a:pPr>
            <a:r>
              <a:rPr lang="en-US">
                <a:latin typeface="Times New Roman"/>
                <a:cs typeface="Times New Roman"/>
              </a:rPr>
              <a:t>Add in sterile turion.</a:t>
            </a:r>
          </a:p>
          <a:p>
            <a:pPr marL="514350" indent="-514350">
              <a:buAutoNum type="arabicPeriod"/>
            </a:pPr>
            <a:r>
              <a:rPr lang="en-US">
                <a:latin typeface="Times New Roman"/>
                <a:cs typeface="Times New Roman"/>
              </a:rPr>
              <a:t>Place in temperature groups: 20°C, 30°C, and 40°C</a:t>
            </a:r>
            <a:endParaRPr lang="en-US">
              <a:latin typeface="Times New Roman" panose="02020603050405020304" pitchFamily="18" charset="0"/>
              <a:cs typeface="Times New Roman" panose="02020603050405020304" pitchFamily="18" charset="0"/>
            </a:endParaRPr>
          </a:p>
        </p:txBody>
      </p:sp>
      <p:sp>
        <p:nvSpPr>
          <p:cNvPr id="33" name="Rectangle: Rounded Corners 32">
            <a:extLst>
              <a:ext uri="{FF2B5EF4-FFF2-40B4-BE49-F238E27FC236}">
                <a16:creationId xmlns:a16="http://schemas.microsoft.com/office/drawing/2014/main" id="{18B5C642-0B11-8A65-D021-2231F52627AA}"/>
              </a:ext>
            </a:extLst>
          </p:cNvPr>
          <p:cNvSpPr/>
          <p:nvPr/>
        </p:nvSpPr>
        <p:spPr bwMode="auto">
          <a:xfrm>
            <a:off x="22181217" y="6125281"/>
            <a:ext cx="3822711" cy="1666101"/>
          </a:xfrm>
          <a:prstGeom prst="roundRect">
            <a:avLst/>
          </a:prstGeom>
          <a:solidFill>
            <a:srgbClr val="DED0D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ctr" defTabSz="4703763" rtl="0" eaLnBrk="1" fontAlgn="base" latinLnBrk="0" hangingPunct="1">
              <a:lnSpc>
                <a:spcPct val="100000"/>
              </a:lnSpc>
              <a:spcBef>
                <a:spcPct val="0"/>
              </a:spcBef>
              <a:spcAft>
                <a:spcPct val="0"/>
              </a:spcAft>
              <a:buClrTx/>
              <a:buSzTx/>
              <a:buFontTx/>
              <a:buNone/>
              <a:tabLst/>
            </a:pPr>
            <a:r>
              <a:rPr lang="en-US" sz="4400" b="1">
                <a:latin typeface="Times New Roman" panose="02020603050405020304" pitchFamily="18" charset="0"/>
                <a:cs typeface="Times New Roman" panose="02020603050405020304" pitchFamily="18" charset="0"/>
              </a:rPr>
              <a:t>Data Collection</a:t>
            </a:r>
            <a:endParaRPr kumimoji="0" lang="en-US" sz="4400" b="1"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4" name="TextBox 33">
            <a:extLst>
              <a:ext uri="{FF2B5EF4-FFF2-40B4-BE49-F238E27FC236}">
                <a16:creationId xmlns:a16="http://schemas.microsoft.com/office/drawing/2014/main" id="{AF943511-BF14-7164-A804-4EE36C99301B}"/>
              </a:ext>
            </a:extLst>
          </p:cNvPr>
          <p:cNvSpPr txBox="1"/>
          <p:nvPr/>
        </p:nvSpPr>
        <p:spPr>
          <a:xfrm>
            <a:off x="21952050" y="7794214"/>
            <a:ext cx="4233075" cy="4401205"/>
          </a:xfrm>
          <a:prstGeom prst="rect">
            <a:avLst/>
          </a:prstGeom>
          <a:noFill/>
        </p:spPr>
        <p:txBody>
          <a:bodyPr wrap="square" lIns="91440" tIns="45720" rIns="91440" bIns="45720" rtlCol="0" anchor="t">
            <a:spAutoFit/>
          </a:bodyPr>
          <a:lstStyle/>
          <a:p>
            <a:pPr marL="457200" indent="-457200">
              <a:buFont typeface="Arial" panose="020B0604020202020204" pitchFamily="34" charset="0"/>
              <a:buChar char="•"/>
            </a:pPr>
            <a:r>
              <a:rPr lang="en-US" sz="2800" dirty="0">
                <a:latin typeface="Times New Roman"/>
                <a:cs typeface="Times New Roman"/>
              </a:rPr>
              <a:t>Using ImageJ, duckweed area was measured to calculate Percent Coverage and the number of fronds within each well were counted.</a:t>
            </a:r>
          </a:p>
          <a:p>
            <a:endParaRPr lang="en-US" sz="2800" dirty="0">
              <a:latin typeface="Times New Roman" panose="02020603050405020304" pitchFamily="18" charset="0"/>
              <a:cs typeface="Times New Roman" panose="02020603050405020304" pitchFamily="18" charset="0"/>
            </a:endParaRPr>
          </a:p>
          <a:p>
            <a:pPr marL="457200" indent="-457200">
              <a:buFont typeface="Arial" panose="020B0604020202020204" pitchFamily="34" charset="0"/>
              <a:buChar char="•"/>
            </a:pPr>
            <a:endParaRPr lang="en-US" sz="2800">
              <a:latin typeface="Times New Roman" panose="02020603050405020304" pitchFamily="18" charset="0"/>
              <a:cs typeface="Times New Roman" panose="02020603050405020304" pitchFamily="18" charset="0"/>
            </a:endParaRPr>
          </a:p>
          <a:p>
            <a:pPr marL="457200" indent="-457200">
              <a:buFont typeface="Arial" panose="020B0604020202020204" pitchFamily="34" charset="0"/>
              <a:buChar char="•"/>
            </a:pPr>
            <a:endParaRPr lang="en-US" sz="2800">
              <a:latin typeface="Times New Roman" panose="02020603050405020304" pitchFamily="18" charset="0"/>
              <a:cs typeface="Times New Roman" panose="02020603050405020304" pitchFamily="18" charset="0"/>
            </a:endParaRPr>
          </a:p>
          <a:p>
            <a:pPr marL="457200" indent="-457200">
              <a:buFont typeface="Arial" panose="020B0604020202020204" pitchFamily="34" charset="0"/>
              <a:buChar char="•"/>
            </a:pPr>
            <a:endParaRPr lang="en-US" sz="2800">
              <a:latin typeface="Times New Roman" panose="02020603050405020304" pitchFamily="18" charset="0"/>
              <a:cs typeface="Times New Roman" panose="02020603050405020304" pitchFamily="18" charset="0"/>
            </a:endParaRPr>
          </a:p>
        </p:txBody>
      </p:sp>
      <p:sp>
        <p:nvSpPr>
          <p:cNvPr id="35" name="Rectangle: Rounded Corners 34">
            <a:extLst>
              <a:ext uri="{FF2B5EF4-FFF2-40B4-BE49-F238E27FC236}">
                <a16:creationId xmlns:a16="http://schemas.microsoft.com/office/drawing/2014/main" id="{69D7526D-8EC8-0C82-A5C3-7D255A0126AF}"/>
              </a:ext>
            </a:extLst>
          </p:cNvPr>
          <p:cNvSpPr/>
          <p:nvPr/>
        </p:nvSpPr>
        <p:spPr bwMode="auto">
          <a:xfrm>
            <a:off x="27041756" y="6121345"/>
            <a:ext cx="3822711" cy="1666101"/>
          </a:xfrm>
          <a:prstGeom prst="roundRect">
            <a:avLst/>
          </a:prstGeom>
          <a:solidFill>
            <a:srgbClr val="DED0D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algn="ctr" defTabSz="4703763"/>
            <a:r>
              <a:rPr lang="en-US" sz="4400" b="1">
                <a:latin typeface="Times New Roman"/>
                <a:cs typeface="Times New Roman"/>
              </a:rPr>
              <a:t>Data </a:t>
            </a:r>
            <a:endParaRPr lang="en-US">
              <a:latin typeface="Times New Roman"/>
              <a:cs typeface="Times New Roman"/>
            </a:endParaRPr>
          </a:p>
          <a:p>
            <a:pPr marL="0" marR="0" indent="0" algn="ctr" defTabSz="4703763">
              <a:lnSpc>
                <a:spcPct val="100000"/>
              </a:lnSpc>
              <a:spcBef>
                <a:spcPct val="0"/>
              </a:spcBef>
              <a:spcAft>
                <a:spcPct val="0"/>
              </a:spcAft>
              <a:buClrTx/>
              <a:buSzTx/>
              <a:buFontTx/>
              <a:buNone/>
              <a:tabLst/>
            </a:pPr>
            <a:r>
              <a:rPr lang="en-US" sz="4400" b="1">
                <a:latin typeface="Times New Roman"/>
                <a:cs typeface="Times New Roman"/>
              </a:rPr>
              <a:t>Analysis</a:t>
            </a:r>
            <a:endParaRPr lang="en-US">
              <a:latin typeface="Times New Roman"/>
              <a:cs typeface="Times New Roman"/>
            </a:endParaRPr>
          </a:p>
        </p:txBody>
      </p:sp>
      <p:sp>
        <p:nvSpPr>
          <p:cNvPr id="36" name="TextBox 35">
            <a:extLst>
              <a:ext uri="{FF2B5EF4-FFF2-40B4-BE49-F238E27FC236}">
                <a16:creationId xmlns:a16="http://schemas.microsoft.com/office/drawing/2014/main" id="{30EAF356-4807-BAF3-0908-80002FAFCE7E}"/>
              </a:ext>
            </a:extLst>
          </p:cNvPr>
          <p:cNvSpPr txBox="1"/>
          <p:nvPr/>
        </p:nvSpPr>
        <p:spPr>
          <a:xfrm>
            <a:off x="27041756" y="7877659"/>
            <a:ext cx="4005413" cy="4247317"/>
          </a:xfrm>
          <a:prstGeom prst="rect">
            <a:avLst/>
          </a:prstGeom>
          <a:noFill/>
        </p:spPr>
        <p:txBody>
          <a:bodyPr wrap="square" lIns="91440" tIns="45720" rIns="91440" bIns="45720" rtlCol="0" anchor="t">
            <a:spAutoFit/>
          </a:bodyPr>
          <a:lstStyle/>
          <a:p>
            <a:pPr marL="457200" indent="-457200">
              <a:buFont typeface="Arial" panose="020B0604020202020204" pitchFamily="34" charset="0"/>
              <a:buChar char="•"/>
            </a:pPr>
            <a:r>
              <a:rPr lang="en-US">
                <a:latin typeface="Times New Roman"/>
                <a:cs typeface="Times New Roman"/>
              </a:rPr>
              <a:t>Using Python, a Repeated Measures ANOVA and Tukey tests were used to determine different in percent coverage and number of fronds within each temperature treatment</a:t>
            </a:r>
          </a:p>
        </p:txBody>
      </p:sp>
      <p:sp>
        <p:nvSpPr>
          <p:cNvPr id="37" name="TextBox 36">
            <a:extLst>
              <a:ext uri="{FF2B5EF4-FFF2-40B4-BE49-F238E27FC236}">
                <a16:creationId xmlns:a16="http://schemas.microsoft.com/office/drawing/2014/main" id="{C0F06F95-DEC7-2E2C-5084-BC64E3C17B22}"/>
              </a:ext>
            </a:extLst>
          </p:cNvPr>
          <p:cNvSpPr txBox="1"/>
          <p:nvPr/>
        </p:nvSpPr>
        <p:spPr>
          <a:xfrm>
            <a:off x="11720984" y="10816443"/>
            <a:ext cx="5356440" cy="523220"/>
          </a:xfrm>
          <a:prstGeom prst="rect">
            <a:avLst/>
          </a:prstGeom>
          <a:noFill/>
        </p:spPr>
        <p:txBody>
          <a:bodyPr wrap="square" lIns="91440" tIns="45720" rIns="91440" bIns="45720" rtlCol="0" anchor="t">
            <a:spAutoFit/>
          </a:bodyPr>
          <a:lstStyle/>
          <a:p>
            <a:r>
              <a:rPr lang="en-US" sz="1400" b="1" dirty="0">
                <a:latin typeface="Times New Roman"/>
                <a:cs typeface="Times New Roman"/>
              </a:rPr>
              <a:t>Figure 1.</a:t>
            </a:r>
            <a:r>
              <a:rPr lang="en-US" sz="1400" dirty="0">
                <a:latin typeface="Times New Roman"/>
                <a:cs typeface="Times New Roman"/>
              </a:rPr>
              <a:t> </a:t>
            </a:r>
            <a:r>
              <a:rPr lang="en-US" sz="1400" i="1" dirty="0">
                <a:latin typeface="Times New Roman"/>
                <a:cs typeface="Times New Roman"/>
              </a:rPr>
              <a:t>S. </a:t>
            </a:r>
            <a:r>
              <a:rPr lang="en-US" sz="1400" i="1" dirty="0" err="1">
                <a:latin typeface="Times New Roman"/>
                <a:cs typeface="Times New Roman"/>
              </a:rPr>
              <a:t>polyrhiza</a:t>
            </a:r>
            <a:r>
              <a:rPr lang="en-US" sz="1400" dirty="0">
                <a:latin typeface="Times New Roman"/>
                <a:cs typeface="Times New Roman"/>
              </a:rPr>
              <a:t> was grown using sterile turions in 6 well plates for each temperature treatment. </a:t>
            </a:r>
            <a:endParaRPr lang="en-US" dirty="0"/>
          </a:p>
        </p:txBody>
      </p:sp>
      <p:sp>
        <p:nvSpPr>
          <p:cNvPr id="7" name="TextBox 6">
            <a:extLst>
              <a:ext uri="{FF2B5EF4-FFF2-40B4-BE49-F238E27FC236}">
                <a16:creationId xmlns:a16="http://schemas.microsoft.com/office/drawing/2014/main" id="{EE761138-33B1-0299-BC55-977C0A61093D}"/>
              </a:ext>
            </a:extLst>
          </p:cNvPr>
          <p:cNvSpPr txBox="1"/>
          <p:nvPr/>
        </p:nvSpPr>
        <p:spPr>
          <a:xfrm>
            <a:off x="22186716" y="22664815"/>
            <a:ext cx="8782919" cy="4154984"/>
          </a:xfrm>
          <a:prstGeom prst="rect">
            <a:avLst/>
          </a:prstGeom>
          <a:noFill/>
          <a:ln>
            <a:solidFill>
              <a:srgbClr val="9C5252"/>
            </a:solid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457200" indent="-457200">
              <a:buFont typeface="Arial"/>
              <a:buChar char="•"/>
            </a:pPr>
            <a:r>
              <a:rPr lang="en-US" sz="3300">
                <a:latin typeface="Times New Roman"/>
                <a:cs typeface="Arial"/>
              </a:rPr>
              <a:t>The 20ºC plate showed the most turion growth and germination,  while the 40ºC plate showed the least. </a:t>
            </a:r>
            <a:endParaRPr lang="en-US" sz="3300">
              <a:latin typeface="Times New Roman"/>
            </a:endParaRPr>
          </a:p>
          <a:p>
            <a:pPr marL="457200" indent="-457200">
              <a:buFont typeface="Arial"/>
              <a:buChar char="•"/>
            </a:pPr>
            <a:r>
              <a:rPr lang="en-US" sz="3300">
                <a:latin typeface="Times New Roman"/>
                <a:cs typeface="Arial"/>
              </a:rPr>
              <a:t>After 7 days, the 40ºC plate growth levels decreased due to turion death. </a:t>
            </a:r>
          </a:p>
          <a:p>
            <a:pPr marL="457200" indent="-457200">
              <a:buFont typeface="Arial"/>
              <a:buChar char="•"/>
            </a:pPr>
            <a:r>
              <a:rPr lang="en-US" sz="3300">
                <a:latin typeface="Times New Roman"/>
                <a:cs typeface="Arial"/>
              </a:rPr>
              <a:t>The 30ºC plate showed moderate growth between 0-14 days, then grew at a similar rate to 20ºC plate. </a:t>
            </a:r>
            <a:endParaRPr lang="en-US" sz="3300">
              <a:latin typeface="Times New Roman"/>
            </a:endParaRPr>
          </a:p>
        </p:txBody>
      </p:sp>
      <p:sp>
        <p:nvSpPr>
          <p:cNvPr id="40" name="Rectangle: Rounded Corners 39">
            <a:extLst>
              <a:ext uri="{FF2B5EF4-FFF2-40B4-BE49-F238E27FC236}">
                <a16:creationId xmlns:a16="http://schemas.microsoft.com/office/drawing/2014/main" id="{4BCFE62E-0780-A2EC-1733-A422197FCCCE}"/>
              </a:ext>
            </a:extLst>
          </p:cNvPr>
          <p:cNvSpPr/>
          <p:nvPr/>
        </p:nvSpPr>
        <p:spPr bwMode="auto">
          <a:xfrm>
            <a:off x="21491102" y="10818050"/>
            <a:ext cx="5565247" cy="993240"/>
          </a:xfrm>
          <a:prstGeom prst="roundRect">
            <a:avLst/>
          </a:prstGeom>
          <a:solidFill>
            <a:srgbClr val="DED0D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ctr" defTabSz="4703763" rtl="0" eaLnBrk="1" fontAlgn="base" latinLnBrk="0" hangingPunct="1">
              <a:lnSpc>
                <a:spcPct val="100000"/>
              </a:lnSpc>
              <a:spcBef>
                <a:spcPct val="0"/>
              </a:spcBef>
              <a:spcAft>
                <a:spcPct val="0"/>
              </a:spcAft>
              <a:buClrTx/>
              <a:buSzTx/>
              <a:buFontTx/>
              <a:buNone/>
              <a:tabLst/>
            </a:pPr>
            <a:endParaRPr lang="en-US" sz="4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48C630A8-F530-223D-9BFB-3CBA8374B4DF}"/>
              </a:ext>
            </a:extLst>
          </p:cNvPr>
          <p:cNvSpPr txBox="1"/>
          <p:nvPr/>
        </p:nvSpPr>
        <p:spPr>
          <a:xfrm>
            <a:off x="21485442" y="10840271"/>
            <a:ext cx="1655871" cy="98861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dirty="0">
                <a:latin typeface="Times New Roman"/>
                <a:cs typeface="Times New Roman"/>
              </a:rPr>
              <a:t>Percent </a:t>
            </a:r>
            <a:endParaRPr lang="en-US"/>
          </a:p>
          <a:p>
            <a:pPr algn="ctr"/>
            <a:r>
              <a:rPr lang="en-US" sz="2800">
                <a:latin typeface="Times New Roman"/>
                <a:cs typeface="Times New Roman"/>
              </a:rPr>
              <a:t>Coverage </a:t>
            </a:r>
            <a:endParaRPr lang="en-US"/>
          </a:p>
        </p:txBody>
      </p:sp>
      <p:sp>
        <p:nvSpPr>
          <p:cNvPr id="18" name="TextBox 17">
            <a:extLst>
              <a:ext uri="{FF2B5EF4-FFF2-40B4-BE49-F238E27FC236}">
                <a16:creationId xmlns:a16="http://schemas.microsoft.com/office/drawing/2014/main" id="{12298693-8928-0338-4994-9067E573FBAD}"/>
              </a:ext>
            </a:extLst>
          </p:cNvPr>
          <p:cNvSpPr txBox="1"/>
          <p:nvPr/>
        </p:nvSpPr>
        <p:spPr>
          <a:xfrm>
            <a:off x="23193472" y="10926534"/>
            <a:ext cx="2708294" cy="98861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a:latin typeface="Times New Roman"/>
                <a:cs typeface="Times New Roman"/>
              </a:rPr>
              <a:t>Duckweed Area</a:t>
            </a:r>
            <a:endParaRPr lang="en-US" dirty="0"/>
          </a:p>
          <a:p>
            <a:pPr algn="ctr"/>
            <a:r>
              <a:rPr lang="en-US" sz="2800">
                <a:latin typeface="Times New Roman"/>
                <a:cs typeface="Times New Roman"/>
              </a:rPr>
              <a:t>Well Area </a:t>
            </a:r>
            <a:endParaRPr lang="en-US"/>
          </a:p>
        </p:txBody>
      </p:sp>
      <p:sp>
        <p:nvSpPr>
          <p:cNvPr id="29" name="TextBox 28">
            <a:extLst>
              <a:ext uri="{FF2B5EF4-FFF2-40B4-BE49-F238E27FC236}">
                <a16:creationId xmlns:a16="http://schemas.microsoft.com/office/drawing/2014/main" id="{F79C0B08-929E-0C8F-A26D-D1900DFDD2FC}"/>
              </a:ext>
            </a:extLst>
          </p:cNvPr>
          <p:cNvSpPr txBox="1"/>
          <p:nvPr/>
        </p:nvSpPr>
        <p:spPr>
          <a:xfrm>
            <a:off x="25746891" y="11023613"/>
            <a:ext cx="1375448"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latin typeface="Times New Roman"/>
                <a:cs typeface="Times New Roman"/>
              </a:rPr>
              <a:t>x 100%</a:t>
            </a:r>
            <a:endParaRPr lang="en-US" dirty="0"/>
          </a:p>
        </p:txBody>
      </p:sp>
      <p:sp>
        <p:nvSpPr>
          <p:cNvPr id="30" name="TextBox 29">
            <a:extLst>
              <a:ext uri="{FF2B5EF4-FFF2-40B4-BE49-F238E27FC236}">
                <a16:creationId xmlns:a16="http://schemas.microsoft.com/office/drawing/2014/main" id="{40B0296A-E37F-E54D-2BBD-5F2CE3010F1A}"/>
              </a:ext>
            </a:extLst>
          </p:cNvPr>
          <p:cNvSpPr txBox="1"/>
          <p:nvPr/>
        </p:nvSpPr>
        <p:spPr>
          <a:xfrm>
            <a:off x="22917426" y="11081809"/>
            <a:ext cx="448173" cy="95410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latin typeface="Times New Roman"/>
                <a:cs typeface="Times New Roman"/>
              </a:rPr>
              <a:t>= </a:t>
            </a:r>
          </a:p>
        </p:txBody>
      </p:sp>
      <p:cxnSp>
        <p:nvCxnSpPr>
          <p:cNvPr id="39" name="Straight Arrow Connector 38">
            <a:extLst>
              <a:ext uri="{FF2B5EF4-FFF2-40B4-BE49-F238E27FC236}">
                <a16:creationId xmlns:a16="http://schemas.microsoft.com/office/drawing/2014/main" id="{4754EDF7-2CB3-F2D2-DD76-D4E1907F29D7}"/>
              </a:ext>
            </a:extLst>
          </p:cNvPr>
          <p:cNvCxnSpPr/>
          <p:nvPr/>
        </p:nvCxnSpPr>
        <p:spPr bwMode="auto">
          <a:xfrm>
            <a:off x="23361411" y="11318933"/>
            <a:ext cx="2363637" cy="17253"/>
          </a:xfrm>
          <a:prstGeom prst="straightConnector1">
            <a:avLst/>
          </a:prstGeom>
          <a:ln w="28575">
            <a:headEnd type="none" w="med" len="med"/>
            <a:tailEnd type="none" w="med" len="med"/>
          </a:ln>
        </p:spPr>
        <p:style>
          <a:lnRef idx="1">
            <a:schemeClr val="dk1"/>
          </a:lnRef>
          <a:fillRef idx="0">
            <a:schemeClr val="dk1"/>
          </a:fillRef>
          <a:effectRef idx="0">
            <a:schemeClr val="dk1"/>
          </a:effectRef>
          <a:fontRef idx="minor">
            <a:schemeClr val="tx1"/>
          </a:fontRef>
        </p:style>
      </p:cxnSp>
      <p:pic>
        <p:nvPicPr>
          <p:cNvPr id="38" name="Picture 37">
            <a:extLst>
              <a:ext uri="{FF2B5EF4-FFF2-40B4-BE49-F238E27FC236}">
                <a16:creationId xmlns:a16="http://schemas.microsoft.com/office/drawing/2014/main" id="{58956C0E-CCF6-6E08-81C6-1B7D33AEA13B}"/>
              </a:ext>
            </a:extLst>
          </p:cNvPr>
          <p:cNvPicPr>
            <a:picLocks noChangeAspect="1"/>
          </p:cNvPicPr>
          <p:nvPr/>
        </p:nvPicPr>
        <p:blipFill rotWithShape="1">
          <a:blip r:embed="rId7"/>
          <a:srcRect l="956" t="2561" r="-2099" b="216"/>
          <a:stretch/>
        </p:blipFill>
        <p:spPr>
          <a:xfrm>
            <a:off x="21945600" y="13598642"/>
            <a:ext cx="8952777" cy="7172507"/>
          </a:xfrm>
          <a:prstGeom prst="rect">
            <a:avLst/>
          </a:prstGeom>
        </p:spPr>
      </p:pic>
      <p:pic>
        <p:nvPicPr>
          <p:cNvPr id="41" name="Picture 40">
            <a:extLst>
              <a:ext uri="{FF2B5EF4-FFF2-40B4-BE49-F238E27FC236}">
                <a16:creationId xmlns:a16="http://schemas.microsoft.com/office/drawing/2014/main" id="{C51EC121-3A0B-D731-4AF6-3305293DC0A1}"/>
              </a:ext>
            </a:extLst>
          </p:cNvPr>
          <p:cNvPicPr>
            <a:picLocks noChangeAspect="1"/>
          </p:cNvPicPr>
          <p:nvPr/>
        </p:nvPicPr>
        <p:blipFill rotWithShape="1">
          <a:blip r:embed="rId8"/>
          <a:srcRect l="60" t="989" r="296" b="-97"/>
          <a:stretch/>
        </p:blipFill>
        <p:spPr>
          <a:xfrm>
            <a:off x="12136950" y="13598642"/>
            <a:ext cx="8856774" cy="7160943"/>
          </a:xfrm>
          <a:prstGeom prst="rect">
            <a:avLst/>
          </a:prstGeom>
        </p:spPr>
      </p:pic>
    </p:spTree>
    <p:extLst>
      <p:ext uri="{BB962C8B-B14F-4D97-AF65-F5344CB8AC3E}">
        <p14:creationId xmlns:p14="http://schemas.microsoft.com/office/powerpoint/2010/main" val="126798669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VERSION" val="5"/>
  <p:tag name="TPFULLVERSION" val="5.2.1.3179"/>
  <p:tag name="PPTVERSION" val="14"/>
  <p:tag name="TPOS" val="2"/>
</p:tagLst>
</file>

<file path=ppt/theme/theme1.xml><?xml version="1.0" encoding="utf-8"?>
<a:theme xmlns:a="http://schemas.openxmlformats.org/drawingml/2006/main" name="Default Design">
  <a:themeElements>
    <a:clrScheme name="Executive">
      <a:dk1>
        <a:sysClr val="windowText" lastClr="000000"/>
      </a:dk1>
      <a:lt1>
        <a:sysClr val="window" lastClr="FFFFFF"/>
      </a:lt1>
      <a:dk2>
        <a:srgbClr val="2F5897"/>
      </a:dk2>
      <a:lt2>
        <a:srgbClr val="E4E9EF"/>
      </a:lt2>
      <a:accent1>
        <a:srgbClr val="6076B4"/>
      </a:accent1>
      <a:accent2>
        <a:srgbClr val="9C5252"/>
      </a:accent2>
      <a:accent3>
        <a:srgbClr val="E68422"/>
      </a:accent3>
      <a:accent4>
        <a:srgbClr val="846648"/>
      </a:accent4>
      <a:accent5>
        <a:srgbClr val="63891F"/>
      </a:accent5>
      <a:accent6>
        <a:srgbClr val="758085"/>
      </a:accent6>
      <a:hlink>
        <a:srgbClr val="3399FF"/>
      </a:hlink>
      <a:folHlink>
        <a:srgbClr val="B2B2B2"/>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Application>Microsoft Office PowerPoint</Application>
  <PresentationFormat>Custom</PresentationFormat>
  <Slides>1</Slides>
  <Notes>1</Notes>
  <HiddenSlides>0</HiddenSlide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Default Desig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atthew J. Faldyn</dc:creator>
  <cp:revision>131</cp:revision>
  <dcterms:modified xsi:type="dcterms:W3CDTF">2024-04-26T01:15:42Z</dcterms:modified>
</cp:coreProperties>
</file>